
<file path=[Content_Types].xml><?xml version="1.0" encoding="utf-8"?>
<Types xmlns="http://schemas.openxmlformats.org/package/2006/content-types">
  <Default Extension="jpeg" ContentType="image/jpeg"/>
  <Default Extension="m4a" ContentType="audi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ink/ink1.xml" ContentType="application/inkml+xml"/>
  <Override PartName="/ppt/notesSlides/notesSlide2.xml" ContentType="application/vnd.openxmlformats-officedocument.presentationml.notesSlide+xml"/>
  <Override PartName="/ppt/ink/ink2.xml" ContentType="application/inkml+xml"/>
  <Override PartName="/ppt/ink/ink3.xml" ContentType="application/inkml+xml"/>
  <Override PartName="/ppt/ink/ink4.xml" ContentType="application/inkml+xml"/>
  <Override PartName="/ppt/ink/ink5.xml" ContentType="application/inkml+xml"/>
  <Override PartName="/ppt/ink/ink6.xml" ContentType="application/inkml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ink/ink7.xml" ContentType="application/inkml+xml"/>
  <Override PartName="/ppt/ink/ink8.xml" ContentType="application/inkml+xml"/>
  <Override PartName="/ppt/ink/ink9.xml" ContentType="application/inkml+xml"/>
  <Override PartName="/ppt/ink/ink10.xml" ContentType="application/inkml+xml"/>
  <Override PartName="/ppt/ink/ink11.xml" ContentType="application/inkml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14"/>
  </p:notesMasterIdLst>
  <p:sldIdLst>
    <p:sldId id="1237" r:id="rId5"/>
    <p:sldId id="1240" r:id="rId6"/>
    <p:sldId id="1244" r:id="rId7"/>
    <p:sldId id="1243" r:id="rId8"/>
    <p:sldId id="1246" r:id="rId9"/>
    <p:sldId id="1245" r:id="rId10"/>
    <p:sldId id="1247" r:id="rId11"/>
    <p:sldId id="1261" r:id="rId12"/>
    <p:sldId id="1262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5B51031F-77DF-4B55-909D-3FAC178A864A}">
          <p14:sldIdLst>
            <p14:sldId id="1237"/>
            <p14:sldId id="1240"/>
            <p14:sldId id="1244"/>
            <p14:sldId id="1243"/>
            <p14:sldId id="1246"/>
            <p14:sldId id="1245"/>
            <p14:sldId id="1247"/>
            <p14:sldId id="1261"/>
            <p14:sldId id="1262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owell, Tracy B" initials="PB" lastIdx="1" clrIdx="0">
    <p:extLst>
      <p:ext uri="{19B8F6BF-5375-455C-9EA6-DF929625EA0E}">
        <p15:presenceInfo xmlns:p15="http://schemas.microsoft.com/office/powerpoint/2012/main" userId="S::tlp29@psu.edu::3a23670c-8d59-42b6-baec-5df9e25afc58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9CDE"/>
    <a:srgbClr val="001E44"/>
    <a:srgbClr val="1E40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2125"/>
    <p:restoredTop sz="83105" autoAdjust="0"/>
  </p:normalViewPr>
  <p:slideViewPr>
    <p:cSldViewPr snapToGrid="0">
      <p:cViewPr varScale="1">
        <p:scale>
          <a:sx n="89" d="100"/>
          <a:sy n="89" d="100"/>
        </p:scale>
        <p:origin x="96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viewProps" Target="viewProps.xml"/><Relationship Id="rId2" Type="http://schemas.openxmlformats.org/officeDocument/2006/relationships/customXml" Target="../customXml/item2.xml"/><Relationship Id="rId16" Type="http://schemas.openxmlformats.org/officeDocument/2006/relationships/presProps" Target="presProp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commentAuthors" Target="commentAuthors.xml"/><Relationship Id="rId10" Type="http://schemas.openxmlformats.org/officeDocument/2006/relationships/slide" Target="slides/slide6.xml"/><Relationship Id="rId19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notesMaster" Target="notesMasters/notesMaster1.xml"/></Relationships>
</file>

<file path=ppt/ink/ink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2-09-27T01:18:08.755"/>
    </inkml:context>
    <inkml:brush xml:id="br0">
      <inkml:brushProperty name="width" value="0.35" units="cm"/>
      <inkml:brushProperty name="height" value="0.35" units="cm"/>
      <inkml:brushProperty name="color" value="#CC0066"/>
    </inkml:brush>
  </inkml:definitions>
  <inkml:trace contextRef="#ctx0" brushRef="#br0">1506 272 24575,'-24'0'0,"3"0"0,9 0 0,-3 0 0,-2 0 0,-5 4 0,2 0 0,4 3 0,2-3 0,-1 3 0,0-6 0,-5 6 0,6-3 0,-1 0 0,0 6 0,2-8 0,0 4 0,2-3 0,0-2 0,-3 5 0,-5-5 0,7 6 0,-2-7 0,-7 7 0,10-3 0,-14 1 0,16 1 0,-2-5 0,0 2 0,3-3 0,-7 4 0,7-3 0,-3 2 0,0-3 0,3 0 0,-4 0 0,2 0 0,2 0 0,-2 0 0,-1 3 0,-1-2 0,1 2 0,0 0 0,4-2 0,-4 2 0,-1-3 0,1 0 0,0 0 0,-2 4 0,4-4 0,-8 4 0,9-4 0,-2 0 0,-1 3 0,3-2 0,-2 2 0,0-3 0,2 0 0,-2 0 0,-1 0 0,3 0 0,-2 0 0,-1 0 0,3 0 0,-3 0 0,-4 0 0,6 0 0,-5 0 0,7 0 0,-11 0 0,5 0 0,-5 0 0,8 0 0,-4 0 0,6 0 0,-6 0 0,7 0 0,-3 0 0,2 0 0,-6 0 0,6 0 0,-5 0 0,5 0 0,-5 0 0,5 0 0,-3 0 0,1 0 0,-1 0 0,-4 0 0,4 0 0,1 0 0,-9 0 0,10 0 0,-14 0 0,12 0 0,-8 0 0,4-3 0,0 2 0,4-2 0,5 3 0,-4 0 0,-1 0 0,0 0 0,2 0 0,-1 0 0,2 0 0,-6 0 0,7 0 0,-4 0 0,1 0 0,2 0 0,-2 0 0,-1-4 0,3 4 0,-2-7 0,-1 6 0,3-5 0,-10 2 0,9-4 0,-13 1 0,13-1 0,-5 1 0,7 0 0,3 0 0,-2-3 0,5 2 0,-2-2 0,6 0 0,1 3 0,6-4 0,-2 4 0,3 0 0,-4 0 0,0 0 0,0 0 0,1-4 0,-1 3 0,0-4 0,1 2 0,-1 2 0,-3-2 0,2 2 0,1 4 0,1-2 0,2 2 0,-3 0 0,0-2 0,3 5 0,-3-5 0,4 5 0,-4-5 0,3 2 0,-2-3 0,3 3 0,-4-3 0,0 3 0,0-3 0,4 3 0,1-2 0,4 1 0,0-3 0,0 4 0,0-3 0,-4 6 0,3-6 0,-3 6 0,4-6 0,0 6 0,-4-6 0,3 6 0,-3-2 0,4-1 0,0 4 0,5-8 0,-4 7 0,3-6 0,-4 6 0,3-3 0,-2 1 0,9 2 0,-2-3 0,0 1 0,-4 2 0,-5-3 0,-3 4 0,11-3 0,2 2 0,-5-3 0,3 4 0,-4 0 0,-5 0 0,8 0 0,-7 0 0,9 0 0,-3 0 0,-2 0 0,-4 0 0,11 0 0,-6 0 0,17 0 0,2 0 0,-15 0 0,12 0 0,-24 0 0,0 0 0,-2 0 0,1 0 0,0 4 0,0-4 0,-1 7 0,-3-6 0,0 5 0,4-2 0,-3 3 0,2 0 0,0 0 0,-2 4 0,3-3 0,-8 2 0,4-3 0,-6 3 0,2-2 0,0 4 0,-3-4 0,3 1 0,0 1 0,1-2 0,3 2 0,-1-3 0,1-4 0,2 0 0,-1 0 0,1 1 0</inkml:trace>
</inkml:ink>
</file>

<file path=ppt/ink/ink1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2-09-27T01:59:51.790"/>
    </inkml:context>
    <inkml:brush xml:id="br0">
      <inkml:brushProperty name="width" value="0.2" units="cm"/>
      <inkml:brushProperty name="height" value="0.2" units="cm"/>
      <inkml:brushProperty name="color" value="#33CCFF"/>
    </inkml:brush>
  </inkml:definitions>
  <inkml:trace contextRef="#ctx0" brushRef="#br0">777 1 24575,'-15'7'0,"2"0"0,6 0 0,0 1 0,0-4 0,-1 2 0,1-2 0,0 0 0,0 2 0,3-2 0,-3 0 0,3 3 0,-3-6 0,0 5 0,0-2 0,0 0 0,3 2 0,-2-5 0,2 2 0,0 0 0,-3-2 0,6 5 0,-5-5 0,2 5 0,-3-2 0,1 0 0,2 2 0,-2-5 0,5 5 0,-6-5 0,4 5 0,-4-2 0,0 2 0,0-2 0,3 2 0,-2-5 0,2 2 0,0 1 0,-2-4 0,2 4 0,0-1 0,-3-2 0,3 5 0,-3-5 0,0 5 0,0-5 0,0 5 0,0-5 0,0 5 0,0-5 0,0 5 0,0-5 0,-1 5 0,1-5 0,0 5 0,0-5 0,3 5 0,-2-5 0,2 2 0,0 0 0,-2-2 0,2 6 0,-3-7 0,0 6 0,0-2 0,0 3 0,0-3 0,0 2 0,-1-2 0,2 3 0,-1-3 0,3 2 0,-3-5 0,3 5 0,-3-5 0,4 5 0,-4-5 0,3 2 0,0 0 0,-2-2 0,5 5 0,-5-5 0,2 2 0,-3 1 0,0-4 0,3 7 0,-2-6 0,2 5 0,-3-5 0,3 5 0,-2-5 0,2 2 0,-3-3 0,0 3 0,0-2 0,0 2 0,3 0 0,-2-2 0,2 5 0,-3-5 0,0 2 0,3 0 0,-2-2 0,2 2 0,0 0 0,-2-2 0,2 2 0,0 0 0,-2-2 0,3 2 0,-4-3 0,0 3 0,1-2 0,-1 2 0,3 0 0,-2-2 0,2 5 0,-3-5 0,1 2 0,-1 0 0,0-2 0,0 5 0,0-6 0,0 3 0,0 1 0,0-4 0,0 7 0,-5 5 0,7-6 0,-3 6 0</inkml:trace>
</inkml:ink>
</file>

<file path=ppt/ink/ink1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2-09-27T02:00:39.557"/>
    </inkml:context>
    <inkml:brush xml:id="br0">
      <inkml:brushProperty name="width" value="0.2" units="cm"/>
      <inkml:brushProperty name="height" value="0.2" units="cm"/>
      <inkml:brushProperty name="color" value="#33CCFF"/>
    </inkml:brush>
  </inkml:definitions>
  <inkml:trace contextRef="#ctx0" brushRef="#br0">2492 2464 24575,'-6'18'0,"5"-3"0,-5-8 0,3 0 0,2 1 0,-9-1 0,6 3 0,-4-2 0,2 2 0,5-3 0,-2 0 0,3 0 0,-3 0 0,-1 0 0,0 0 0,-2-3 0,5 2 0,-5-5 0,0 2 0,-2-3 0,-2 0 0,3 0 0,0 0 0,0 0 0,0 0 0,0 0 0,0 0 0,0 0 0,0 0 0,0-3 0,-4-1 0,3-3 0,-2-1 0,-4-2 0,6 2 0,-9-2 0,9 2 0,-3 4 0,-3-5 0,2 4 0,-3-6 0,0 7 0,4-6 0,-1 9 0,-1-12 0,1 8 0,-2-5 0,0-1 0,3 3 0,0-2 0,4 6 0,3-2 0,-2 2 0,-2-7 0,1 4 0,-4-4 0,4 7 0,0-5 0,-3 1 0,2-3 0,-6-3 0,10 6 0,-6 1 0,3-3 0,2 6 0,-8-10 0,12 6 0,-15-9 0,10 8 0,-4-4 0,0 2 0,5 0 0,-5-3 0,3 3 0,0-3 0,0 7 0,3-4 0,-2 4 0,2-3 0,-4-1 0,1-1 0,0 2 0,0 0 0,3 2 0,-6-6 0,9 6 0,-9-9 0,6 8 0,-7-13 0,6 10 0,-9-11 0,13 10 0,-13-11 0,12 14 0,-7-15 0,5 16 0,0-5 0,-3 4 0,6 2 0,-5-3 0,5 4 0,-5 0 0,5-3 0,-5 5 0,2-8 0,-7 5 0,3-7 0,-2 4 0,6 1 0,-6-1 0,2 0 0,-3-3 0,0 3 0,4 0 0,-3 4 0,2 0 0,-6-7 0,6 5 0,-2-4 0,-1 2 0,3 3 0,-2-2 0,0-4 0,2 6 0,-6-9 0,6 6 0,-2-1 0,-1-1 0,3 5 0,-2-3 0,3 4 0,-1-3 0,1 5 0,0-5 0,-3 3 0,-2-4 0,-2-3 0,3-1 0,-3 4 0,6 1 0,-2 2 0,3 1 0,-7-6 0,6 1 0,-6-3 0,0-1 0,5 7 0,-4-5 0,5 3 0,-6-7 0,-2-3 0,-1-3 0,2 5 0,4 0 0,-1 2 0,0-2 0,-3 0 0,3-1 0,1 4 0,-1-3 0,2 4 0,-6-8 0,4 6 0,-9-11 0,12 19 0,-1-9 0,3 7 0,3 3 0,-7-7 0,3 7 0,-6-2 0,2-1 0,-7-4 0,7 3 0,-6-3 0,3 1 0,-9-3 0,3-3 0,-7 4 0,4-7 0,-17-6 0,13 2 0,-13-11 0,16 13 0,-4-3 0,9 4 0,-2 1 0,9 7 0,-5-3 0,6 8 0,-4-6 0,7 9 0,-2-6 0,5 7 0,-1-4 0,-4 0 0,0 0 0,0 4 0,1-3 0,2 6 0,-2-7 0,-1 4 0,0-3 0,-3-2 0,-1 1 0,4 1 0,-3-1 0,6 7 0,-13-17 0,8 14 0,-17-17 0,6 7 0,4 1 0,-2 1 0,9 8 0,1-1 0,-10-7 0,5 2 0,-7-2 0,9 4 0,1 0 0,2 3 0,1 0 0,-4 2 0,4-2 0,0 4 0,1-3 0,3 7 0,0 0 0,1 0 0,-1 0 0,0 0 0,1 0 0,-1 0 0,1 0 0,-1 0 0,0 0 0,0 0 0,0 0 0,22 0 0,-10 0 0,18 0 0,-16 0 0,0 0 0,1 0 0,-1 0 0,0 0 0,0 0 0,0 0 0,1 0 0,-1 0 0,4 0 0,-3 0 0,7 0 0,-7 0 0,7-3 0,-7 2 0,7-3 0,-3 1 0,4 2 0,0-3 0,5 4 0,-4-3 0,4 2 0,-6-3 0,1 4 0,0 0 0,0-3 0,3 2 0,-2-6 0,2 6 0,12-10 0,-12 9 0,18-8 0,-23 6 0,8-1 0,-7-1 0,5 1 0,-4-2 0,-1 0 0,-5 0 0,2 3 0,-1-3 0,7 3 0,-9-3 0,4 3 0,1-2 0,-5 5 0,8-6 0,-9 3 0,2 0 0,0-2 0,5 2 0,-2-1 0,1 2 0,3 0 0,4-1 0,2-3 0,-5 3 0,-8-3 0,1 6 0,0-5 0,0 5 0,3-5 0,-6 5 0,-1-5 0,-1 5 0,-5-6 0,5 7 0,-11 13 0,3-6 0,-9 17 0,4-16 0,2 3 0,-1-4 0,2 0 0,0 0 0,-6 4 0,6 0 0,-4 0 0,5 0 0,0-1 0,2-2 0,-2 2 0,0 4 0,-1-5 0,0 7 0,-3-5 0,4 0 0,-1 0 0,1-4 0,3 0 0,0 0 0,-3 0 0,2 0 0,-2 1 0,3-1 0,0 0 0,0 0 0,0 0 0,0 0 0,0 1 0,0-1 0,0 0 0,0 0 0,0 0 0,0 0 0,0 1 0,0-1 0,0 0 0,0 0 0,0 0 0,0 1 0,0-1 0,0 0 0,0 0 0,0 0 0,0 1 0,0 2 0,0-2 0,3 9 0,1-8 0,3 4 0,3-2 0,-5-3 0,5 6 0,-2 1 0,4 5 0,0 0 0,2 3 0,-5-11 0,5 10 0,-2-6 0,-1 7 0,0-3 0,-7-5 0,3-4 0,-3-3 0,0-1 0,3 4 0,-3-3 0,0 3 0,3 0 0,-3-3 0,0 7 0,3-6 0,-3 5 0,3-5 0,-2 6 0,2-3 0,-3 4 0,4-4 0,0 3 0,-1-3 0,1 4 0,-3 0 0,2 0 0,-3 0 0,4 0 0,0 0 0,0-4 0,0 3 0,-1-7 0,1 7 0,-1-7 0,1 3 0,-1 0 0,0-3 0,1 3 0,-1-3 0,0-1 0,-3 4 0,3-3 0,-3 7 0,3-7 0,1 7 0,3-3 0,-2 4 0,3 0 0,-1 0 0,-2 0 0,3 0 0,-1 0 0,-2 0 0,3 0 0,-4 0 0,3 0 0,-2 0 0,2-4 0,-3 3 0,7 4 0,-5-1 0,4 1 0,-2-4 0,-4-3 0,4 4 0,-5-4 0,1 3 0,0-3 0,3 0 0,-2 3 0,3-2 0,-4-1 0,-1-1 0,1 0 0,-1-3 0,0 3 0,1-3 0,-1 3 0,0-3 0,1 3 0,0 0 0,-1-3 0,0 3 0,-3-4 0,3 5 0,-3-4 0,4 7 0,-1-7 0,1 3 0,0 0 0,-1-3 0,0 3 0,4 0 0,-2-2 0,2 6 0,0-7 0,-2 3 0,2-3 0,-4 3 0,1-3 0,3 4 0,-3-5 0,3 0 0,-3 1 0,-1-1 0,0 4 0,1-3 0,3 3 0,-3-3 0,3-1 0,-3 1 0,-1-1 0,0 0 0,0 0 0,0 0 0,1 1 0,-1-4 0,0 2 0,0-2 0,0 0 0,1 2 0,-1-5 0,0 6 0,0-7 0,0 7 0,1-6 0,-1 5 0,0-5 0,0 2 0,4 0 0,-3-2 0,4 3 0,-1-1 0,1-2 0,0 3 0,3-1 0,-7-2 0,7 6 0,-7-6 0,3 6 0,0-6 0,-3 5 0,3-5 0,-3 5 0,-1-2 0,0 0 0,0 3 0,0-3 0,1 3 0,-1 0 0,0-3 0,0 3 0,0-3 0,1 3 0,-1 0 0,0 0 0,0 0 0,0 0 0,0 1 0,-3-1 0,3 0 0,-3 0 0,3 0 0,0 1 0,0-1 0,1 0 0,-4 0 0,2 0 0,-2 4 0,4-2 0,-1 2 0,1 0 0,-1-3 0,0 3 0,1-4 0,-1 4 0,1-2 0,-1 2 0,0-4 0,0 0 0,1 0 0,-1 0 0,0 1 0,-3-1 0,-1 0 0,1-3 0,-4 2 0,7 2 0,-3-4 0,0 6 0,2-6 0,-5 3 0,2 0 0,-3-1 0,3 1 0,-2 0 0,2 0 0,-3 0 0,0 0 0,0 0 0,0 0 0,3 0 0,-2 0 0,2 0 0,-3 0 0,0 0 0,0 0 0,0 1 0,3-1 0,-2 0 0,2 0 0,-3 0 0,0 1 0,4-1 0,-4 0 0,4 0 0,-4 0 0,0 0 0,0 0 0,0 0 0,0 0 0,0-22 0,0 6 0,0-15 0,0 9 0,0 7 0,0-7 0,0 7 0,0-7 0,0 6 0,0-6 0,3 7 0,-2-3 0,2 4 0,-3 0 0,0 0 0,0-1 0,0 1 0,0 0 0,0 0 0,0 0 0,0 0 0,0-1 0,0 1 0,0 0 0,0 0 0,-3 0 0,2 0 0,-6 3 0,7-3 0,-4 3 0,1 0 0,2-2 0,-5 2 0,5-3 0,-5 0 0,5 0 0,-5 0 0,5 0 0,-2 0 0,-1 0 0,4 0 0,-4-1 0,1 4 0,2-2 0,-2 2 0,0-3 0,-1 0 0,0-1 0,-2 1 0,2 0 0,-3 0 0,-1 3 0,4-2 0,-2 2 0,2-4 0,-3 1 0,0 0 0,-1 3 0,1-2 0,-4 1 0,3 1 0,-3-3 0,4 7 0,-1-7 0,1 3 0,0 0 0,0-2 0,0 5 0,0-2 0,3 0 0,-3 2 0,3-5 0,-3 5 0,0-5 0,0 5 0,3-6 0,-3 7 0,3-7 0,-3 6 0,0-5 0,0 5 0,3-5 0,-3 5 0,3-2 0,0 0 0,-2 2 0,2-2 0,-3 3 0,0-4 0,0 1 0,-1-1 0,1-3 0,0 7 0,0-4 0,0 1 0,-4 2 0,3-5 0,-4 5 0,1-6 0,3 7 0,-7-8 0,7 4 0,-7 0 0,7-2 0,-3 2 0,0 0 0,2-3 0,-2 3 0,4-3 0,0 0 0,0 0 0,0 3 0,3-3 0,-3 3 0,3 0 0,0-2 0,-2 2 0,2-3 0,-3 3 0,3-3 0,-3 3 0,6-3 0,-5 0 0,2 3 0,-3-3 0,3 3 0,-3-3 0,3 0 0,-3 0 0,0 0 0,0 0 0,0-1 0,0 1 0,0 0 0,0 3 0,3-2 0,-3 5 0,6-5 0,-5 5 0,2-5 0,-3 2 0,0 0 0,0-2 0,0 2 0,-1 0 0,-3-3 0,3 3 0,-3-4 0,4 4 0,-4-2 0,3 1 0,-3-2 0,-1-1 0,4 1 0,-3 3 0,0-3 0,3 3 0,-3-4 0,-3 1 0,5 0 0,-6 3 0,8-2 0,0 5 0,0-6 0,-1 7 0,1-4 0,3 1 0,-2 2 0,2-2 0,0 0 0,-2 2 0,2-5 0,-3 2 0,0-3 0,1 1 0,-1-1 0,3 0 0,-3 3 0,3-3 0,0 3 0,-2-3 0,5 0 0,-5 0 0,1-8 0,-2 6 0,3-5 0,-3 7 0,3 0 0,0-4 0,-2 2 0,2-2 0,0 4 0,-2 0 0,2 0 0,-4-1 0,4 1 0,-2-4 0,2 3 0,-4-3 0,4 4 0,-3-4 0,3 2 0,-3-2 0,-1 0 0,4 3 0,-3-3 0,3 4 0,-3-4 0,-1 3 0,1-4 0,0 5 0,3-4 0,-3 3 0,3-3 0,-3 4 0,-1-8 0,1 6 0,3-5 0,-3 3 0,3 3 0,0-7 0,0 7 0,1-3 0,2 3 0,-5-3 0,5 3 0,-6-3 0,6 4 0,-5 0 0,5-1 0,-2-3 0,0 3 0,2-3 0,-2 4 0,-1 0 0,4-4 0,-4 2 0,1-2 0,-1 0 0,0 3 0,-3-7 0,2 3 0,-3-4 0,0 0 0,0 0 0,1 4 0,-1-3 0,4 3 0,-3-4 0,2 0 0,-3 0 0,0 0 0,0 0 0,0 0 0,1 4 0,-1-3 0,1 7 0,-1-7 0,0 7 0,4-3 0,-3 0 0,3 3 0,0-4 0,-3 5 0,7 0 0,-7 3 0,6-2 0,-2 2 0,0 0 0,2-3 0,-5 6 0,5-5 0,-5 2 0,5-3 0,-5 0 0,6 0 0,-3 1 0,-1-1 0,4-1 0,-3 2 0,-1-2 0,4 1 0,-4 0 0,1 0 0,2-4 0,-2 3 0,0-3 0,2 0 0,-5-2 0,5 1 0,-7-7 0,7 6 0,-6-8 0,6 5 0,-6 0 0,6 0 0,-6 0 0,6 0 0,-3 0 0,1 0 0,2 0 0,-3 4 0,4 1 0,0 4 0,0 0 0,0 0 0,0 0 0,0 0 0,0 0 0,0 1 0,0-1 0,0 0 0,-3 3 0,2-2 0,-2 2 0,3-3 0,0 0 0,0 0 0,0 0 0,0 0 0,0 0 0,0 0 0,0 0 0,0 0 0,0 0 0,0 0 0,0 0 0,0 0 0,0 0 0,0 0 0,0 0 0,0 0 0,0 0 0,0 0 0,0 0 0,0 0 0,0 0 0,0 23 0,-3-11 0,-1 23 0,-4-20 0,1 3 0,-1 0 0,1-3 0,-1 3 0,1-4 0,0 1 0,3-1 0,-2-3 0,2 2 0,-4-5 0,1 2 0,0-3 0,0 0 0,0 0 0,0 0 0,0 0 0,0 0 0,0 0 0,0 0 0,0 0 0,0 0 0,-1 0 0,1 0 0,0 3 0,0-2 0,0 2 0,0 0 0,0-2 0,0 2 0,3 0 0,-2-2 0,2 2 0,-3-3 0,1 0 0,2 3 0,4 4 0,4 1 0,3-1 0,1-1 0,3-1 0,-3 2 0,3 1 0,0-1 0,-3 0 0,3 1 0,-3-1 0,-1 0 0,0 1 0,3 2 0,-2-2 0,3 2 0,-7-2 0,2 2 0,-2-5 0,0 4 0,3-5 0,-3 4 0,3-1 0,0 3 0,0-2 0,0 2 0,0-3 0,-3 0 0,3-3 0,-7 3 0,7-3 0,-3 3 0,0 0 0,2 0 0,-5 0 0,5 1 0,-2-1 0,0 0 0,3 4 0,-3-3 0,1 7 0,5 1 0,-5 7 0,2-6 0,0 5 0,-2-6 0,-1-3 0,3 1 0,-6-4 0,8 2 0,-7 2 0,11 4 0,-11-6 0,11 13 0,-4-9 0,-1 7 0,1-8 0,-8-4 0,6-4 0,-3 3 0,3-2 0,0 3 0,1 3 0,-1-2 0,4 10 0,-3-2 0,3 0 0,-7-5 0,3 0 0,-3-7 0,4 10 0,6-2 0,-9 3 0,8-1 0,-9-3 0,6 0 0,-5-4 0,5-1 0,-9-2 0,5-1 0,-2 0 0,3 3 0,0-2 0,0 2 0,-3-3 0,2 0 0,-2-3 0,0 2 0,2-2 0,2 4 0,-4-1 0,6 0 0,-3 0 0,-2 1 0,5-4 0,-6 2 0,3-2 0,0 6 0,3 2 0,-2-1 0,9 6 0,-4-2 0,1 1 0,-3-2 0,-7-7 0,2 0 0,1 4 0,1 0 0,0 0 0,-2 0 0,-2-1 0,3-2 0,-3 3 0,2-4 0,-2 0 0,0-1 0,3-2 0,-7 2 0,7-2 0,-4 3 0,4 0 0,-3 0 0,2 0 0,-5 0 0,5-4 0,-5 4 0,5-3 0,-5 3 0,5-3 0,-5 2 0,5-5 0,-2 5 0,0-2 0,3 3 0,-3 4 0,0-4 0,2 0 0,-5-1 0,5-2 0,-2 3 0,3 3 0,0-2 0,4 2 0,-3-2 0,-1-1 0,-1-3 0,-5 2 0,5-2 0,-2 3 0,3 0 0,-3 0 0,2 0 0,1 1 0,8 5 0,-3-4 0,5 8 0,-9-9 0,2 2 0,-6-3 0,6 8 0,-5-6 0,6 5 0,-4-7 0,6 7 0,-4-5 0,2 4 0,-2-2 0,-7-3 0,7-1 0,-5-1 0,4-2 0,-4 3 0,5 0 0,-7 1 0,7 2 0,-5-6 0,3 6 0,0-6 0,-3 3 0,2 0 0,-2 0 0,3 0 0,1 1 0,-1 2 0,0-2 0,0-1 0,0 3 0,1-2 0,2 3 0,-2-1 0,2-3 0,-3 0 0,-3 0 0,2-3 0,-2 3 0,3-3 0,1 3 0,-1 0 0,-3 0 0,2 0 0,-2 0 0,3 1 0,0-1 0,0 0 0,1 0 0,-1 0 0,0 0 0,6 7 0,-4-5 0,8 7 0,-9-8 0,9 13 0,-8-11 0,12 11 0,-12-9 0,6-1 0,-4 1 0,-3-5 0,7 4 0,-4 0 0,0 0 0,-1 0 0,1-4 0,-3 0 0,2-3 0,-6 2 0,2-5 0,-2 2 0,3 0 0,0-2 0,-1 2 0,1 0 0,0-3 0,0 4 0,0-4 0,-4 3 0,3-2 0,-2 5 0,3-3 0</inkml:trace>
</inkml:ink>
</file>

<file path=ppt/ink/ink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2-09-27T01:52:36.441"/>
    </inkml:context>
    <inkml:brush xml:id="br0">
      <inkml:brushProperty name="width" value="0.35" units="cm"/>
      <inkml:brushProperty name="height" value="0.35" units="cm"/>
      <inkml:brushProperty name="color" value="#66CC00"/>
    </inkml:brush>
  </inkml:definitions>
  <inkml:trace contextRef="#ctx0" brushRef="#br0">4731 4722 24575,'-66'4'0,"3"-1"0,23-3 0,-9 0 0,9 0 0,-35 0 0,7 0 0,10 0 0,-1 0 0,-7 0 0,11 0 0,3 0 0,8 0 0,-17 0 0,6 0 0,13-4 0,-8 3 0,18-4 0,6 1 0,0 4 0,0-8 0,4 7 0,-3-7 0,8 4 0,-4-1 0,1-3 0,3 7 0,-4-6 0,5 6 0,0-6 0,0 6 0,0-6 0,1 6 0,-6-2 0,4-1 0,-8 3 0,8-2 0,-8 3 0,3-4 0,-4 3 0,-1-3 0,1 0 0,0 3 0,-6-7 0,5 7 0,-5-7 0,1 7 0,3-7 0,-9 3 0,10 0 0,-10-4 0,9 4 0,-8 0 0,8-3 0,-9 3 0,10 0 0,-10-3 0,4 2 0,-5-3 0,0-1 0,-6 0 0,4 1 0,-10-1 0,11-4 0,-5 3 0,0-8 0,4 8 0,-4-3 0,11 5 0,-4-5 0,10 4 0,-5-3 0,6 4 0,0 0 0,0-3 0,-1 2 0,6-2 0,-4-1 0,3 4 0,-4-4 0,-1 1 0,6 2 0,-4-6 0,3 6 0,-4-2 0,0-1 0,-6 3 0,4-7 0,-3 7 0,-1-7 0,5 3 0,-10-5 0,4 1 0,-6-6 0,6 4 0,-6-4 0,11 1 0,-4 4 0,4-8 0,1 8 0,0-3 0,0-1 0,-1 0 0,5 0 0,-4-4 0,5 9 0,-6-10 0,5 6 0,-3-2 0,3-2 0,-4 7 0,4-7 0,-4 2 0,9-2 0,-9 3 0,10 2 0,-9-1 0,8 4 0,-4-8 0,1 8 0,3-2 0,-2 3 0,4 1 0,-6-6 0,5 5 0,-5-9 0,6 9 0,-1-4 0,0 1 0,0-2 0,1 1 0,-2-5 0,5 5 0,-2-1 0,1-3 0,-3 3 0,0-4 0,-8-12 0,4 4 0,-4-6 0,7 9 0,-8-7 0,11 9 0,-17-21 0,16 21 0,-5-9 0,-3 0 0,4-8 0,-16-18 0,-5-19 0,10 21 0,-8-17 0,19 38 0,-2-3 0,-1-10 0,3 17 0,-2-13 0,7 14 0,2 3 0,4 0 0,4-4 0,-3 10 0,7-5 0,-3 6 0,1-8 0,2-1 0,-3 5 0,4 2 0,0 9 0,0 2 0,0-6 0,0-6 0,-4-11 0,-4-8 0,-3-9 0,-1 15 0,2-7 0,1 10 0,0-1 0,4 1 0,1 7 0,4-13 0,0 19 0,0-20 0,0 32 0,0-8 0,0 10 0,3-2 0,1-2 0,4 1 0,3-4 0,5-5 0,-3 7 0,2-10 0,0 7 0,3-14 0,14-15 0,-8 10 0,8-13 0,-7 10 0,-6 5 0,0 1 0,-4 9 0,2 2 0,0 0 0,-2 2 0,0 0 0,2 2 0,7-15 0,-3 14 0,-5-6 0,6 5 0,-8 5 0,9-5 0,-3 0 0,0-2 0,1 1 0,-2 4 0,4-2 0,9-6 0,-1 4 0,12-13 0,-15 22 0,17-14 0,-4 7 0,11-4 0,-11 7 0,-3-1 0,-12 10 0,1-3 0,6 1 0,2-1 0,3-3 0,-4 6 0,-10 0 0,3 5 0,-9-3 0,5 0 0,0 4 0,7-4 0,7 4 0,1-1 0,-9 2 0,6-1 0,-11 3 0,28-3 0,-21 4 0,14 0 0,-7 0 0,-9-4 0,14 3 0,-4-3 0,7 4 0,-5 0 0,-3 0 0,-5 0 0,-5 0 0,5 0 0,1 0 0,1-4 0,-5 3 0,3-3 0,12 4 0,-13 0 0,17 0 0,-6 0 0,-12 0 0,19 0 0,-22 0 0,24 0 0,-21 0 0,21 0 0,-24 0 0,20 4 0,-18 1 0,6 0 0,-9 3 0,-2-4 0,11 4 0,2 4 0,4-3 0,-7 4 0,-1-5 0,4 5 0,-9-4 0,26 8 0,-25-7 0,19 3 0,-10 4 0,7 2 0,-5-1 0,-3 3 0,7 0 0,-14-2 0,21 13 0,-17-9 0,7 6 0,0-1 0,-4-2 0,6 13 0,-18-16 0,4 7 0,-14-14 0,7 7 0,-5-5 0,9 12 0,-11-12 0,4 5 0,0 4 0,4 4 0,7 16 0,-5-16 0,-1 6 0,-1-8 0,2 6 0,7 7 0,-10-11 0,0 1 0,-3-8 0,-1 3 0,1-3 0,6 15 0,-14-18 0,17 21 0,-15-17 0,5 0 0,-3 1 0,-4-9 0,-1 2 0,1 4 0,4 2 0,-3-1 0,3 4 0,-1 1 0,3 6 0,7 7 0,-4-7 0,0-2 0,9 17 0,-11-22 0,14 32 0,-15-36 0,3 14 0,-3-12 0,-1 1 0,9 11 0,-8-14 0,4 13 0,-7-15 0,-1 4 0,0 0 0,5 7 0,-4-5 0,5 6 0,-2 4 0,3 3 0,-2-1 0,-1 3 0,-2-4 0,2 8 0,0 0 0,-1-7 0,-4-7 0,3 17 0,-5-18 0,10 35 0,-11-25 0,3 9 0,0 5 0,-3-20 0,7 24 0,-7-29 0,7 29 0,-7-24 0,4 8 0,-1 5 0,4-7 0,2 15 0,3-3 0,-9-13 0,3 4 0,-6-21 0,5 11 0,-2-11 0,-1 8 0,3 0 0,-6-4 0,-2-4 0,0 6 0,-2-12 0,3 15 0,-4-19 0,0 8 0,-1 2 0,2-2 0,-1 7 0,3-10 0,-6 0 0,6 1 0,-6 0 0,3-5 0,-1 7 0,-2-5 0,3 3 0,-4-2 0,3-6 0,-2 10 0,2-9 0,-3 8 0,0-9 0,0 6 0,0-6 0,0 5 0,0-2 0,0-3 0,0 2 0,0 1 0,0-6 0,0 5 0,0 0 0,0-2 0,0 10 0,0-9 0,0 1 0,0-4 0,0-2 0,0 7 0,0-7 0,0 9 0,0-8 0,0 8 0,0-6 0,-7 3 0,3 1 0,-10-1 0,6-3 0,-9 10 0,5-8 0,-3 9 0,4-10 0,0 2 0,7-6 0,-6 2 0,3 1 0,-1-3 0,-3 2 0,4-3 0,1-3 0,-4 5 0,2-4 0,-2 4 0,3-5 0,0 2 0,0-2 0,-4 4 0,6-1 0,-4 0 0,5 0 0,-3 0 0,-1 1 0,1-1 0,0 0 0,0 0 0,0-3 0,-1 3 0,1-3 0,0 3 0,-3-3 0,5 2 0,-4-2 0,2 0 0,-1-1 0,-2 0 0,0-2 0,2 5 0,-2-5 0,3 6 0,-3-7 0,2 7 0,-2-6 0,2 5 0,-2-5 0,2 5 0,-2-5 0,3 6 0,-4-3 0,3 0 0,-2 2 0,3-5 0,-1 5 0,-2-5 0,2 5 0,-2-5 0,-1 6 0,3-7 0,-2 4 0,0-1 0,2-2 0,-3 5 0,4-2 0,0 0 0,-3-1 0,2-3 0,-2 3 0,1 1 0,1 0 0,-2-1 0,0-3 0,2 0 0,-1 3 0,-2-2 0,4 2 0,-3 0 0,-1-2 0,4 5 0,-4-5 0,2 2 0,1 0 0,-2-3 0,3 3 0</inkml:trace>
</inkml:ink>
</file>

<file path=ppt/ink/ink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2-09-27T01:52:44.510"/>
    </inkml:context>
    <inkml:brush xml:id="br0">
      <inkml:brushProperty name="width" value="0.35" units="cm"/>
      <inkml:brushProperty name="height" value="0.35" units="cm"/>
      <inkml:brushProperty name="color" value="#66CC00"/>
    </inkml:brush>
  </inkml:definitions>
  <inkml:trace contextRef="#ctx0" brushRef="#br0">4832 767 24575,'-7'-41'0,"1"-4"0,-15 21 0,6-8 0,-13-2 0,-4-6 0,0 3 0,2 2 0,3 8 0,5 9 0,-1-4 0,2 5 0,1 5 0,3-4 0,-8 7 0,8-3 0,-4 0 0,5 4 0,-4-4 0,2 4 0,-2-4 0,4 3 0,0-3 0,-4 4 0,2 0 0,-2 0 0,4 0 0,0 0 0,0 0 0,-4-1 0,2 5 0,-2-7 0,-1 5 0,4-5 0,-8 2 0,3 1 0,-4-1 0,-17-8 0,7 6 0,-13-6 0,10 7 0,1 1 0,0-1 0,0 0 0,-6 1 0,5-1 0,0 0 0,2 5 0,9-3 0,-8 3 0,8 0 0,-3-3 0,9 7 0,-3-3 0,3 0 0,1 3 0,-5-2 0,5 3 0,-6 0 0,1 0 0,0 0 0,0 0 0,-1 0 0,1 0 0,0 0 0,0 0 0,-1 0 0,1 0 0,0 0 0,-12 0 0,9 0 0,-14 0 0,15 0 0,-3 0 0,4 0 0,6 0 0,-4 0 0,3 0 0,-4 3 0,4-2 0,-3 7 0,3-3 0,-4 0 0,0 3 0,4-7 0,-3 6 0,-2-1 0,4 2 0,-7 1 0,3 0 0,-1 0 0,-3 0 0,4 0 0,1-1 0,-5 1 0,3 4 0,-3-3 0,4 3 0,1 0 0,4-4 0,-3 3 0,4 1 0,-5-4 0,4 7 0,2-7 0,-1 7 0,4-7 0,-4 7 0,1-7 0,3 6 0,-4-5 0,1 1 0,3 1 0,-8-2 0,7 1 0,-2 1 0,-1-3 0,0 7 0,-6-6 0,1 2 0,0 1 0,0-3 0,0 2 0,-6-3 0,5 0 0,-5 4 0,6-3 0,0 3 0,-1-5 0,1 1 0,0 0 0,-1 0 0,6-1 0,-4 1 0,8-1 0,-9 0 0,9 1 0,-3-1 0,4 0 0,0 0 0,0 0 0,4-1 0,-3 1 0,3 0 0,-4 3 0,0-2 0,0 3 0,0-1 0,4-2 0,-3 2 0,3 0 0,-4-2 0,0 3 0,0-1 0,0-2 0,0 3 0,0-1 0,0-2 0,-4 7 0,3-7 0,-4 7 0,1-3 0,2-1 0,-2 4 0,4-3 0,0-1 0,0 3 0,-4-2 0,2 0 0,-2 2 0,4-2 0,-5 3 0,4-3 0,-3 3 0,-1-3 0,4 3 0,-3 1 0,-1-1 0,4 0 0,-4 1 0,6-1 0,-1 0 0,0 0 0,-5 1 0,3 3 0,-7-1 0,2 7 0,1-8 0,-4 4 0,8-1 0,-8-2 0,4 2 0,0-4 0,1 4 0,1-3 0,2 2 0,-3-3 0,5-1 0,0 5 0,-1-4 0,4 3 0,-2 1 0,2-4 0,0 8 0,-3-3 0,6 4 0,-7 0 0,3 6 0,0 1 0,-3-1 0,6 5 0,-1-9 0,2 9 0,1-10 0,-4 10 0,7-10 0,-7 5 0,8-6 0,-3 1 0,3-1 0,-3-5 0,7 0 0,-2 0 0,-1-4 0,4 3 0,-4-4 0,4 0 0,0 0 0,0 0 0,0 4 0,0-2 0,0 2 0,-4-4 0,4 0 0,-4 4 0,4-2 0,0 2 0,0-4 0,0-4 0,0 3 0,0-3 0,0 0 0,0 3 0,0-3 0,0 4 0,0 0 0,0-4 0,0 3 0,0-3 0,0 4 0,4 0 0,-4-4 0,8 3 0,-8-3 0,7 4 0,-2 0 0,3-4 0,-4 3 0,3-3 0,-3 4 0,4 0 0,0 0 0,0-4 0,0 3 0,-1-3 0,1 0 0,0 3 0,-1-7 0,1 4 0,-1-1 0,0-3 0,1 3 0,3-4 0,-3 1 0,7 0 0,-3-1 0,4 1 0,0 4 0,0-3 0,0 2 0,5-3 0,-4 0 0,3 4 0,-4-3 0,0 3 0,0-4 0,5 0 0,-8 0 0,6 0 0,-7 0 0,0-1 0,3 1 0,-6-1 0,6 1 0,-7-4 0,3 3 0,-4-6 0,3 5 0,-2-5 0,3 2 0,3 1 0,-5-4 0,5 4 0,-6-1 0,-1-2 0,3 2 0,2-3 0,0 0 0,-1 0 0,-4 3 0,3-2 0,2 2 0,-1-3 0,1 0 0,-1 0 0,-3 0 0,7 0 0,-3 0 0,4 0 0,0 0 0,0 0 0,0 0 0,0 0 0,0 0 0,0 0 0,0 0 0,0 0 0,-1 0 0,1 0 0,0 0 0,-4 0 0,3 0 0,-2 0 0,2 0 0,1 0 0,0 0 0,-4 0 0,3 0 0,-6 0 0,6 0 0,-7 0 0,7 0 0,-7 0 0,7 0 0,-7 0 0,7 0 0,-7 0 0,3 0 0,0 0 0,-2 0 0,2 0 0,0 0 0,-3 0 0,3 0 0,3 0 0,-5 0 0,6-3 0,-8 2 0,4-2 0,-3 3 0,3-3 0,3 2 0,-5-2 0,6-1 0,-4 4 0,-3-4 0,7 1 0,-3 2 0,0-3 0,3 1 0,-3 2 0,4-6 0,0 2 0,0 1 0,0-3 0,0 6 0,4-6 0,-3 2 0,4 0 0,-1-2 0,-2 2 0,7 1 0,-8-4 0,3 4 0,-4 0 0,5-4 0,-4 4 0,3-5 0,1 5 0,-4-3 0,15 2 0,-13-3 0,13 0 0,-15 4 0,8-4 0,-8 3 0,9 0 0,-9-2 0,8 6 0,-4-6 0,6 6 0,-1-3 0,0 0 0,1 3 0,-1-3 0,0 4 0,0-3 0,0 2 0,0-3 0,1 4 0,11 0 0,-9 0 0,9 0 0,-5-4 0,2 3 0,7-3 0,-11 0 0,-3 4 0,-1-4 0,-8 4 0,39-4 0,-30 4 0,31-4 0,-35 4 0,8 0 0,-10 0 0,-1 0 0,5 0 0,-5 0 0,1 0 0,3 0 0,-3 0 0,4 0 0,-4 0 0,10 0 0,-9 0 0,6 4 0,3 0 0,-6 4 0,4 1 0,-7-5 0,4 4 0,-1-4 0,4 1 0,-7 2 0,0-3 0,9 4 0,-6 0 0,12-3 0,-9 2 0,-3-6 0,13 2 0,-15-3 0,9 4 0,0-3 0,2 3 0,1-4 0,-3 0 0,0 0 0,7 0 0,-8 0 0,4 0 0,-11 0 0,4 0 0,4 0 0,-1 0 0,-2 0 0,1 0 0,-9 0 0,1 0 0,-3 0 0,3 0 0,2 0 0,2 0 0,-11 0 0,5 0 0,-8 0 0,9 0 0,-9 0 0,1 0 0,1-3 0,-6 2 0,5-6 0,-4 3 0,9-10 0,-2 5 0,8-9 0,-5 3 0,-4 2 0,2-5 0,-2 2 0,-3-1 0,9-9 0,-1-6 0,-3 5 0,4-15 0,-9 12 0,7-19 0,-6 16 0,1-8 0,-10 20 0,-2 1 0,-3 1 0,0 4 0,0 2 0,0-5 0,0 3 0,0-5 0,0 0 0,0-2 0,0 5 0,0-9 0,0 8 0,0-29 0,0 16 0,0-49 0,0 34 0,0-20 0,0 27 0,0-16 0,0 1 0,0-4 0,0 14 0,4 1 0,-3 14 0,7-5 0,-7 2 0,5 10 0,-5-6 0,6 8 0,-3-2 0,0 1 0,-1 2 0,15-63 0,-14 47 0,13-45 0,0-5 0,-9 25 0,3-7 0,-1 1 0,-6 20 0,-1-3 0,-3 30 0,0 5 0,0 7 0,0-3 0,0 2 0,0-5 0,0 3 0</inkml:trace>
</inkml:ink>
</file>

<file path=ppt/ink/ink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2-09-27T01:52:55.602"/>
    </inkml:context>
    <inkml:brush xml:id="br0">
      <inkml:brushProperty name="width" value="0.2" units="cm"/>
      <inkml:brushProperty name="height" value="0.2" units="cm"/>
      <inkml:brushProperty name="color" value="#5B2D90"/>
    </inkml:brush>
  </inkml:definitions>
  <inkml:trace contextRef="#ctx0" brushRef="#br0">2345 1075 24575,'0'-20'0,"-4"-3"0,-1 1 0,-3 0 0,-1-3 0,-3-3 0,-18-24 0,12 17 0,-11-9 0,21 28 0,-7-12 0,2 6 0,-3-6 0,4 9 0,1-1 0,2 4 0,-2 0 0,3 5 0,-6-6 0,-1-3 0,-1 0 0,2 2 0,4 8 0,-2-5 0,1 2 0,-4-1 0,3-1 0,-7 3 0,7-4 0,-6 2 0,2 2 0,-15-11 0,9 9 0,-5-8 0,12 13 0,0-5 0,-5 5 0,-3-6 0,6 7 0,-8-7 0,11 10 0,-5-5 0,-3 2 0,5-4 0,-3 0 0,2 5 0,-1-3 0,-2 1 0,-15-7 0,14 4 0,-5 3 0,-8-5 0,10 11 0,-23-15 0,25 12 0,-10-6 0,16 8 0,-8-4 0,4 3 0,-6-4 0,6 4 0,-4-2 0,8 2 0,-4 0 0,5-2 0,0 3 0,0-1 0,-7-2 0,5 3 0,-5-1 0,0-5 0,-1 4 0,-1-2 0,2 1 0,-5 3 0,2-1 0,-3-2 0,1 6 0,4-3 0,-10 1 0,-4 2 0,-4-3 0,11 4 0,4 0 0,5 0 0,4 0 0,-4 0 0,2 0 0,0 0 0,4 0 0,-2 0 0,3 0 0,-9 4 0,3 0 0,-2 4 0,4 3 0,3-2 0,-3 2 0,8-4 0,-4 7 0,7-5 0,-2 8 0,-1-6 0,3 0 0,-2 7 0,2-9 0,-10 23 0,8-16 0,-9 14 0,4-7 0,2-6 0,-3 7 0,1-1 0,2 1 0,1-3 0,1 1 0,-1-2 0,0 9 0,-1-3 0,1 6 0,0-8 0,-4 17 0,2-13 0,-1 10 0,11-21 0,-7 9 0,9-8 0,-9 9 0,6 2 0,0 11 0,-2-9 0,2 30 0,1-38 0,0 25 0,4-15 0,0 2 0,0 4 0,0 15 0,0 17 0,0-8 0,0 32 0,0-34 0,4 4 0,-3-10 0,8 6 0,-4-22 0,4 54 0,0-51 0,0 41 0,1-42 0,-1 9 0,5 11 0,9-1 0,3 23 0,11-7 0,5 12 0,-11-32 0,12 22 0,-27-43 0,9 10 0,-3 3 0,6 6 0,0-5 0,1 18 0,-14-37 0,6 25 0,-11-26 0,6 21 0,-6-21 0,3 26 0,-4-19 0,-3 8 0,-2 5 0,-4-7 0,0 21 0,0-4 0,0-7 0,0-7 0,4 3 0,1 0 0,0 4 0,2-7 0,-2 3 0,0-12 0,3 9 0,-3-2 0,7 5 0,-6-10 0,5 6 0,-10-23 0,6 24 0,-6-18 0,3 24 0,-4-32 0,0 15 0,0-11 0,0 1 0,0 3 0,0-2 0,0 0 0,0-2 0,0 5 0,0-5 0,-4 6 0,0 3 0,-4-8 0,-1 9 0,-3 12 0,2-14 0,-2 14 0,-1-2 0,3-12 0,-11 29 0,9-24 0,-9 20 0,11-22 0,-3 9 0,0-3 0,-1 16 0,-4-1 0,0-3 0,4-14 0,-2 0 0,6-14 0,-2 13 0,-3-10 0,5-3 0,-8 5 0,7-10 0,2-3 0,0-2 0,5-4 0,0-2 0,-3-1 0,7-1 0,-9-2 0,7 3 0,-7 4 0,4 1 0,-7 8 0,-1 2 0,-5 4 0,5 6 0,-4-5 0,3 5 0,0-6 0,2 0 0,3-4 0,1-2 0,0-4 0,4 0 0,-3-4 0,6-1 0,-2-3 0,3-1 0,0-3 0,0-1 0</inkml:trace>
</inkml:ink>
</file>

<file path=ppt/ink/ink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2-09-27T01:52:58.784"/>
    </inkml:context>
    <inkml:brush xml:id="br0">
      <inkml:brushProperty name="width" value="0.2" units="cm"/>
      <inkml:brushProperty name="height" value="0.2" units="cm"/>
      <inkml:brushProperty name="color" value="#5B2D90"/>
    </inkml:brush>
  </inkml:definitions>
  <inkml:trace contextRef="#ctx0" brushRef="#br0">0 0 24575,'0'24'0,"0"-4"0,0 1 0,0-1 0,0-3 0,0 9 0,0-5 0,0 1 0,0 10 0,0-3 0,0 1 0,0 0 0,0-8 0,0 4 0,0 1 0,0-1 0,4 5 0,-3-3 0,7 3 0,-3-4 0,4-1 0,-4 5 0,3-3 0,-3 9 0,0-10 0,3 5 0,-3-6 0,0-4 0,2 3 0,-6-8 0,7 4 0,-7-6 0,6 1 0,-6 0 0,6 0 0,-6 0 0,2 0 0,1 0 0,-3 0 0,6 0 0,-6 0 0,6 0 0,-3 0 0,1 0 0,2 0 0,-3 0 0,1 0 0,2 0 0,-3 0 0,4 4 0,1-3 0,-1 8 0,0-7 0,1 7 0,-1-8 0,1 8 0,-1-4 0,0 1 0,1 3 0,-1-8 0,0 4 0,0-5 0,1 4 0,-5-2 0,4 2 0,-7 1 0,6-4 0,-6 8 0,2-8 0,1 8 0,-3-8 0,3 8 0,-4-3 0,0 0 0,0 3 0,0-4 0,0 1 0,0 3 0,0-3 0,0 0 0,0 3 0,3-8 0,-2 8 0,3-8 0,-4 3 0,0-4 0,4 5 0,-3-4 0,3 4 0,-1-5 0,-2 0 0,3 4 0,-1-3 0,-2 4 0,6-5 0,-6 0 0,6 0 0,-2 0 0,-1-1 0,3 6 0,-6-4 0,3 4 0,0-1 0,-3-3 0,7 4 0,-8-5 0,8 0 0,-8 0 0,4-1 0,-4 1 0,0 0 0,0 5 0,0-4 0,0 8 0,0-3 0,0 4 0,0 0 0,0 1 0,0-1 0,0 5 0,0-3 0,0 3 0,0-4 0,0-1 0,0-4 0,0 3 0,0-4 0,-4 1 0,0 3 0,-1-3 0,-2 0 0,2 3 0,0-4 0,-2 1 0,2 3 0,1-8 0,-4 8 0,7-8 0,-7 4 0,8 0 0,-8-4 0,8 3 0,-7-4 0,6 5 0,-6-4 0,2 3 0,1 1 0,-3-4 0,2 8 0,-3-8 0,-1 8 0,5-3 0,-4 4 0,3 0 0,-4 1 0,-3-1 0,2 0 0,-3 0 0,4 1 0,1-1 0,-5 0 0,3 0 0,-2 0 0,-1 1 0,4-6 0,-4 4 0,5-8 0,0 4 0,0-5 0,0 0 0,0 0 0,0-4 0,4-1 0,1-4 0,0 0 0,2 1 0,-2-1 0,3 0 0,0 0 0,0 0 0,-4 0 0,4 0 0,-4 1 0,1-2 0,3 2 0,-7-1 0,3 0 0,-3-3 0,0 2 0,-4-1 0,6-1 0,-2-1 0</inkml:trace>
</inkml:ink>
</file>

<file path=ppt/ink/ink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2-09-27T01:53:05.684"/>
    </inkml:context>
    <inkml:brush xml:id="br0">
      <inkml:brushProperty name="width" value="0.2" units="cm"/>
      <inkml:brushProperty name="height" value="0.2" units="cm"/>
      <inkml:brushProperty name="color" value="#5B2D90"/>
    </inkml:brush>
  </inkml:definitions>
  <inkml:trace contextRef="#ctx0" brushRef="#br0">363 251 24575,'-19'0'0,"4"0"0,1 0 0,2 0 0,0 0 0,-2 0 0,3 7 0,-1 2 0,-13 28 0,14-15 0,-15 22 0,17-26 0,-2 5 0,3-7 0,0 0 0,0-1 0,0 1 0,0 0 0,-4 0 0,3 0 0,-2-4 0,3 3 0,1-6 0,-1 6 0,0 0 0,1-2 0,-1 1 0,1 0 0,-1 6 0,-3 8 0,3 0 0,0 1 0,1-9 0,6 0 0,-2-4 0,3 12 0,0-2 0,0 20 0,0-8 0,0 2 0,4-7 0,0-11 0,27 29 0,-11-24 0,16 20 0,-17-31 0,1 3 0,-3-9 0,9 12 0,-8-12 0,8 8 0,-9-9 0,2 2 0,0 3 0,1-1 0,3 6 0,-3-7 0,-4-1 0,2 0 0,-5-3 0,2 3 0,7 7 0,-5-4 0,2 4 0,6-3 0,-16-7 0,9 3 0,-4-1 0,2-1 0,8 5 0,-5-5 0,-3 2 0,6 0 0,-8-2 0,9-1 0,0 2 0,13 3 0,-8 0 0,18 3 0,-20-4 0,8-6 0,-9 4 0,23-5 0,-21 3 0,23-3 0,-24-1 0,0 0 0,1-3 0,-1 3 0,17-4 0,-12 0 0,12 0 0,0 0 0,-6 0 0,20 0 0,-25 0 0,4 0 0,-7 0 0,6 0 0,8 0 0,-1 0 0,-12 0 0,2-4 0,-14 3 0,14-7 0,-2 3 0,24-7 0,-2-2 0,-3 5 0,6-6 0,-30 10 0,10-4 0,-12 2 0,-2 3 0,2-4 0,-3 3 0,-1-1 0,4 1 0,-6 1 0,7-3 0,-12 3 0,7 0 0,-8-3 0,3 3 0,-6 0 0,2-2 0,-3 5 0,7-5 0,-5 2 0,4 0 0,1-6 0,-5 8 0,7-10 0,-8 10 0,3-8 0,-1 6 0,-2-3 0,3 3 0,-1-2 0,1 2 0,0-3 0,3-1 0,-6 1 0,6 0 0,-6 3 0,2-3 0,-3 3 0,4-3 0,-3 0 0,2-3 0,-3 5 0,4-8 0,-3 8 0,2-2 0,0-3 0,2 6 0,-1-7 0,6 1 0,-9 2 0,6 1 0,0-3 0,-6 8 0,6-7 0,-7 5 0,0-3 0,0 0 0,-3 0 0,2 3 0,-5-2 0,5 5 0,-5-8 0,6 7 0,-7-7 0,4 5 0,-4-7 0,3 3 0,-3-5 0,6 5 0,-1-9 0,-1 5 0,2-6 0,-2 6 0,4-1 0,-4 5 0,2-6 0,-5 5 0,9-12 0,-8 7 0,7-11 0,-4 8 0,2-1 0,1 2 0,-4 1 0,3-5 0,-3 0 0,0 0 0,3 1 0,-2-4 0,3-2 0,-4 1 0,3 1 0,-2-12 0,3 14 0,-4-21 0,0 25 0,-4-6 0,3 0 0,-2 9 0,3-12 0,-4 14 0,0-4 0,0-6 0,0 1 0,0-3 0,0-4 0,0 4 0,0-10 0,0 8 0,0-2 0,-4 5 0,-4-1 0,0 3 0,-3 1 0,4 8 0,0 4 0,0-1 0,0 5 0,-1 0 0,5-2 0,-4 5 0,3-5 0,-3 5 0,-3-5 0,2 2 0,-2 0 0,3-2 0,-1 5 0,1-2 0,0 3 0,0-3 0,0 2 0,0-6 0,-1 7 0,1-4 0,0 1 0,-4 2 0,3-2 0,-3 0 0,3 2 0,1-2 0,0 3 0,0-3 0,-4 2 0,3-2 0,-3 3 0,-1-4 0,4 3 0,-3-2 0,0-1 0,3 3 0,-6-2 0,6 3 0,-6-3 0,6 2 0,-2-6 0,6 3 0,-3 0 0,6-2 0,-5 5 0,5-5 0,-2 0 0,3-2 0,0-1 0,0 2 0,0 0 0,0 1 0,0-1 0</inkml:trace>
</inkml:ink>
</file>

<file path=ppt/ink/ink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2-09-27T01:59:00.631"/>
    </inkml:context>
    <inkml:brush xml:id="br0">
      <inkml:brushProperty name="width" value="0.2" units="cm"/>
      <inkml:brushProperty name="height" value="0.2" units="cm"/>
      <inkml:brushProperty name="color" value="#33CCFF"/>
    </inkml:brush>
  </inkml:definitions>
  <inkml:trace contextRef="#ctx0" brushRef="#br0">1343 2379 24575,'-3'-15'0,"2"2"0,-2 6 0,3 0 0,0-10 0,-4-3 0,0 1 0,-4-6 0,1 9 0,2-4 0,-1 5 0,1-7 0,1 12 0,-3-16 0,3 7 0,-4 2 0,4-3 0,-3 8 0,6 1 0,-2-2 0,3 5 0,-3-3 0,2 4 0,-2 0 0,0 0 0,2 0 0,-5-1 0,2 1 0,-4-3 0,4 2 0,-2 1 0,2-3 0,-3 6 0,0-10 0,3 6 0,-6-9 0,8 8 0,-11-16 0,8 16 0,-5-9 0,-1 4 0,3 5 0,-3-9 0,0 2 0,-1-4 0,0 0 0,1 5 0,0-7 0,-1 5 0,-7-14 0,6 10 0,-2 2 0,7 4 0,1 3 0,-1 0 0,0-3 0,0 3 0,0-4 0,1 4 0,-1-3 0,4 7 0,-3-7 0,3 7 0,-1-7 0,-1 6 0,-1-12 0,2 11 0,-5-14 0,6 15 0,-1-6 0,-1 1 0,-2 2 0,0-10 0,-2 6 0,2-6 0,-2 7 0,1-4 0,2 7 0,-4-6 0,7 9 0,-11-16 0,-1 8 0,-1-14 0,-6 2 0,10 4 0,-2 6 0,4-3 0,-1 8 0,-1-9 0,-9-7 0,8 4 0,-5-6 0,4 1 0,-1 7 0,-1-4 0,1 4 0,5 5 0,0-4 0,2 5 0,-6-12 0,-1 5 0,3 4 0,-2-1 0,0 3 0,6 5 0,-10-15 0,11 19 0,-7-15 0,7 12 0,-3-3 0,0-2 0,3 2 0,-7-7 0,4 0 0,-1 7 0,1 1 0,1-6 0,2 10 0,-14-24 0,12 24 0,-8-14 0,11 13 0,-8-8 0,5 3 0,-9-5 0,11 9 0,-3-2 0,-3 1 0,1-2 0,-5-7 0,6 7 0,1 2 0,1 3 0,2 3 0,-2-2 0,2-5 0,-2 3 0,1-3 0,2 5 0,-3-1 0,6-3 0,-7 5 0,1-7 0,5 11 0,-1-5 0,8 6 0,13 8 0,3 6 0,12 12 0,-3-4 0,1 10 0,0-5 0,0 6 0,1-1 0,-2-4 0,-3 2 0,-4-8 0,1 3 0,-3-8 0,2 3 0,-4-7 0,0 2 0,0 1 0,-4-4 0,3 4 0,-3-5 0,0 1 0,-1-1 0,7 7 0,-8-5 0,7 5 0,-10-7 0,8 4 0,-6 1 0,5 0 0,-3 6 0,4 1 0,-2-2 0,4 8 0,-9-13 0,3 7 0,-7-8 0,3 4 0,-3-7 0,0 2 0,-1-3 0,1 14 0,0-7 0,1 8 0,1-4 0,-1-6 0,-1 3 0,3-4 0,-3 3 0,0-5 0,3 5 0,-3-3 0,3 0 0,0 0 0,-3 4 0,3-4 0,0 8 0,-2-7 0,5 2 0,-6 1 0,3 1 0,0 0 0,1 2 0,-4-10 0,3 3 0,-3 0 0,3 12 0,1-5 0,0 12 0,0-10 0,0 0 0,-1-1 0,1 4 0,4 2 0,1 16 0,3-2 0,-2 0 0,-2-6 0,0 1 0,-2 6 0,2-9 0,-3 6 0,-1-20 0,4 22 0,-7-18 0,6 17 0,-7-21 0,3 5 0,-2-5 0,1 5 0,-2-9 0,0 5 0,3-6 0,-3 6 0,0-5 0,0 1 0,-1-3 0,-2-3 0,6 3 0,-6-3 0,5 3 0,-5-3 0,6 3 0,-6-4 0,2 4 0,-3-3 0,3 3 0,-2-3 0,2 3 0,0-3 0,-2 3 0,2-4 0,-3 0 0,0 1 0,4-1 0,-4 0 0,4 0 0,-4 0 0,0 0 0,0 0 0,0 0 0,0 0 0,3-1 0,-3 1 0,6 0 0,-5 0 0,5 0 0,-5 0 0,5 0 0,-5 1 0,6-1 0,-3 0 0,3 0 0,-3 0 0,2 1 0,-2-1 0,4 4 0,-4-3 0,3 3 0,-3 0 0,3-3 0,1 3 0,-4-3 0,3 3 0,-3-3 0,3 3 0,-3-4 0,3 4 0,-3-3 0,4 4 0,-4-5 0,2 0 0,-2 0 0,0 0 0,2 1 0,-5-1 0,6 0 0,-7 0 0,7 0 0,-6 1 0,2-1 0,0-3 0,-2 2 0,2-2 0,0 0 0,-2 3 0,5-3 0,-5 3 0,2 0 0,1-3 0,-4 2 0,7-2 0,-7 3 0,3 0 0,1 0 0,-4 0 0,7 1 0,-3-1 0,3 0 0,-3 0 0,2 0 0,-1 5 0,2 0 0,1 0 0,0 3 0,0-3 0,-1 0 0,1-1 0,-4-4 0,3 4 0,-3-3 0,0 3 0,2-3 0,-2-1 0,3 0 0,-3 0 0,3-3 0,-7 2 0,7-2 0,-4 3 0,-6-23 0,1 6 0,-9-19 0,3 9 0,-1-2 0,1 0 0,-1-3 0,5 4 0,-9-11 0,11 5 0,-14-5 0,14 6 0,-14-1 0,10 1 0,-6 5 0,3-5 0,1 9 0,0-3 0,0 4 0,4 0 0,-3 4 0,3 1 0,-3 4 0,-1-8 0,1 6 0,3-5 0,-3 7 0,6 0 0,-5-1 0,2 1 0,0 0 0,-3-4 0,6 3 0,-5-3 0,1-1 0,-2 0 0,2-4 0,-2 0 0,3 1 0,-4-1 0,-1-5 0,1 4 0,3-4 0,-2 5 0,3 0 0,-4 1 0,4-1 0,-4 0 0,4 0 0,-4 4 0,0-3 0,1-5 0,-1 3 0,3-6 0,-2 7 0,3 0 0,-4 4 0,0-3 0,4 3 0,-3-4 0,3 0 0,-1 0 0,-2 0 0,6 0 0,-6 0 0,3 0 0,-1 0 0,-2 0 0,3 0 0,-4 0 0,0 0 0,0 0 0,0 0 0,0 0 0,0 0 0,0 0 0,4 0 0,-4-4 0,4 3 0,-5-4 0,1 5 0,4 0 0,-3 0 0,2 0 0,-3 1 0,0-1 0,0 0 0,4 0 0,-3 0 0,3 0 0,-1 4 0,-2-3 0,3 3 0,-1-4 0,-2 0 0,3 4 0,0-3 0,-3 3 0,3 0 0,-1-3 0,-1 3 0,2-1 0,-1-1 0,-1 1 0,1 1 0,-2-3 0,2 7 0,-2-7 0,6 7 0,-5-3 0,5 4 0,-5 0 0,5-1 0,-6 1 0,7 0 0,-7 0 0,6 0 0,-5-1 0,2 1 0,0 0 0,-2 0 0,5 0 0,-5 0 0,5 0 0,-6 0 0,3-1 0,0 1 0,-2 0 0,5 0 0,-2 0 0,0-1 0,2 1 0,-5 0 0,5 0 0,-2-4 0,-1 3 0,4-4 0,-7 1 0,6 3 0,-2-7 0,3 7 0,-4-3 0,3 0 0,-2 3 0,3-7 0,0 7 0,0-7 0,0 6 0,0-6 0,0 0 0,0 2 0,0-1 0,0 3 0,0 3 0,0-3 0,0 3 0,0 1 0,0 0 0,0-4 0,0 3 0,3-3 0,-2 3 0,2 1 0,1 0 0,-4 0 0,7 0 0,-6-4 0,2 2 0,0-2 0,-2 4 0,5 0 0,-5 0 0,2 0 0,1-1 0,-4 1 0,4 0 0,-1 0 0,-2 0 0,2-1 0,0 1 0,-2 0 0,5-4 0,-5 3 0,6-3 0,-6 3 0,5 1 0,-2 3 0,0 18 0,-1-7 0,-3 13 0,0-8 0,0-4 0,0 7 0,0-7 0,0 7 0,0-3 0,0 0 0,0 3 0,0-3 0,0 0 0,0 3 0,0-7 0,0 7 0,0-7 0,0 7 0,0-3 0,0 0 0,0 0 0,0-5 0,0 0 0,0 0 0,0 0 0,0 1 0,0-1 0,0 0 0,0 0 0,0 0 0,0 0 0,0 0 0,0 0 0,0 0 0,0 0 0,0-27 0,0 14 0,0-30 0,0 23 0,0-8 0,0 5 0,0-4 0,0 3 0,0-4 0,0 5 0,0-4 0,0 6 0,0-5 0,0 7 0,0 0 0,0 1 0,0 3 0,0 1 0,0 0 0,0 0 0,3 3 0,-2-2 0,5 2 0,-5-3 0,5 0 0,-2 0 0,-1 0 0,3 4 0,-5-3 0,2 2 0,-3-3 0,-12 13 0,2-7 0,-7 13 0,2-7 0,6-1 0,-6-1 0,3-3 0,-7 0 0,2 0 0,-2 0 0,3 0 0,0 0 0,0 0 0,4 0 0,-3 0 0,7 0 0,-7 0 0,7 0 0,-10 0 0,5 0 0,-2 0 0,0 0 0,7 0 0,-7 0 0,6 0 0,-6 0 0,3-3 0,0 2 0,-3-6 0,7 6 0,-7-6 0,7 6 0,-3-6 0,4 6 0,-4-5 0,3 5 0,-3-6 0,4 6 0,-1-2 0,1 3 0,3-3 0,-2 2 0,2-2 0,-3 3 0,0 0 0,0 0 0,3-3 0,-2 2 0,2-2 0</inkml:trace>
</inkml:ink>
</file>

<file path=ppt/ink/ink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2-09-27T01:59:06.093"/>
    </inkml:context>
    <inkml:brush xml:id="br0">
      <inkml:brushProperty name="width" value="0.2" units="cm"/>
      <inkml:brushProperty name="height" value="0.2" units="cm"/>
      <inkml:brushProperty name="color" value="#33CCFF"/>
    </inkml:brush>
  </inkml:definitions>
  <inkml:trace contextRef="#ctx0" brushRef="#br0">2238 1190 24575,'-4'-20'0,"0"2"0,-11-5 0,5 5 0,-9-5 0,-7-10 0,4 6 0,-9-5 0,17 15 0,-1 9 0,4-2 0,0-1 0,-3-1 0,3-1 0,0 5 0,0-3 0,1 1 0,2 5 0,-2-8 0,2 9 0,1-7 0,-3 1 0,-5-5 0,3 3 0,-1-1 0,2 6 0,-1-1 0,-2-2 0,-8-9 0,-6-5 0,0-3 0,1 6 0,11 7 0,-2-1 0,5 6 0,-9-13 0,1 5 0,-2-6 0,3 3 0,1 1 0,8 8 0,-7-4 0,5 3 0,-3 1 0,-2-4 0,-1-3 0,-2 4 0,0-7 0,9 16 0,-3-5 0,0 2 0,-1-3 0,-6-4 0,3 0 0,2 3 0,-8-2 0,15 5 0,-8-2 0,4 4 0,-2-4 0,-11 3 0,9-7 0,-8 6 0,9-3 0,-9 4 0,6 0 0,-8-4 0,-4-1 0,10 1 0,-15-3 0,16 7 0,0-3 0,-1 6 0,10-1 0,-4 1 0,-3-3 0,6 1 0,-8-1 0,8 4 0,-5-6 0,2 9 0,1-9 0,0 6 0,3 0 0,-6-3 0,6 3 0,-7 0 0,8 1 0,-8 0 0,7 2 0,-7-6 0,8 6 0,-11-6 0,9 7 0,-13-4 0,9 1 0,-2 2 0,0-3 0,2 4 0,-9 0 0,8-3 0,-1 2 0,-10-2 0,17 3 0,-17-4 0,17 3 0,-7-2 0,-1-1 0,0 3 0,1-2 0,0-1 0,-1 4 0,-3-7 0,3 6 0,4-6 0,-2 6 0,-5-5 0,5 5 0,-7-2 0,17 0 0,-10 2 0,9-2 0,-5 3 0,6 0 0,1 0 0,0 0 0,-3 0 0,2 0 0,-2 0 0,3 0 0,0 0 0,0 0 0,1 0 0,-1 0 0,0 0 0</inkml:trace>
</inkml:ink>
</file>

<file path=ppt/ink/ink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2-09-27T01:59:40.450"/>
    </inkml:context>
    <inkml:brush xml:id="br0">
      <inkml:brushProperty name="width" value="0.2" units="cm"/>
      <inkml:brushProperty name="height" value="0.2" units="cm"/>
      <inkml:brushProperty name="color" value="#33CCFF"/>
    </inkml:brush>
  </inkml:definitions>
  <inkml:trace contextRef="#ctx0" brushRef="#br0">1124 406 24575,'-19'0'0,"2"0"0,9 0 0,1 0 0,0 0 0,0 0 0,0 0 0,-1 0 0,1 0 0,-4 0 0,3 0 0,-3 0 0,0 0 0,3-3 0,-7 2 0,7-2 0,-4 3 0,5 0 0,-4-3 0,3 2 0,-3-3 0,4 4 0,-1 0 0,-3 0 0,3 0 0,-3-3 0,-3 2 0,5-2 0,-5 3 0,3 0 0,2 0 0,-6 0 0,7 0 0,-3 0 0,0 0 0,3 0 0,-3 0 0,4 0 0,-4 0 0,2 0 0,-2 0 0,0 0 0,3 0 0,-3 0 0,0 0 0,3 0 0,-3 0 0,-1 0 0,4 0 0,-3 0 0,4 0 0,-4 0 0,3 0 0,-3 0 0,4 0 0,0 0 0,-1 0 0,1 0 0,0 0 0,0 0 0,0 0 0,-1 0 0,1 0 0,0 0 0,0 0 0,0 0 0,-1 0 0,1 0 0,-4 0 0,3 0 0,-3 0 0,0 0 0,3 0 0,-7 0 0,6 0 0,-6 0 0,7 0 0,-7 0 0,7 0 0,-3 0 0,4 3 0,0-2 0,-1 2 0,1 0 0,0-2 0,0 6 0,-4-7 0,3 4 0,-4-1 0,5-2 0,0 5 0,-4-5 0,3 5 0,-3-5 0,3 2 0,1 0 0,0-2 0,0 2 0,0 1 0,0-4 0,0 4 0,-1-4 0,1 0 0,3 3 0,-2-2 0,2 2 0,-3 0 0,-1-2 0,1 2 0,0-3 0,0 0 0,0 3 0,0-2 0,0 2 0,0-3 0,0 0 0,23 0 0,-7 4 0,20-3 0,-13 2 0,4-3 0,-3 0 0,4 0 0,-1 0 0,-3 0 0,4 0 0,-5 0 0,0 0 0,0 0 0,0 0 0,0 0 0,0 0 0,-4 0 0,3 0 0,-3 0 0,4-3 0,0 2 0,0-6 0,0 6 0,-4-3 0,3 1 0,-3 2 0,0-3 0,-1 1 0,-4 2 0,0-2 0,0 3 0,1-3 0,-1 2 0,0-2 0,0 0 0,0 2 0,-3-5 0,2 5 0,-5-5 0,2 2 0,-3-3 0,0 0 0,0 0 0,0 0 0,0 0 0,0 0 0,0-1 0,0 1 0,0 0 0,0 0 0,0 0 0,0-1 0,0 1 0,0 0 0,0 0 0,0 0 0,0-1 0,0 1 0,0 0 0,0 0 0,0 0 0,3-1 0,-2 1 0,5 0 0,-5 0 0,6 0 0,-3 3 0,0-3 0,2 3 0,-5-3 0,5 3 0,-2-2 0,0 2 0,3-3 0,-7 0 0,7 0 0,-6 0 0,5 0 0,-5 0 0,2 0 0,0 0 0,-2 0 0,2 0 0,-3 0 0,3 0 0,-2 0 0,2 0 0,-3 0 0,0 0 0,0 0 0,0 0 0,0 0 0,0-1 0,0 1 0,0 0 0,0 0 0,0 0 0,0 0 0,0 0 0,0 0 0,0 23 0,3-8 0,1 17 0,1-10 0,1-7 0,-5 3 0,2-4 0,0 0 0,-2 1 0,2-1 0,0 0 0,-2 0 0,2 0 0,1-3 0,-4 2 0,7-5 0,-6 6 0,5-3 0,-2 3 0,3 0 0,0 0 0,0-1 0,0 2 0,-3-1 0,2-3 0,-2 2 0,3-2 0,1 0 0,-1 2 0,0-2 0,0 4 0,0-1 0,1 0 0,-1 0 0,0-3 0,0 3 0,0-3 0,-3 3 0,3 0 0,-3-3 0,0 3 0,2-7 0,-2 7 0,0-3 0,3 0 0,-4-1 0,1 0 0,3-2 0,-4 5 0,4-6 0,-3 6 0,2-5 0,-21-4 0,11 1 0,-15-7 0,11 8 0,1-2 0,0 3 0,0 0 0,0 0 0,-1 0 0,-3 0 0,3 0 0,-3 0 0,0 0 0,3 0 0,-3 0 0,0 0 0,2 0 0,-2 0 0,0 0 0,3 0 0,-3 0 0,4 0 0,0 0 0,-1 0 0,1 0 0,0 0 0,0 0 0,0 0 0,-1 0 0,1 0 0,0 0 0,0 0 0,0 0 0,0 0 0,0 0 0,0-4 0,-1 4 0,1-4 0,0 1 0,0 2 0,0-5 0,0 5 0,0-2 0,0 3 0,0 0 0,0 0 0,0 0 0,1 0 0,-1 0 0,0 0 0,0 0 0,1 0 0,-1 0 0,0 0 0,1 0 0,-1 0 0,0 0 0,0 0 0,0 0 0,0 0 0,0 0 0,0 3 0,0-2 0,0 5 0,0-5 0,0 2 0,0-3 0,-1 4 0,1-4 0,0 7 0,0-6 0,0 2 0,0 0 0,-1-2 0,2 2 0,2 0 0,-2-2 0,5 7 0,-2-3 0,3 4 0,0-2 0,0 0 0,0-1 0,-7-2 0,2 2 0,-6-2 0,0 4 0,2-1 0,-5 1 0,5-4 0,-6 3 0,7-3 0,-3 4 0,4-4 0,-4 2 0,3-5 0,-2 5 0,3-5 0,0 2 0,3 1 0,-3-4 0,3 4 0,-3-4 0,3 3 0,-2-2 0,2 2 0,0 0 0,-3-2 0,3 2 0,-3-3 0,4 3 0,-4-2 0,4 2 0,-4 0 0,0-2 0,0 2 0,3 0 0,-2-2 0,2 5 0,-3-5 0,3 5 0,-2-5 0,2 5 0,-3-5 0,3 5 0,-2-5 0,2 2 0,-3-3 0,3 3 0,-2-2 0,2 2 0,-3-3 0,1 0 0,-1 0 0,3-6 0,1 2 0,3-3 0,0 4 0</inkml:trace>
</inkml:ink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22EB4B-25EF-3744-8493-62DDE0E0A39F}" type="datetimeFigureOut">
              <a:rPr lang="en-US" smtClean="0"/>
              <a:t>1/24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6A41CE5-54C7-0243-8776-41785DD7F1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52016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3" Type="http://schemas.openxmlformats.org/officeDocument/2006/relationships/hyperlink" Target="https://anatomytool.org/content/surface-anatomy-thorax-and-abdomen" TargetMode="External"/><Relationship Id="rId7" Type="http://schemas.openxmlformats.org/officeDocument/2006/relationships/hyperlink" Target="https://creativecommons.org/licenses/by/4.0/" TargetMode="External"/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Relationship Id="rId6" Type="http://schemas.openxmlformats.org/officeDocument/2006/relationships/hyperlink" Target="https://blausen.com/" TargetMode="External"/><Relationship Id="rId5" Type="http://schemas.openxmlformats.org/officeDocument/2006/relationships/hyperlink" Target="https://anatomytool.org/content/blausen-0723-anatomy-pelvis-english-labels" TargetMode="External"/><Relationship Id="rId4" Type="http://schemas.openxmlformats.org/officeDocument/2006/relationships/hyperlink" Target="https://creativecommons.org/licenses/by-nc-sa/4.0/" TargetMode="External"/></Relationships>
</file>

<file path=ppt/notesSlides/_rels/notesSlide2.xml.rels><?xml version="1.0" encoding="UTF-8" standalone="yes"?>
<Relationships xmlns="http://schemas.openxmlformats.org/package/2006/relationships"><Relationship Id="rId3" Type="http://schemas.openxmlformats.org/officeDocument/2006/relationships/hyperlink" Target="https://anatomytool.org/content/saggital-section-male-pelvis-filled-bladder" TargetMode="External"/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Relationship Id="rId5" Type="http://schemas.openxmlformats.org/officeDocument/2006/relationships/hyperlink" Target="https://creativecommons.org/licenses/by-nc-sa/4.0/" TargetMode="External"/><Relationship Id="rId4" Type="http://schemas.openxmlformats.org/officeDocument/2006/relationships/hyperlink" Target="https://nl.linkedin.com/in/ron-slagter-2905a95" TargetMode="External"/></Relationships>
</file>

<file path=ppt/notesSlides/_rels/notesSlide3.xml.rels><?xml version="1.0" encoding="UTF-8" standalone="yes"?>
<Relationships xmlns="http://schemas.openxmlformats.org/package/2006/relationships"><Relationship Id="rId3" Type="http://schemas.openxmlformats.org/officeDocument/2006/relationships/hyperlink" Target="https://anatomytool.org/content/leiden-drawing-sagittal-section-female-pelvis-peritoneum" TargetMode="External"/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Relationship Id="rId5" Type="http://schemas.openxmlformats.org/officeDocument/2006/relationships/hyperlink" Target="https://creativecommons.org/licenses/by-nc-sa/4.0/" TargetMode="External"/><Relationship Id="rId4" Type="http://schemas.openxmlformats.org/officeDocument/2006/relationships/hyperlink" Target="https://nl.linkedin.com/in/ron-slagter-2905a95" TargetMode="External"/></Relationships>
</file>

<file path=ppt/notesSlides/_rels/notesSlide4.xml.rels><?xml version="1.0" encoding="UTF-8" standalone="yes"?>
<Relationships xmlns="http://schemas.openxmlformats.org/package/2006/relationships"><Relationship Id="rId3" Type="http://schemas.openxmlformats.org/officeDocument/2006/relationships/hyperlink" Target="https://anatomytool.org/content/saggital-section-male-pelvis-filled-bladder" TargetMode="External"/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Relationship Id="rId6" Type="http://schemas.openxmlformats.org/officeDocument/2006/relationships/hyperlink" Target="https://anatomytool.org/content/leiden-drawing-sagittal-section-female-pelvis-peritoneum" TargetMode="External"/><Relationship Id="rId5" Type="http://schemas.openxmlformats.org/officeDocument/2006/relationships/hyperlink" Target="https://creativecommons.org/licenses/by-nc-sa/4.0/" TargetMode="External"/><Relationship Id="rId4" Type="http://schemas.openxmlformats.org/officeDocument/2006/relationships/hyperlink" Target="https://nl.linkedin.com/in/ron-slagter-2905a95" TargetMode="Externa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0" i="0" dirty="0">
                <a:solidFill>
                  <a:srgbClr val="333333"/>
                </a:solidFill>
                <a:effectLst/>
                <a:latin typeface="proxima"/>
              </a:rPr>
              <a:t>Image by Ron </a:t>
            </a:r>
            <a:r>
              <a:rPr lang="en-US" b="0" i="0" dirty="0" err="1">
                <a:solidFill>
                  <a:srgbClr val="333333"/>
                </a:solidFill>
                <a:effectLst/>
                <a:latin typeface="proxima"/>
              </a:rPr>
              <a:t>Slagter</a:t>
            </a:r>
            <a:r>
              <a:rPr lang="en-US" b="0" i="0" dirty="0">
                <a:solidFill>
                  <a:srgbClr val="333333"/>
                </a:solidFill>
                <a:effectLst/>
                <a:latin typeface="proxima"/>
              </a:rPr>
              <a:t>, retrieved from: https://anatomytool.org/content/slagter-drawing-visible-and-palpable-surface-anatomy-thorax-and-abdomen-no-labels on 09/27/2022. Creative Commons License associated: https://creativecommons.org/licenses/by-nc-sa/4.0/.</a:t>
            </a:r>
            <a:endParaRPr lang="en-US" b="0" i="0" u="none" strike="noStrike" dirty="0">
              <a:solidFill>
                <a:srgbClr val="0275D8"/>
              </a:solidFill>
              <a:effectLst/>
              <a:latin typeface="Times New Roman" panose="02020603050405020304" pitchFamily="18" charset="0"/>
              <a:hlinkClick r:id="rId3"/>
            </a:endParaRPr>
          </a:p>
          <a:p>
            <a:pPr marL="171450" marR="0" lvl="0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lang="en-US" b="0" i="0" u="none" strike="noStrike" dirty="0">
                <a:solidFill>
                  <a:srgbClr val="0275D8"/>
                </a:solidFill>
                <a:effectLst/>
                <a:latin typeface="Times New Roman" panose="02020603050405020304" pitchFamily="18" charset="0"/>
                <a:hlinkClick r:id="rId3"/>
              </a:rPr>
              <a:t>"Surface anatomy thorax and abdomen"</a:t>
            </a:r>
            <a:r>
              <a:rPr lang="en-US" b="0" i="0" dirty="0">
                <a:solidFill>
                  <a:srgbClr val="666666"/>
                </a:solidFill>
                <a:effectLst/>
                <a:latin typeface="Times New Roman" panose="02020603050405020304" pitchFamily="18" charset="0"/>
              </a:rPr>
              <a:t> by Ron </a:t>
            </a:r>
            <a:r>
              <a:rPr lang="en-US" b="0" i="0" dirty="0" err="1">
                <a:solidFill>
                  <a:srgbClr val="666666"/>
                </a:solidFill>
                <a:effectLst/>
                <a:latin typeface="Times New Roman" panose="02020603050405020304" pitchFamily="18" charset="0"/>
              </a:rPr>
              <a:t>Slagter</a:t>
            </a:r>
            <a:r>
              <a:rPr lang="en-US" b="0" i="0" dirty="0">
                <a:solidFill>
                  <a:srgbClr val="666666"/>
                </a:solidFill>
                <a:effectLst/>
                <a:latin typeface="Times New Roman" panose="02020603050405020304" pitchFamily="18" charset="0"/>
              </a:rPr>
              <a:t>, license: </a:t>
            </a:r>
            <a:r>
              <a:rPr lang="en-US" b="0" i="0" u="none" strike="noStrike" dirty="0">
                <a:solidFill>
                  <a:srgbClr val="0275D8"/>
                </a:solidFill>
                <a:effectLst/>
                <a:latin typeface="Times New Roman" panose="02020603050405020304" pitchFamily="18" charset="0"/>
                <a:hlinkClick r:id="rId4"/>
              </a:rPr>
              <a:t>CC BY-NC-SA</a:t>
            </a:r>
            <a:endParaRPr lang="en-US" b="0" i="0" u="none" strike="noStrike" dirty="0">
              <a:solidFill>
                <a:srgbClr val="0275D8"/>
              </a:solidFill>
              <a:effectLst/>
              <a:latin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="0" i="0" u="none" strike="noStrike" dirty="0">
              <a:solidFill>
                <a:srgbClr val="0275D8"/>
              </a:solidFill>
              <a:effectLst/>
              <a:latin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0" i="0" dirty="0">
                <a:solidFill>
                  <a:srgbClr val="333333"/>
                </a:solidFill>
                <a:effectLst/>
                <a:latin typeface="proxima"/>
              </a:rPr>
              <a:t>Image by </a:t>
            </a:r>
            <a:r>
              <a:rPr lang="en-US" dirty="0"/>
              <a:t>Blausen.com staff (2014), </a:t>
            </a:r>
            <a:r>
              <a:rPr lang="en-US" b="0" i="0" dirty="0">
                <a:solidFill>
                  <a:srgbClr val="333333"/>
                </a:solidFill>
                <a:effectLst/>
                <a:latin typeface="proxima"/>
              </a:rPr>
              <a:t>retrieved from: https://anatomytool.org/content/blausen-0723-anatomy-pelvis-english-labels on 09/27/2022. Creative Commons License associated: https://creativecommons.org/licenses/by/4.0/.</a:t>
            </a:r>
            <a:endParaRPr lang="en-US" b="0" i="0" u="none" strike="noStrike" dirty="0">
              <a:solidFill>
                <a:srgbClr val="0275D8"/>
              </a:solidFill>
              <a:effectLst/>
              <a:latin typeface="Times New Roman" panose="02020603050405020304" pitchFamily="18" charset="0"/>
            </a:endParaRPr>
          </a:p>
          <a:p>
            <a:pPr marL="171450" marR="0" lvl="0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lang="en-US" b="0" i="0" u="none" strike="noStrike" dirty="0">
                <a:solidFill>
                  <a:srgbClr val="0275D8"/>
                </a:solidFill>
                <a:effectLst/>
                <a:latin typeface="Times New Roman" panose="02020603050405020304" pitchFamily="18" charset="0"/>
                <a:hlinkClick r:id="rId5"/>
              </a:rPr>
              <a:t>"Blausen 0723 - Anatomy of the pelvis - English labels "</a:t>
            </a:r>
            <a:r>
              <a:rPr lang="en-US" b="0" i="0" dirty="0">
                <a:solidFill>
                  <a:srgbClr val="666666"/>
                </a:solidFill>
                <a:effectLst/>
                <a:latin typeface="Times New Roman" panose="02020603050405020304" pitchFamily="18" charset="0"/>
              </a:rPr>
              <a:t> by </a:t>
            </a:r>
            <a:r>
              <a:rPr lang="en-US" b="0" i="0" u="none" strike="noStrike" dirty="0">
                <a:solidFill>
                  <a:srgbClr val="0275D8"/>
                </a:solidFill>
                <a:effectLst/>
                <a:latin typeface="Times New Roman" panose="02020603050405020304" pitchFamily="18" charset="0"/>
                <a:hlinkClick r:id="rId6"/>
              </a:rPr>
              <a:t>Blausen.com staff (2014)</a:t>
            </a:r>
            <a:r>
              <a:rPr lang="en-US" b="0" i="0" dirty="0">
                <a:solidFill>
                  <a:srgbClr val="666666"/>
                </a:solidFill>
                <a:effectLst/>
                <a:latin typeface="Times New Roman" panose="02020603050405020304" pitchFamily="18" charset="0"/>
              </a:rPr>
              <a:t>, license: </a:t>
            </a:r>
            <a:r>
              <a:rPr lang="en-US" b="0" i="0" u="none" strike="noStrike" dirty="0">
                <a:solidFill>
                  <a:srgbClr val="0275D8"/>
                </a:solidFill>
                <a:effectLst/>
                <a:latin typeface="Times New Roman" panose="02020603050405020304" pitchFamily="18" charset="0"/>
                <a:hlinkClick r:id="rId7"/>
              </a:rPr>
              <a:t>CC BY</a:t>
            </a:r>
            <a:r>
              <a:rPr lang="en-US" b="0" i="0" dirty="0">
                <a:solidFill>
                  <a:srgbClr val="666666"/>
                </a:solidFill>
                <a:effectLst/>
                <a:latin typeface="Times New Roman" panose="02020603050405020304" pitchFamily="18" charset="0"/>
              </a:rPr>
              <a:t>. Source: "Medical gallery of </a:t>
            </a:r>
            <a:r>
              <a:rPr lang="en-US" b="0" i="0" dirty="0" err="1">
                <a:solidFill>
                  <a:srgbClr val="666666"/>
                </a:solidFill>
                <a:effectLst/>
                <a:latin typeface="Times New Roman" panose="02020603050405020304" pitchFamily="18" charset="0"/>
              </a:rPr>
              <a:t>Blausen</a:t>
            </a:r>
            <a:r>
              <a:rPr lang="en-US" b="0" i="0" dirty="0">
                <a:solidFill>
                  <a:srgbClr val="666666"/>
                </a:solidFill>
                <a:effectLst/>
                <a:latin typeface="Times New Roman" panose="02020603050405020304" pitchFamily="18" charset="0"/>
              </a:rPr>
              <a:t> Medical 2014“ https://en.wikiversity.org/wiki/WikiJournal_of_Medicine/Medical_gallery_of_Blausen_Medical_2014</a:t>
            </a:r>
            <a:endParaRPr lang="en-US" b="0" i="0" u="none" strike="noStrike" dirty="0">
              <a:solidFill>
                <a:srgbClr val="0275D8"/>
              </a:solidFill>
              <a:effectLst/>
              <a:latin typeface="Times New Roman" panose="02020603050405020304" pitchFamily="18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6A41CE5-54C7-0243-8776-41785DD7F13A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16254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0" i="0" dirty="0">
                <a:solidFill>
                  <a:srgbClr val="333333"/>
                </a:solidFill>
                <a:effectLst/>
                <a:latin typeface="proxima"/>
              </a:rPr>
              <a:t>Image by Ron </a:t>
            </a:r>
            <a:r>
              <a:rPr lang="en-US" b="0" i="0" dirty="0" err="1">
                <a:solidFill>
                  <a:srgbClr val="333333"/>
                </a:solidFill>
                <a:effectLst/>
                <a:latin typeface="proxima"/>
              </a:rPr>
              <a:t>Slagter</a:t>
            </a:r>
            <a:r>
              <a:rPr lang="en-US" b="0" i="0" dirty="0">
                <a:solidFill>
                  <a:srgbClr val="333333"/>
                </a:solidFill>
                <a:effectLst/>
                <a:latin typeface="proxima"/>
              </a:rPr>
              <a:t>, retrieved from: https://anatomytool.org/content/saggital-section-male-pelvis-filled-bladder on 09/27/2022. Creative Commons License associated: https://creativecommons.org/licenses/by-nc-sa/4.0/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b="0" i="0" u="none" strike="noStrike" dirty="0">
                <a:solidFill>
                  <a:srgbClr val="0275D8"/>
                </a:solidFill>
                <a:effectLst/>
                <a:latin typeface="Times New Roman" panose="02020603050405020304" pitchFamily="18" charset="0"/>
                <a:hlinkClick r:id="rId3"/>
              </a:rPr>
              <a:t>"Saggital section male pelvis with filled bladder"</a:t>
            </a:r>
            <a:r>
              <a:rPr lang="en-US" b="0" i="0" dirty="0">
                <a:solidFill>
                  <a:srgbClr val="666666"/>
                </a:solidFill>
                <a:effectLst/>
                <a:latin typeface="Times New Roman" panose="02020603050405020304" pitchFamily="18" charset="0"/>
              </a:rPr>
              <a:t> by </a:t>
            </a:r>
            <a:r>
              <a:rPr lang="en-US" b="0" i="0" u="none" strike="noStrike" dirty="0">
                <a:solidFill>
                  <a:srgbClr val="0275D8"/>
                </a:solidFill>
                <a:effectLst/>
                <a:latin typeface="Times New Roman" panose="02020603050405020304" pitchFamily="18" charset="0"/>
                <a:hlinkClick r:id="rId4"/>
              </a:rPr>
              <a:t>Ron Slagter</a:t>
            </a:r>
            <a:r>
              <a:rPr lang="en-US" b="0" i="0" dirty="0">
                <a:solidFill>
                  <a:srgbClr val="666666"/>
                </a:solidFill>
                <a:effectLst/>
                <a:latin typeface="Times New Roman" panose="02020603050405020304" pitchFamily="18" charset="0"/>
              </a:rPr>
              <a:t>, license: </a:t>
            </a:r>
            <a:r>
              <a:rPr lang="en-US" b="0" i="0" u="none" strike="noStrike" dirty="0">
                <a:solidFill>
                  <a:srgbClr val="0275D8"/>
                </a:solidFill>
                <a:effectLst/>
                <a:latin typeface="Times New Roman" panose="02020603050405020304" pitchFamily="18" charset="0"/>
                <a:hlinkClick r:id="rId5"/>
              </a:rPr>
              <a:t>CC BY-NC-SA</a:t>
            </a:r>
            <a:endParaRPr lang="en-US" b="0" i="0" u="none" strike="noStrike" dirty="0">
              <a:solidFill>
                <a:srgbClr val="0275D8"/>
              </a:solidFill>
              <a:effectLst/>
              <a:latin typeface="Times New Roman" panose="02020603050405020304" pitchFamily="18" charset="0"/>
            </a:endParaRPr>
          </a:p>
          <a:p>
            <a:endParaRPr lang="en-US" b="0" i="0" u="none" strike="noStrike" dirty="0">
              <a:solidFill>
                <a:srgbClr val="0275D8"/>
              </a:solidFill>
              <a:effectLst/>
              <a:latin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Pelvic Ultrasound Image: Author Owned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6A41CE5-54C7-0243-8776-41785DD7F13A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760448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0" i="0" dirty="0">
                <a:solidFill>
                  <a:srgbClr val="333333"/>
                </a:solidFill>
                <a:effectLst/>
                <a:latin typeface="proxima"/>
              </a:rPr>
              <a:t>Image by Ron </a:t>
            </a:r>
            <a:r>
              <a:rPr lang="en-US" b="0" i="0" dirty="0" err="1">
                <a:solidFill>
                  <a:srgbClr val="333333"/>
                </a:solidFill>
                <a:effectLst/>
                <a:latin typeface="proxima"/>
              </a:rPr>
              <a:t>Slagter</a:t>
            </a:r>
            <a:r>
              <a:rPr lang="en-US" b="0" i="0" dirty="0">
                <a:solidFill>
                  <a:srgbClr val="333333"/>
                </a:solidFill>
                <a:effectLst/>
                <a:latin typeface="proxima"/>
              </a:rPr>
              <a:t>, retrieved from: https://anatomytool.org/content/leiden-drawing-sagittal-section-female-pelvis-peritoneum on 09/27/2022. Creative Commons License associated: https://creativecommons.org/licenses/by-nc-sa/4.0/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b="0" i="0" u="none" strike="noStrike" dirty="0">
                <a:solidFill>
                  <a:srgbClr val="0275D8"/>
                </a:solidFill>
                <a:effectLst/>
                <a:latin typeface="Times New Roman" panose="02020603050405020304" pitchFamily="18" charset="0"/>
                <a:hlinkClick r:id="rId3"/>
              </a:rPr>
              <a:t>"Leiden - Drawing Sagittal section female pelvis with peritoneum"</a:t>
            </a:r>
            <a:r>
              <a:rPr lang="en-US" b="0" i="0" dirty="0">
                <a:solidFill>
                  <a:srgbClr val="666666"/>
                </a:solidFill>
                <a:effectLst/>
                <a:latin typeface="Times New Roman" panose="02020603050405020304" pitchFamily="18" charset="0"/>
              </a:rPr>
              <a:t> by </a:t>
            </a:r>
            <a:r>
              <a:rPr lang="en-US" b="0" i="0" u="none" strike="noStrike" dirty="0">
                <a:solidFill>
                  <a:srgbClr val="0275D8"/>
                </a:solidFill>
                <a:effectLst/>
                <a:latin typeface="Times New Roman" panose="02020603050405020304" pitchFamily="18" charset="0"/>
                <a:hlinkClick r:id="rId4"/>
              </a:rPr>
              <a:t>Ron </a:t>
            </a:r>
            <a:r>
              <a:rPr lang="en-US" b="0" i="0" u="none" strike="noStrike" dirty="0" err="1">
                <a:solidFill>
                  <a:srgbClr val="0275D8"/>
                </a:solidFill>
                <a:effectLst/>
                <a:latin typeface="Times New Roman" panose="02020603050405020304" pitchFamily="18" charset="0"/>
                <a:hlinkClick r:id="rId4"/>
              </a:rPr>
              <a:t>Slagter</a:t>
            </a:r>
            <a:r>
              <a:rPr lang="en-US" b="0" i="0" dirty="0">
                <a:solidFill>
                  <a:srgbClr val="666666"/>
                </a:solidFill>
                <a:effectLst/>
                <a:latin typeface="Times New Roman" panose="02020603050405020304" pitchFamily="18" charset="0"/>
              </a:rPr>
              <a:t>, license: </a:t>
            </a:r>
            <a:r>
              <a:rPr lang="en-US" b="0" i="0" u="none" strike="noStrike" dirty="0">
                <a:solidFill>
                  <a:srgbClr val="0275D8"/>
                </a:solidFill>
                <a:effectLst/>
                <a:latin typeface="Times New Roman" panose="02020603050405020304" pitchFamily="18" charset="0"/>
                <a:hlinkClick r:id="rId5"/>
              </a:rPr>
              <a:t>CC BY-NC-SA</a:t>
            </a:r>
            <a:endParaRPr lang="en-US" dirty="0"/>
          </a:p>
          <a:p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Pelvic Ultrasound Image: Author Owned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6A41CE5-54C7-0243-8776-41785DD7F13A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997800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0" i="0" dirty="0">
                <a:solidFill>
                  <a:srgbClr val="333333"/>
                </a:solidFill>
                <a:effectLst/>
                <a:latin typeface="proxima"/>
              </a:rPr>
              <a:t>Image by Ron </a:t>
            </a:r>
            <a:r>
              <a:rPr lang="en-US" b="0" i="0" dirty="0" err="1">
                <a:solidFill>
                  <a:srgbClr val="333333"/>
                </a:solidFill>
                <a:effectLst/>
                <a:latin typeface="proxima"/>
              </a:rPr>
              <a:t>Slagter</a:t>
            </a:r>
            <a:r>
              <a:rPr lang="en-US" b="0" i="0" dirty="0">
                <a:solidFill>
                  <a:srgbClr val="333333"/>
                </a:solidFill>
                <a:effectLst/>
                <a:latin typeface="proxima"/>
              </a:rPr>
              <a:t>, retrieved from: https://anatomytool.org/content/saggital-section-male-pelvis-filled-bladder on 09/27/2022. Creative Commons License associated: https://creativecommons.org/licenses/by-nc-sa/4.0/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b="0" i="0" u="none" strike="noStrike" dirty="0">
                <a:solidFill>
                  <a:srgbClr val="0275D8"/>
                </a:solidFill>
                <a:effectLst/>
                <a:latin typeface="Times New Roman" panose="02020603050405020304" pitchFamily="18" charset="0"/>
                <a:hlinkClick r:id="rId3"/>
              </a:rPr>
              <a:t>"</a:t>
            </a:r>
            <a:r>
              <a:rPr lang="en-US" b="0" i="0" u="none" strike="noStrike" dirty="0" err="1">
                <a:solidFill>
                  <a:srgbClr val="0275D8"/>
                </a:solidFill>
                <a:effectLst/>
                <a:latin typeface="Times New Roman" panose="02020603050405020304" pitchFamily="18" charset="0"/>
                <a:hlinkClick r:id="rId3"/>
              </a:rPr>
              <a:t>Saggital</a:t>
            </a:r>
            <a:r>
              <a:rPr lang="en-US" b="0" i="0" u="none" strike="noStrike" dirty="0">
                <a:solidFill>
                  <a:srgbClr val="0275D8"/>
                </a:solidFill>
                <a:effectLst/>
                <a:latin typeface="Times New Roman" panose="02020603050405020304" pitchFamily="18" charset="0"/>
                <a:hlinkClick r:id="rId3"/>
              </a:rPr>
              <a:t> section male pelvis with filled bladder"</a:t>
            </a:r>
            <a:r>
              <a:rPr lang="en-US" b="0" i="0" dirty="0">
                <a:solidFill>
                  <a:srgbClr val="666666"/>
                </a:solidFill>
                <a:effectLst/>
                <a:latin typeface="Times New Roman" panose="02020603050405020304" pitchFamily="18" charset="0"/>
              </a:rPr>
              <a:t> by </a:t>
            </a:r>
            <a:r>
              <a:rPr lang="en-US" b="0" i="0" u="none" strike="noStrike" dirty="0">
                <a:solidFill>
                  <a:srgbClr val="0275D8"/>
                </a:solidFill>
                <a:effectLst/>
                <a:latin typeface="Times New Roman" panose="02020603050405020304" pitchFamily="18" charset="0"/>
                <a:hlinkClick r:id="rId4"/>
              </a:rPr>
              <a:t>Ron </a:t>
            </a:r>
            <a:r>
              <a:rPr lang="en-US" b="0" i="0" u="none" strike="noStrike" dirty="0" err="1">
                <a:solidFill>
                  <a:srgbClr val="0275D8"/>
                </a:solidFill>
                <a:effectLst/>
                <a:latin typeface="Times New Roman" panose="02020603050405020304" pitchFamily="18" charset="0"/>
                <a:hlinkClick r:id="rId4"/>
              </a:rPr>
              <a:t>Slagter</a:t>
            </a:r>
            <a:r>
              <a:rPr lang="en-US" b="0" i="0" dirty="0">
                <a:solidFill>
                  <a:srgbClr val="666666"/>
                </a:solidFill>
                <a:effectLst/>
                <a:latin typeface="Times New Roman" panose="02020603050405020304" pitchFamily="18" charset="0"/>
              </a:rPr>
              <a:t>, license: </a:t>
            </a:r>
            <a:r>
              <a:rPr lang="en-US" b="0" i="0" u="none" strike="noStrike" dirty="0">
                <a:solidFill>
                  <a:srgbClr val="0275D8"/>
                </a:solidFill>
                <a:effectLst/>
                <a:latin typeface="Times New Roman" panose="02020603050405020304" pitchFamily="18" charset="0"/>
                <a:hlinkClick r:id="rId5"/>
              </a:rPr>
              <a:t>CC BY-NC-SA</a:t>
            </a:r>
            <a:endParaRPr lang="en-US" b="0" i="0" u="none" strike="noStrike" dirty="0">
              <a:solidFill>
                <a:srgbClr val="0275D8"/>
              </a:solidFill>
              <a:effectLst/>
              <a:latin typeface="Times New Roman" panose="02020603050405020304" pitchFamily="18" charset="0"/>
            </a:endParaRPr>
          </a:p>
          <a:p>
            <a:endParaRPr lang="en-US" b="0" i="0" u="none" strike="noStrike" dirty="0">
              <a:solidFill>
                <a:srgbClr val="0275D8"/>
              </a:solidFill>
              <a:effectLst/>
              <a:latin typeface="Times New Roman" panose="02020603050405020304" pitchFamily="18" charset="0"/>
              <a:hlinkClick r:id="rId6"/>
            </a:endParaRPr>
          </a:p>
          <a:p>
            <a:r>
              <a:rPr lang="en-US" b="0" i="0" dirty="0">
                <a:solidFill>
                  <a:srgbClr val="333333"/>
                </a:solidFill>
                <a:effectLst/>
                <a:latin typeface="proxima"/>
              </a:rPr>
              <a:t>Image by Ron </a:t>
            </a:r>
            <a:r>
              <a:rPr lang="en-US" b="0" i="0" dirty="0" err="1">
                <a:solidFill>
                  <a:srgbClr val="333333"/>
                </a:solidFill>
                <a:effectLst/>
                <a:latin typeface="proxima"/>
              </a:rPr>
              <a:t>Slagter</a:t>
            </a:r>
            <a:r>
              <a:rPr lang="en-US" b="0" i="0" dirty="0">
                <a:solidFill>
                  <a:srgbClr val="333333"/>
                </a:solidFill>
                <a:effectLst/>
                <a:latin typeface="proxima"/>
              </a:rPr>
              <a:t>, retrieved from: https://anatomytool.org/content/leiden-drawing-sagittal-section-female-pelvis-peritoneum on 09/27/2022. Creative Commons License associated: https://creativecommons.org/licenses/by-nc-sa/4.0/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b="0" i="0" u="none" strike="noStrike" dirty="0">
                <a:solidFill>
                  <a:srgbClr val="0275D8"/>
                </a:solidFill>
                <a:effectLst/>
                <a:latin typeface="Times New Roman" panose="02020603050405020304" pitchFamily="18" charset="0"/>
                <a:hlinkClick r:id="rId6"/>
              </a:rPr>
              <a:t>"Leiden - Drawing Sagittal section female pelvis with peritoneum"</a:t>
            </a:r>
            <a:r>
              <a:rPr lang="en-US" b="0" i="0" dirty="0">
                <a:solidFill>
                  <a:srgbClr val="666666"/>
                </a:solidFill>
                <a:effectLst/>
                <a:latin typeface="Times New Roman" panose="02020603050405020304" pitchFamily="18" charset="0"/>
              </a:rPr>
              <a:t> by </a:t>
            </a:r>
            <a:r>
              <a:rPr lang="en-US" b="0" i="0" u="none" strike="noStrike" dirty="0">
                <a:solidFill>
                  <a:srgbClr val="0275D8"/>
                </a:solidFill>
                <a:effectLst/>
                <a:latin typeface="Times New Roman" panose="02020603050405020304" pitchFamily="18" charset="0"/>
                <a:hlinkClick r:id="rId4"/>
              </a:rPr>
              <a:t>Ron Slagter</a:t>
            </a:r>
            <a:r>
              <a:rPr lang="en-US" b="0" i="0" dirty="0">
                <a:solidFill>
                  <a:srgbClr val="666666"/>
                </a:solidFill>
                <a:effectLst/>
                <a:latin typeface="Times New Roman" panose="02020603050405020304" pitchFamily="18" charset="0"/>
              </a:rPr>
              <a:t>, license: </a:t>
            </a:r>
            <a:r>
              <a:rPr lang="en-US" b="0" i="0" u="none" strike="noStrike" dirty="0">
                <a:solidFill>
                  <a:srgbClr val="0275D8"/>
                </a:solidFill>
                <a:effectLst/>
                <a:latin typeface="Times New Roman" panose="02020603050405020304" pitchFamily="18" charset="0"/>
                <a:hlinkClick r:id="rId5"/>
              </a:rPr>
              <a:t>CC BY-NC-SA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6A41CE5-54C7-0243-8776-41785DD7F13A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974452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Pathologic Pelvic Ultrasound Image: Author Owned</a:t>
            </a:r>
          </a:p>
          <a:p>
            <a:endParaRPr lang="en-US" dirty="0"/>
          </a:p>
          <a:p>
            <a:r>
              <a:rPr lang="en-US" dirty="0"/>
              <a:t>Is this the rectum or uterus?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6A41CE5-54C7-0243-8776-41785DD7F13A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2645893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In this video, we will be covering the Left upper quadrant, or </a:t>
            </a:r>
            <a:r>
              <a:rPr lang="en-US" dirty="0" err="1"/>
              <a:t>perisplenic</a:t>
            </a:r>
            <a:r>
              <a:rPr lang="en-US" dirty="0"/>
              <a:t>, view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6A41CE5-54C7-0243-8776-41785DD7F13A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42642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5A5C87FB-6C7F-6341-B3AC-7A03AC6D386F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14" y="0"/>
            <a:ext cx="12181172" cy="6858000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9E4E5EF8-3F55-CC40-8877-5D48D7C0631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1570961"/>
          </a:xfrm>
          <a:prstGeom prst="rect">
            <a:avLst/>
          </a:prstGeom>
        </p:spPr>
        <p:txBody>
          <a:bodyPr anchor="b">
            <a:normAutofit/>
          </a:bodyPr>
          <a:lstStyle>
            <a:lvl1pPr algn="l">
              <a:defRPr sz="4400">
                <a:solidFill>
                  <a:schemeClr val="bg1"/>
                </a:solidFill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FD648D3-80FB-6246-9942-F676252E6F9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2693324"/>
            <a:ext cx="9144000" cy="648392"/>
          </a:xfrm>
        </p:spPr>
        <p:txBody>
          <a:bodyPr/>
          <a:lstStyle>
            <a:lvl1pPr marL="0" indent="0" algn="l">
              <a:buNone/>
              <a:defRPr sz="2400">
                <a:solidFill>
                  <a:schemeClr val="bg1"/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BD09F92B-E9CD-1043-ADF5-647DA2A9ECBB}"/>
              </a:ext>
            </a:extLst>
          </p:cNvPr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3158" y="3851391"/>
            <a:ext cx="2596403" cy="12001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577885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 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0580087E-EAD0-9943-8A61-EC0B6D11A0DC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8740"/>
          <a:stretch/>
        </p:blipFill>
        <p:spPr>
          <a:xfrm>
            <a:off x="5414" y="6085754"/>
            <a:ext cx="12181172" cy="772245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B0115303-0D88-FC4F-A64A-0DABCD2F0B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886159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5C8021D-5040-E443-B438-B5DF5DB17BB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251285"/>
            <a:ext cx="10515600" cy="479263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466905F6-993F-D349-A0EA-9D639A51B81E}"/>
              </a:ext>
            </a:extLst>
          </p:cNvPr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2050" y="6064834"/>
            <a:ext cx="1761191" cy="8140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633949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icture Placeholder 8">
            <a:extLst>
              <a:ext uri="{FF2B5EF4-FFF2-40B4-BE49-F238E27FC236}">
                <a16:creationId xmlns:a16="http://schemas.microsoft.com/office/drawing/2014/main" id="{66C763D1-54E7-1F4C-9A40-8033FD87C96D}"/>
              </a:ext>
            </a:extLst>
          </p:cNvPr>
          <p:cNvSpPr>
            <a:spLocks noGrp="1"/>
          </p:cNvSpPr>
          <p:nvPr>
            <p:ph type="pic" sz="quarter" idx="10"/>
          </p:nvPr>
        </p:nvSpPr>
        <p:spPr>
          <a:xfrm>
            <a:off x="6049963" y="1250950"/>
            <a:ext cx="5303837" cy="4819111"/>
          </a:xfrm>
        </p:spPr>
        <p:txBody>
          <a:bodyPr/>
          <a:lstStyle/>
          <a:p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B0115303-0D88-FC4F-A64A-0DABCD2F0B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886159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5C8021D-5040-E443-B438-B5DF5DB17BB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250951"/>
            <a:ext cx="5085945" cy="481911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FBD3E57B-7AA0-CB4E-84C8-14051157E7C1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8740"/>
          <a:stretch/>
        </p:blipFill>
        <p:spPr>
          <a:xfrm>
            <a:off x="5414" y="6085754"/>
            <a:ext cx="12181172" cy="772245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C92E3011-1B8B-5640-AE26-C7ED9C07F799}"/>
              </a:ext>
            </a:extLst>
          </p:cNvPr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2050" y="6064834"/>
            <a:ext cx="1761191" cy="8140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789695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bg>
      <p:bgPr>
        <a:solidFill>
          <a:srgbClr val="001E44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8F5CCD73-4F4C-6E40-91EC-E9DA02F326CB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2440"/>
          <a:stretch/>
        </p:blipFill>
        <p:spPr>
          <a:xfrm>
            <a:off x="5414" y="0"/>
            <a:ext cx="12181172" cy="3261674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DFF89896-24B9-D543-BC49-89300DAB77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527048" y="1124712"/>
            <a:ext cx="7928237" cy="1442997"/>
          </a:xfrm>
          <a:prstGeom prst="rect">
            <a:avLst/>
          </a:prstGeom>
        </p:spPr>
        <p:txBody>
          <a:bodyPr anchor="b">
            <a:normAutofit/>
          </a:bodyPr>
          <a:lstStyle>
            <a:lvl1pPr>
              <a:defRPr sz="3600">
                <a:solidFill>
                  <a:schemeClr val="bg1"/>
                </a:solidFill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9384264-DB8D-274D-83EB-C183729E59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527048" y="2495399"/>
            <a:ext cx="7928237" cy="766273"/>
          </a:xfrm>
        </p:spPr>
        <p:txBody>
          <a:bodyPr/>
          <a:lstStyle>
            <a:lvl1pPr marL="0" indent="0">
              <a:buNone/>
              <a:defRPr sz="2400">
                <a:solidFill>
                  <a:schemeClr val="accent1">
                    <a:lumMod val="20000"/>
                    <a:lumOff val="80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6C403D84-AA45-1D40-9400-B1135229D764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0019" b="25694"/>
          <a:stretch/>
        </p:blipFill>
        <p:spPr>
          <a:xfrm>
            <a:off x="0" y="3261673"/>
            <a:ext cx="12186586" cy="35963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173734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Header 2">
    <p:bg>
      <p:bgPr>
        <a:solidFill>
          <a:srgbClr val="001E44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8F5CCD73-4F4C-6E40-91EC-E9DA02F326CB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2440"/>
          <a:stretch/>
        </p:blipFill>
        <p:spPr>
          <a:xfrm>
            <a:off x="5414" y="0"/>
            <a:ext cx="12181172" cy="3261674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DFF89896-24B9-D543-BC49-89300DAB77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527048" y="1124712"/>
            <a:ext cx="7928237" cy="1442997"/>
          </a:xfrm>
          <a:prstGeom prst="rect">
            <a:avLst/>
          </a:prstGeom>
        </p:spPr>
        <p:txBody>
          <a:bodyPr anchor="b">
            <a:normAutofit/>
          </a:bodyPr>
          <a:lstStyle>
            <a:lvl1pPr>
              <a:defRPr sz="3600">
                <a:solidFill>
                  <a:schemeClr val="bg1"/>
                </a:solidFill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9384264-DB8D-274D-83EB-C183729E59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527048" y="2495400"/>
            <a:ext cx="7928237" cy="672674"/>
          </a:xfrm>
        </p:spPr>
        <p:txBody>
          <a:bodyPr/>
          <a:lstStyle>
            <a:lvl1pPr marL="0" indent="0">
              <a:buNone/>
              <a:defRPr sz="2400">
                <a:solidFill>
                  <a:schemeClr val="accent1">
                    <a:lumMod val="20000"/>
                    <a:lumOff val="80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8" name="Picture Placeholder 7">
            <a:extLst>
              <a:ext uri="{FF2B5EF4-FFF2-40B4-BE49-F238E27FC236}">
                <a16:creationId xmlns:a16="http://schemas.microsoft.com/office/drawing/2014/main" id="{EF58B01F-C66D-C041-B01B-9D8150197C3E}"/>
              </a:ext>
            </a:extLst>
          </p:cNvPr>
          <p:cNvSpPr>
            <a:spLocks noGrp="1"/>
          </p:cNvSpPr>
          <p:nvPr>
            <p:ph type="pic" sz="quarter" idx="10"/>
          </p:nvPr>
        </p:nvSpPr>
        <p:spPr>
          <a:xfrm>
            <a:off x="0" y="3262313"/>
            <a:ext cx="12192000" cy="3595687"/>
          </a:xfrm>
        </p:spPr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29362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losing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4851C92B-9FEA-5643-8E61-4A0757AD8E3A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14" y="0"/>
            <a:ext cx="12181172" cy="68580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7D03306-2E4A-D447-A57E-3DFA585649E0}"/>
              </a:ext>
            </a:extLst>
          </p:cNvPr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3158" y="5077568"/>
            <a:ext cx="2596403" cy="1200150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9E4E5EF8-3F55-CC40-8877-5D48D7C0631B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1524000" y="1122363"/>
            <a:ext cx="9144000" cy="1570961"/>
          </a:xfrm>
          <a:prstGeom prst="rect">
            <a:avLst/>
          </a:prstGeom>
        </p:spPr>
        <p:txBody>
          <a:bodyPr anchor="b">
            <a:normAutofit/>
          </a:bodyPr>
          <a:lstStyle>
            <a:lvl1pPr algn="l">
              <a:defRPr sz="4400">
                <a:solidFill>
                  <a:schemeClr val="bg1"/>
                </a:solidFill>
              </a:defRPr>
            </a:lvl1pPr>
          </a:lstStyle>
          <a:p>
            <a:r>
              <a:rPr lang="en-US"/>
              <a:t>Thank you.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FD648D3-80FB-6246-9942-F676252E6F93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1524000" y="3797665"/>
            <a:ext cx="5139447" cy="1279903"/>
          </a:xfrm>
        </p:spPr>
        <p:txBody>
          <a:bodyPr/>
          <a:lstStyle>
            <a:lvl1pPr marL="0" indent="0" algn="l">
              <a:buNone/>
              <a:defRPr sz="2400">
                <a:solidFill>
                  <a:schemeClr val="bg1"/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ontact information</a:t>
            </a:r>
          </a:p>
        </p:txBody>
      </p:sp>
    </p:spTree>
    <p:extLst>
      <p:ext uri="{BB962C8B-B14F-4D97-AF65-F5344CB8AC3E}">
        <p14:creationId xmlns:p14="http://schemas.microsoft.com/office/powerpoint/2010/main" val="38706628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Title and Content 3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10D1FE8A-B770-A54B-BB1F-BB647AC8A8FD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80445" y="3993267"/>
            <a:ext cx="2411555" cy="2864733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B0115303-0D88-FC4F-A64A-0DABCD2F0B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886159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5C8021D-5040-E443-B438-B5DF5DB17BB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250951"/>
            <a:ext cx="10515600" cy="428408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88728744-A790-8648-9D59-4DCBBF5298FE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3"/>
          <a:srcRect l="5272" t="13428" r="5705" b="18819"/>
          <a:stretch/>
        </p:blipFill>
        <p:spPr>
          <a:xfrm>
            <a:off x="8032866" y="6148022"/>
            <a:ext cx="1784465" cy="621545"/>
          </a:xfrm>
          <a:prstGeom prst="rect">
            <a:avLst/>
          </a:prstGeom>
        </p:spPr>
      </p:pic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6062243-C1CF-714B-A683-D890075FBD68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838200" y="5592763"/>
            <a:ext cx="6516688" cy="836612"/>
          </a:xfrm>
        </p:spPr>
        <p:txBody>
          <a:bodyPr/>
          <a:lstStyle>
            <a:lvl1pPr>
              <a:defRPr sz="2000"/>
            </a:lvl1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1779427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AF0656E-DA2F-C14C-BF10-2FC3587B40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251284"/>
            <a:ext cx="10515600" cy="49256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5C3011-D639-B54B-9228-EB3085D04C0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EC4368-C769-8143-B102-F97927FA2E0C}" type="datetimeFigureOut">
              <a:rPr lang="en-US" smtClean="0"/>
              <a:t>1/24/24</a:t>
            </a:fld>
            <a:endParaRPr lang="en-US"/>
          </a:p>
        </p:txBody>
      </p:sp>
      <p:sp>
        <p:nvSpPr>
          <p:cNvPr id="7" name="Title Placeholder 6">
            <a:extLst>
              <a:ext uri="{FF2B5EF4-FFF2-40B4-BE49-F238E27FC236}">
                <a16:creationId xmlns:a16="http://schemas.microsoft.com/office/drawing/2014/main" id="{A5E7B941-CE32-1D43-B287-BCB25BBF8F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0" cy="75381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33394305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60" r:id="rId3"/>
    <p:sldLayoutId id="2147483651" r:id="rId4"/>
    <p:sldLayoutId id="2147483663" r:id="rId5"/>
    <p:sldLayoutId id="2147483662" r:id="rId6"/>
    <p:sldLayoutId id="2147483664" r:id="rId7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3800" kern="1200" baseline="0">
          <a:solidFill>
            <a:schemeClr val="accent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6.xml"/><Relationship Id="rId2" Type="http://schemas.openxmlformats.org/officeDocument/2006/relationships/audio" Target="../media/media1.m4a"/><Relationship Id="rId1" Type="http://schemas.microsoft.com/office/2007/relationships/media" Target="../media/media1.m4a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6.xml"/><Relationship Id="rId2" Type="http://schemas.openxmlformats.org/officeDocument/2006/relationships/audio" Target="../media/media2.m4a"/><Relationship Id="rId1" Type="http://schemas.microsoft.com/office/2007/relationships/media" Target="../media/media2.m4a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0.png"/><Relationship Id="rId3" Type="http://schemas.openxmlformats.org/officeDocument/2006/relationships/slideLayout" Target="../slideLayouts/slideLayout2.xml"/><Relationship Id="rId7" Type="http://schemas.openxmlformats.org/officeDocument/2006/relationships/customXml" Target="../ink/ink1.xml"/><Relationship Id="rId2" Type="http://schemas.openxmlformats.org/officeDocument/2006/relationships/audio" Target="../media/media3.m4a"/><Relationship Id="rId1" Type="http://schemas.microsoft.com/office/2007/relationships/media" Target="../media/media3.m4a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10" Type="http://schemas.openxmlformats.org/officeDocument/2006/relationships/image" Target="../media/image10.png"/><Relationship Id="rId4" Type="http://schemas.openxmlformats.org/officeDocument/2006/relationships/notesSlide" Target="../notesSlides/notesSlide1.xml"/><Relationship Id="rId9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0.png"/><Relationship Id="rId13" Type="http://schemas.openxmlformats.org/officeDocument/2006/relationships/customXml" Target="../ink/ink5.xml"/><Relationship Id="rId18" Type="http://schemas.openxmlformats.org/officeDocument/2006/relationships/image" Target="../media/image10.png"/><Relationship Id="rId3" Type="http://schemas.openxmlformats.org/officeDocument/2006/relationships/slideLayout" Target="../slideLayouts/slideLayout2.xml"/><Relationship Id="rId7" Type="http://schemas.openxmlformats.org/officeDocument/2006/relationships/customXml" Target="../ink/ink2.xml"/><Relationship Id="rId12" Type="http://schemas.openxmlformats.org/officeDocument/2006/relationships/image" Target="../media/image13.png"/><Relationship Id="rId17" Type="http://schemas.openxmlformats.org/officeDocument/2006/relationships/image" Target="../media/image6.png"/><Relationship Id="rId2" Type="http://schemas.openxmlformats.org/officeDocument/2006/relationships/audio" Target="../media/media4.m4a"/><Relationship Id="rId16" Type="http://schemas.openxmlformats.org/officeDocument/2006/relationships/image" Target="../media/image15.png"/><Relationship Id="rId1" Type="http://schemas.microsoft.com/office/2007/relationships/media" Target="../media/media4.m4a"/><Relationship Id="rId6" Type="http://schemas.openxmlformats.org/officeDocument/2006/relationships/image" Target="../media/image12.png"/><Relationship Id="rId11" Type="http://schemas.openxmlformats.org/officeDocument/2006/relationships/customXml" Target="../ink/ink4.xml"/><Relationship Id="rId5" Type="http://schemas.openxmlformats.org/officeDocument/2006/relationships/image" Target="../media/image11.jpeg"/><Relationship Id="rId15" Type="http://schemas.openxmlformats.org/officeDocument/2006/relationships/customXml" Target="../ink/ink6.xml"/><Relationship Id="rId10" Type="http://schemas.openxmlformats.org/officeDocument/2006/relationships/image" Target="../media/image120.png"/><Relationship Id="rId4" Type="http://schemas.openxmlformats.org/officeDocument/2006/relationships/notesSlide" Target="../notesSlides/notesSlide2.xml"/><Relationship Id="rId9" Type="http://schemas.openxmlformats.org/officeDocument/2006/relationships/customXml" Target="../ink/ink3.xml"/><Relationship Id="rId14" Type="http://schemas.openxmlformats.org/officeDocument/2006/relationships/image" Target="../media/image1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7" Type="http://schemas.openxmlformats.org/officeDocument/2006/relationships/image" Target="../media/image6.png"/><Relationship Id="rId2" Type="http://schemas.openxmlformats.org/officeDocument/2006/relationships/audio" Target="../media/media5.m4a"/><Relationship Id="rId1" Type="http://schemas.microsoft.com/office/2007/relationships/media" Target="../media/media5.m4a"/><Relationship Id="rId6" Type="http://schemas.openxmlformats.org/officeDocument/2006/relationships/image" Target="../media/image12.png"/><Relationship Id="rId5" Type="http://schemas.openxmlformats.org/officeDocument/2006/relationships/image" Target="../media/image13.jpeg"/><Relationship Id="rId4" Type="http://schemas.openxmlformats.org/officeDocument/2006/relationships/notesSlide" Target="../notesSlides/notesSlide3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13" Type="http://schemas.openxmlformats.org/officeDocument/2006/relationships/customXml" Target="../ink/ink10.xml"/><Relationship Id="rId18" Type="http://schemas.openxmlformats.org/officeDocument/2006/relationships/image" Target="../media/image10.png"/><Relationship Id="rId3" Type="http://schemas.openxmlformats.org/officeDocument/2006/relationships/slideLayout" Target="../slideLayouts/slideLayout2.xml"/><Relationship Id="rId7" Type="http://schemas.openxmlformats.org/officeDocument/2006/relationships/customXml" Target="../ink/ink7.xml"/><Relationship Id="rId12" Type="http://schemas.openxmlformats.org/officeDocument/2006/relationships/image" Target="../media/image19.png"/><Relationship Id="rId17" Type="http://schemas.openxmlformats.org/officeDocument/2006/relationships/image" Target="../media/image6.png"/><Relationship Id="rId2" Type="http://schemas.openxmlformats.org/officeDocument/2006/relationships/audio" Target="../media/media6.m4a"/><Relationship Id="rId16" Type="http://schemas.openxmlformats.org/officeDocument/2006/relationships/image" Target="../media/image21.png"/><Relationship Id="rId1" Type="http://schemas.microsoft.com/office/2007/relationships/media" Target="../media/media6.m4a"/><Relationship Id="rId6" Type="http://schemas.openxmlformats.org/officeDocument/2006/relationships/image" Target="../media/image11.jpeg"/><Relationship Id="rId11" Type="http://schemas.openxmlformats.org/officeDocument/2006/relationships/customXml" Target="../ink/ink9.xml"/><Relationship Id="rId5" Type="http://schemas.openxmlformats.org/officeDocument/2006/relationships/image" Target="../media/image13.jpeg"/><Relationship Id="rId15" Type="http://schemas.openxmlformats.org/officeDocument/2006/relationships/customXml" Target="../ink/ink11.xml"/><Relationship Id="rId10" Type="http://schemas.openxmlformats.org/officeDocument/2006/relationships/image" Target="../media/image18.png"/><Relationship Id="rId4" Type="http://schemas.openxmlformats.org/officeDocument/2006/relationships/notesSlide" Target="../notesSlides/notesSlide4.xml"/><Relationship Id="rId9" Type="http://schemas.openxmlformats.org/officeDocument/2006/relationships/customXml" Target="../ink/ink8.xml"/><Relationship Id="rId14" Type="http://schemas.openxmlformats.org/officeDocument/2006/relationships/image" Target="../media/image20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audio" Target="../media/media7.m4a"/><Relationship Id="rId1" Type="http://schemas.microsoft.com/office/2007/relationships/media" Target="../media/media7.m4a"/><Relationship Id="rId6" Type="http://schemas.openxmlformats.org/officeDocument/2006/relationships/image" Target="../media/image6.png"/><Relationship Id="rId5" Type="http://schemas.openxmlformats.org/officeDocument/2006/relationships/image" Target="../media/image16.png"/><Relationship Id="rId4" Type="http://schemas.openxmlformats.org/officeDocument/2006/relationships/notesSlide" Target="../notesSlides/notesSlide5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6.xml"/><Relationship Id="rId2" Type="http://schemas.openxmlformats.org/officeDocument/2006/relationships/audio" Target="../media/media8.m4a"/><Relationship Id="rId1" Type="http://schemas.microsoft.com/office/2007/relationships/media" Target="../media/media8.m4a"/><Relationship Id="rId5" Type="http://schemas.openxmlformats.org/officeDocument/2006/relationships/image" Target="../media/image6.png"/><Relationship Id="rId4" Type="http://schemas.openxmlformats.org/officeDocument/2006/relationships/notesSlide" Target="../notesSlides/notesSlide6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audio" Target="../media/media9.m4a"/><Relationship Id="rId1" Type="http://schemas.microsoft.com/office/2007/relationships/media" Target="../media/media9.m4a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Subtitle 2">
            <a:extLst>
              <a:ext uri="{FF2B5EF4-FFF2-40B4-BE49-F238E27FC236}">
                <a16:creationId xmlns:a16="http://schemas.microsoft.com/office/drawing/2014/main" id="{2F18CB67-A57B-4FD6-B3AD-D457A1407C8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119386"/>
            <a:ext cx="9144000" cy="900660"/>
          </a:xfr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en-US" i="1" dirty="0"/>
              <a:t>PennState Hershey Medical Center</a:t>
            </a:r>
          </a:p>
          <a:p>
            <a:r>
              <a:rPr lang="en-US" i="1" dirty="0"/>
              <a:t>C. Nguyen, K. Hartmann, C. Goodmurphy, A. Flamm</a:t>
            </a:r>
            <a:endParaRPr lang="en-US" dirty="0"/>
          </a:p>
          <a:p>
            <a:endParaRPr lang="en-US" dirty="0"/>
          </a:p>
        </p:txBody>
      </p:sp>
      <p:sp>
        <p:nvSpPr>
          <p:cNvPr id="4" name="Title 1">
            <a:extLst>
              <a:ext uri="{FF2B5EF4-FFF2-40B4-BE49-F238E27FC236}">
                <a16:creationId xmlns:a16="http://schemas.microsoft.com/office/drawing/2014/main" id="{6BC46404-153F-844C-97C7-1591E71011B0}"/>
              </a:ext>
            </a:extLst>
          </p:cNvPr>
          <p:cNvSpPr txBox="1">
            <a:spLocks/>
          </p:cNvSpPr>
          <p:nvPr/>
        </p:nvSpPr>
        <p:spPr>
          <a:xfrm>
            <a:off x="1524000" y="1122363"/>
            <a:ext cx="9144000" cy="1570961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 baseline="0">
                <a:solidFill>
                  <a:schemeClr val="bg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b="1" dirty="0"/>
              <a:t>PreHospital Provider Ultrasound Suprapubic View</a:t>
            </a:r>
            <a:endParaRPr lang="en-US" dirty="0"/>
          </a:p>
        </p:txBody>
      </p:sp>
      <p:pic>
        <p:nvPicPr>
          <p:cNvPr id="3" name="Audio Recording Sep 27, 2022 at 8:11:16 PM" descr="Audio Recording Sep 27, 2022 at 8:11:16 PM">
            <a:hlinkClick r:id="" action="ppaction://media"/>
            <a:extLst>
              <a:ext uri="{FF2B5EF4-FFF2-40B4-BE49-F238E27FC236}">
                <a16:creationId xmlns:a16="http://schemas.microsoft.com/office/drawing/2014/main" id="{54761227-A9B0-5EBA-BB3F-0710174B53FC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0668000" y="5601677"/>
            <a:ext cx="812800" cy="812800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88167BF1-38CE-D771-120C-A9181ADA0F0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668000" y="90248"/>
            <a:ext cx="1422400" cy="482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2505505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9088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3"/>
                </p:tgtEl>
              </p:cMediaNode>
            </p:audio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62C33B-CFA6-0239-4799-6A1FBFB3028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86753" y="950258"/>
            <a:ext cx="9144000" cy="753035"/>
          </a:xfrm>
        </p:spPr>
        <p:txBody>
          <a:bodyPr>
            <a:normAutofit/>
          </a:bodyPr>
          <a:lstStyle/>
          <a:p>
            <a:r>
              <a:rPr lang="en-US" u="sng" dirty="0"/>
              <a:t>EFAST Exam Components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FAC2473-7008-2500-F21B-391A8B2B175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461247" y="2013688"/>
            <a:ext cx="9511553" cy="3616147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3200" b="1" dirty="0"/>
              <a:t>Pericardial View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3200" dirty="0"/>
              <a:t>Anterior Thoracic (Lung) View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3200" dirty="0"/>
              <a:t>View of the Right Upper Quadrant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3200" dirty="0"/>
              <a:t>View of the Left Upper Quadrant View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4400" dirty="0"/>
              <a:t>Suprapubic View</a:t>
            </a:r>
          </a:p>
        </p:txBody>
      </p:sp>
      <p:pic>
        <p:nvPicPr>
          <p:cNvPr id="4" name="Audio Recording Sep 27, 2022 at 8:12:57 PM" descr="Audio Recording Sep 27, 2022 at 8:12:57 PM">
            <a:hlinkClick r:id="" action="ppaction://media"/>
            <a:extLst>
              <a:ext uri="{FF2B5EF4-FFF2-40B4-BE49-F238E27FC236}">
                <a16:creationId xmlns:a16="http://schemas.microsoft.com/office/drawing/2014/main" id="{B77266F7-EB01-D986-997F-799481C90684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0730753" y="5629835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6408430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8576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audio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A77FBC8-3CF1-1ED6-5B57-2F061F46984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endParaRPr lang="en-US" sz="900" dirty="0">
              <a:solidFill>
                <a:srgbClr val="000000"/>
              </a:solidFill>
              <a:latin typeface="Verdana" panose="020B0604030504040204" pitchFamily="34" charset="0"/>
            </a:endParaRPr>
          </a:p>
          <a:p>
            <a:endParaRPr lang="en-US" sz="900" dirty="0">
              <a:solidFill>
                <a:srgbClr val="000000"/>
              </a:solidFill>
              <a:latin typeface="Verdana" panose="020B0604030504040204" pitchFamily="34" charset="0"/>
            </a:endParaRPr>
          </a:p>
          <a:p>
            <a:pPr algn="l"/>
            <a:endParaRPr lang="en-US" sz="900" b="0" i="0" dirty="0">
              <a:solidFill>
                <a:srgbClr val="000000"/>
              </a:solidFill>
              <a:effectLst/>
              <a:latin typeface="Verdana" panose="020B0604030504040204" pitchFamily="34" charset="0"/>
            </a:endParaRPr>
          </a:p>
          <a:p>
            <a:pPr algn="l"/>
            <a:endParaRPr lang="en-US" sz="900" b="0" i="0" dirty="0">
              <a:solidFill>
                <a:srgbClr val="000000"/>
              </a:solidFill>
              <a:effectLst/>
              <a:latin typeface="Verdana" panose="020B0604030504040204" pitchFamily="34" charset="0"/>
            </a:endParaRPr>
          </a:p>
          <a:p>
            <a:endParaRPr lang="en-US" sz="1100" dirty="0"/>
          </a:p>
        </p:txBody>
      </p:sp>
      <p:pic>
        <p:nvPicPr>
          <p:cNvPr id="3076" name="Picture 4">
            <a:extLst>
              <a:ext uri="{FF2B5EF4-FFF2-40B4-BE49-F238E27FC236}">
                <a16:creationId xmlns:a16="http://schemas.microsoft.com/office/drawing/2014/main" id="{9428BA5F-67F5-2CA1-0F21-E3B6F23AE16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83" t="9084" r="76534" b="68537"/>
          <a:stretch/>
        </p:blipFill>
        <p:spPr bwMode="auto">
          <a:xfrm>
            <a:off x="6096000" y="-186928"/>
            <a:ext cx="5257800" cy="623084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C7B3CBF3-44D3-9DEF-514C-609F0F585213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27299" r="3291" b="7553"/>
          <a:stretch/>
        </p:blipFill>
        <p:spPr>
          <a:xfrm>
            <a:off x="-11464" y="-221308"/>
            <a:ext cx="6771813" cy="6230843"/>
          </a:xfrm>
          <a:prstGeom prst="rect">
            <a:avLst/>
          </a:prstGeom>
        </p:spPr>
      </p:pic>
      <mc:AlternateContent xmlns:mc="http://schemas.openxmlformats.org/markup-compatibility/2006" xmlns:p14="http://schemas.microsoft.com/office/powerpoint/2010/main">
        <mc:Choice Requires="p14">
          <p:contentPart p14:bwMode="auto" r:id="rId7">
            <p14:nvContentPartPr>
              <p14:cNvPr id="5" name="Ink 4">
                <a:extLst>
                  <a:ext uri="{FF2B5EF4-FFF2-40B4-BE49-F238E27FC236}">
                    <a16:creationId xmlns:a16="http://schemas.microsoft.com/office/drawing/2014/main" id="{23F5F94C-4BC4-7083-87B2-BCE8CD0D8183}"/>
                  </a:ext>
                </a:extLst>
              </p14:cNvPr>
              <p14:cNvContentPartPr/>
              <p14:nvPr/>
            </p14:nvContentPartPr>
            <p14:xfrm>
              <a:off x="8543449" y="4925239"/>
              <a:ext cx="542520" cy="148680"/>
            </p14:xfrm>
          </p:contentPart>
        </mc:Choice>
        <mc:Fallback xmlns="">
          <p:pic>
            <p:nvPicPr>
              <p:cNvPr id="5" name="Ink 4">
                <a:extLst>
                  <a:ext uri="{FF2B5EF4-FFF2-40B4-BE49-F238E27FC236}">
                    <a16:creationId xmlns:a16="http://schemas.microsoft.com/office/drawing/2014/main" id="{23F5F94C-4BC4-7083-87B2-BCE8CD0D8183}"/>
                  </a:ext>
                </a:extLst>
              </p:cNvPr>
              <p:cNvPicPr/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8480449" y="4862239"/>
                <a:ext cx="668160" cy="274320"/>
              </a:xfrm>
              <a:prstGeom prst="rect">
                <a:avLst/>
              </a:prstGeom>
            </p:spPr>
          </p:pic>
        </mc:Fallback>
      </mc:AlternateContent>
      <p:grpSp>
        <p:nvGrpSpPr>
          <p:cNvPr id="7" name="Group 6">
            <a:extLst>
              <a:ext uri="{FF2B5EF4-FFF2-40B4-BE49-F238E27FC236}">
                <a16:creationId xmlns:a16="http://schemas.microsoft.com/office/drawing/2014/main" id="{F554474B-4FE0-D8CF-A1FA-23A435786915}"/>
              </a:ext>
            </a:extLst>
          </p:cNvPr>
          <p:cNvGrpSpPr/>
          <p:nvPr/>
        </p:nvGrpSpPr>
        <p:grpSpPr>
          <a:xfrm rot="4509984">
            <a:off x="3147254" y="5419146"/>
            <a:ext cx="843265" cy="385095"/>
            <a:chOff x="5052989" y="3277750"/>
            <a:chExt cx="843265" cy="385095"/>
          </a:xfrm>
        </p:grpSpPr>
        <p:sp>
          <p:nvSpPr>
            <p:cNvPr id="8" name="Rectangle: Top Corners Snipped 4">
              <a:extLst>
                <a:ext uri="{FF2B5EF4-FFF2-40B4-BE49-F238E27FC236}">
                  <a16:creationId xmlns:a16="http://schemas.microsoft.com/office/drawing/2014/main" id="{84E9396F-74CC-57FE-E402-11F6688F69B6}"/>
                </a:ext>
              </a:extLst>
            </p:cNvPr>
            <p:cNvSpPr/>
            <p:nvPr/>
          </p:nvSpPr>
          <p:spPr>
            <a:xfrm rot="17074548">
              <a:off x="5282074" y="3048665"/>
              <a:ext cx="385095" cy="843265"/>
            </a:xfrm>
            <a:prstGeom prst="snip2SameRect">
              <a:avLst/>
            </a:prstGeom>
            <a:solidFill>
              <a:schemeClr val="tx1">
                <a:lumMod val="65000"/>
                <a:lumOff val="35000"/>
              </a:schemeClr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Oval 9">
              <a:extLst>
                <a:ext uri="{FF2B5EF4-FFF2-40B4-BE49-F238E27FC236}">
                  <a16:creationId xmlns:a16="http://schemas.microsoft.com/office/drawing/2014/main" id="{1D71CC50-1ACD-53A2-7E93-BCFE46DEA7BD}"/>
                </a:ext>
              </a:extLst>
            </p:cNvPr>
            <p:cNvSpPr/>
            <p:nvPr/>
          </p:nvSpPr>
          <p:spPr>
            <a:xfrm flipV="1">
              <a:off x="5147830" y="3456012"/>
              <a:ext cx="45719" cy="58281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pic>
        <p:nvPicPr>
          <p:cNvPr id="2" name="Audio Recording Sep 27, 2022 at 8:22:10 PM" descr="Audio Recording Sep 27, 2022 at 8:22:10 PM">
            <a:hlinkClick r:id="" action="ppaction://media"/>
            <a:extLst>
              <a:ext uri="{FF2B5EF4-FFF2-40B4-BE49-F238E27FC236}">
                <a16:creationId xmlns:a16="http://schemas.microsoft.com/office/drawing/2014/main" id="{35605C3A-E222-D9CB-F825-A689C53D5D8D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9"/>
          <a:stretch>
            <a:fillRect/>
          </a:stretch>
        </p:blipFill>
        <p:spPr>
          <a:xfrm>
            <a:off x="10831480" y="5200315"/>
            <a:ext cx="812800" cy="812800"/>
          </a:xfrm>
          <a:prstGeom prst="rect">
            <a:avLst/>
          </a:prstGeom>
        </p:spPr>
      </p:pic>
      <p:grpSp>
        <p:nvGrpSpPr>
          <p:cNvPr id="4" name="Group 3">
            <a:extLst>
              <a:ext uri="{FF2B5EF4-FFF2-40B4-BE49-F238E27FC236}">
                <a16:creationId xmlns:a16="http://schemas.microsoft.com/office/drawing/2014/main" id="{512FFF24-9676-C780-8BF9-A614D572ECDB}"/>
              </a:ext>
            </a:extLst>
          </p:cNvPr>
          <p:cNvGrpSpPr/>
          <p:nvPr/>
        </p:nvGrpSpPr>
        <p:grpSpPr>
          <a:xfrm rot="4509984">
            <a:off x="8377298" y="5384765"/>
            <a:ext cx="843265" cy="385095"/>
            <a:chOff x="5052989" y="3277750"/>
            <a:chExt cx="843265" cy="385095"/>
          </a:xfrm>
        </p:grpSpPr>
        <p:sp>
          <p:nvSpPr>
            <p:cNvPr id="9" name="Rectangle: Top Corners Snipped 4">
              <a:extLst>
                <a:ext uri="{FF2B5EF4-FFF2-40B4-BE49-F238E27FC236}">
                  <a16:creationId xmlns:a16="http://schemas.microsoft.com/office/drawing/2014/main" id="{4B1CACA8-BFE1-FDD0-9E78-D380F471F71C}"/>
                </a:ext>
              </a:extLst>
            </p:cNvPr>
            <p:cNvSpPr/>
            <p:nvPr/>
          </p:nvSpPr>
          <p:spPr>
            <a:xfrm rot="17074548">
              <a:off x="5282074" y="3048665"/>
              <a:ext cx="385095" cy="843265"/>
            </a:xfrm>
            <a:prstGeom prst="snip2SameRect">
              <a:avLst/>
            </a:prstGeom>
            <a:solidFill>
              <a:schemeClr val="tx1">
                <a:lumMod val="65000"/>
                <a:lumOff val="35000"/>
              </a:schemeClr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Oval 13">
              <a:extLst>
                <a:ext uri="{FF2B5EF4-FFF2-40B4-BE49-F238E27FC236}">
                  <a16:creationId xmlns:a16="http://schemas.microsoft.com/office/drawing/2014/main" id="{6826994E-E904-22C1-8929-D15AF1F57436}"/>
                </a:ext>
              </a:extLst>
            </p:cNvPr>
            <p:cNvSpPr/>
            <p:nvPr/>
          </p:nvSpPr>
          <p:spPr>
            <a:xfrm flipV="1">
              <a:off x="5147830" y="3456012"/>
              <a:ext cx="45719" cy="58281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pic>
        <p:nvPicPr>
          <p:cNvPr id="11" name="Picture 2">
            <a:extLst>
              <a:ext uri="{FF2B5EF4-FFF2-40B4-BE49-F238E27FC236}">
                <a16:creationId xmlns:a16="http://schemas.microsoft.com/office/drawing/2014/main" id="{CB658A4D-96D8-045E-814C-652102AAE52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65985" y="5766372"/>
            <a:ext cx="563680" cy="1972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2">
            <a:extLst>
              <a:ext uri="{FF2B5EF4-FFF2-40B4-BE49-F238E27FC236}">
                <a16:creationId xmlns:a16="http://schemas.microsoft.com/office/drawing/2014/main" id="{8EC9C457-517E-034B-7BF6-18EC8ED9CBE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124808" y="5846627"/>
            <a:ext cx="563680" cy="1972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73031737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14944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13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A77FBC8-3CF1-1ED6-5B57-2F061F46984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endParaRPr lang="en-US" sz="900" dirty="0">
              <a:solidFill>
                <a:srgbClr val="000000"/>
              </a:solidFill>
              <a:latin typeface="Verdana" panose="020B0604030504040204" pitchFamily="34" charset="0"/>
            </a:endParaRPr>
          </a:p>
          <a:p>
            <a:endParaRPr lang="en-US" sz="900" dirty="0">
              <a:solidFill>
                <a:srgbClr val="000000"/>
              </a:solidFill>
              <a:latin typeface="Verdana" panose="020B0604030504040204" pitchFamily="34" charset="0"/>
            </a:endParaRPr>
          </a:p>
          <a:p>
            <a:pPr algn="l"/>
            <a:endParaRPr lang="en-US" sz="900" b="0" i="0" dirty="0">
              <a:solidFill>
                <a:srgbClr val="000000"/>
              </a:solidFill>
              <a:effectLst/>
              <a:latin typeface="Verdana" panose="020B0604030504040204" pitchFamily="34" charset="0"/>
            </a:endParaRPr>
          </a:p>
          <a:p>
            <a:pPr algn="l"/>
            <a:endParaRPr lang="en-US" sz="900" b="0" i="0" dirty="0">
              <a:solidFill>
                <a:srgbClr val="000000"/>
              </a:solidFill>
              <a:effectLst/>
              <a:latin typeface="Verdana" panose="020B0604030504040204" pitchFamily="34" charset="0"/>
            </a:endParaRPr>
          </a:p>
          <a:p>
            <a:endParaRPr lang="en-US" sz="1100" dirty="0"/>
          </a:p>
        </p:txBody>
      </p:sp>
      <p:pic>
        <p:nvPicPr>
          <p:cNvPr id="1032" name="Picture 8" descr="A filled bladder displaces the peritoneum upwards and brings the bladder preperitoneal">
            <a:extLst>
              <a:ext uri="{FF2B5EF4-FFF2-40B4-BE49-F238E27FC236}">
                <a16:creationId xmlns:a16="http://schemas.microsoft.com/office/drawing/2014/main" id="{B0B8F284-3567-3F3E-81A3-20C8FCA066D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43299" y="326836"/>
            <a:ext cx="4394522" cy="560671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10" name="Group 9">
            <a:extLst>
              <a:ext uri="{FF2B5EF4-FFF2-40B4-BE49-F238E27FC236}">
                <a16:creationId xmlns:a16="http://schemas.microsoft.com/office/drawing/2014/main" id="{5CFB9244-5A25-0A0A-3B18-A4A13FE25E54}"/>
              </a:ext>
            </a:extLst>
          </p:cNvPr>
          <p:cNvGrpSpPr/>
          <p:nvPr/>
        </p:nvGrpSpPr>
        <p:grpSpPr>
          <a:xfrm rot="8712747">
            <a:off x="909316" y="2524543"/>
            <a:ext cx="843265" cy="385095"/>
            <a:chOff x="5071604" y="3000803"/>
            <a:chExt cx="843265" cy="385095"/>
          </a:xfrm>
        </p:grpSpPr>
        <p:sp>
          <p:nvSpPr>
            <p:cNvPr id="11" name="Rectangle: Top Corners Snipped 4">
              <a:extLst>
                <a:ext uri="{FF2B5EF4-FFF2-40B4-BE49-F238E27FC236}">
                  <a16:creationId xmlns:a16="http://schemas.microsoft.com/office/drawing/2014/main" id="{7B977097-9E67-16DD-176F-36F008D61209}"/>
                </a:ext>
              </a:extLst>
            </p:cNvPr>
            <p:cNvSpPr/>
            <p:nvPr/>
          </p:nvSpPr>
          <p:spPr>
            <a:xfrm rot="17074548">
              <a:off x="5300689" y="2771718"/>
              <a:ext cx="385095" cy="843265"/>
            </a:xfrm>
            <a:prstGeom prst="snip2SameRect">
              <a:avLst/>
            </a:prstGeom>
            <a:solidFill>
              <a:schemeClr val="tx1">
                <a:lumMod val="65000"/>
                <a:lumOff val="35000"/>
              </a:schemeClr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Oval 11">
              <a:extLst>
                <a:ext uri="{FF2B5EF4-FFF2-40B4-BE49-F238E27FC236}">
                  <a16:creationId xmlns:a16="http://schemas.microsoft.com/office/drawing/2014/main" id="{8FD01E9C-DAA0-AFBD-F7A1-AD29934BD78C}"/>
                </a:ext>
              </a:extLst>
            </p:cNvPr>
            <p:cNvSpPr/>
            <p:nvPr/>
          </p:nvSpPr>
          <p:spPr>
            <a:xfrm flipH="1" flipV="1">
              <a:off x="5193550" y="3238864"/>
              <a:ext cx="55712" cy="46107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3" name="Block Arc 12">
            <a:extLst>
              <a:ext uri="{FF2B5EF4-FFF2-40B4-BE49-F238E27FC236}">
                <a16:creationId xmlns:a16="http://schemas.microsoft.com/office/drawing/2014/main" id="{784E19FD-BE4F-8F34-0ED3-02554F7494A8}"/>
              </a:ext>
            </a:extLst>
          </p:cNvPr>
          <p:cNvSpPr/>
          <p:nvPr/>
        </p:nvSpPr>
        <p:spPr>
          <a:xfrm rot="4540169">
            <a:off x="1827455" y="1936770"/>
            <a:ext cx="1399641" cy="870149"/>
          </a:xfrm>
          <a:prstGeom prst="blockArc">
            <a:avLst>
              <a:gd name="adj1" fmla="val 10800000"/>
              <a:gd name="adj2" fmla="val 6"/>
              <a:gd name="adj3" fmla="val 26334"/>
            </a:avLst>
          </a:prstGeom>
          <a:effectLst>
            <a:softEdge rad="6350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4" name="Block Arc 13">
            <a:extLst>
              <a:ext uri="{FF2B5EF4-FFF2-40B4-BE49-F238E27FC236}">
                <a16:creationId xmlns:a16="http://schemas.microsoft.com/office/drawing/2014/main" id="{3E79C04E-029D-491E-99F8-B67384CBAD03}"/>
              </a:ext>
            </a:extLst>
          </p:cNvPr>
          <p:cNvSpPr/>
          <p:nvPr/>
        </p:nvSpPr>
        <p:spPr>
          <a:xfrm rot="4548798">
            <a:off x="1525325" y="2023535"/>
            <a:ext cx="1241095" cy="870149"/>
          </a:xfrm>
          <a:prstGeom prst="blockArc">
            <a:avLst>
              <a:gd name="adj1" fmla="val 10800000"/>
              <a:gd name="adj2" fmla="val 6"/>
              <a:gd name="adj3" fmla="val 26334"/>
            </a:avLst>
          </a:prstGeom>
          <a:effectLst>
            <a:softEdge rad="6350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5" name="Block Arc 14">
            <a:extLst>
              <a:ext uri="{FF2B5EF4-FFF2-40B4-BE49-F238E27FC236}">
                <a16:creationId xmlns:a16="http://schemas.microsoft.com/office/drawing/2014/main" id="{53D1722B-4A8F-9EAF-F4DC-BFB97DBEE68A}"/>
              </a:ext>
            </a:extLst>
          </p:cNvPr>
          <p:cNvSpPr/>
          <p:nvPr/>
        </p:nvSpPr>
        <p:spPr>
          <a:xfrm rot="4534082">
            <a:off x="1287572" y="2116587"/>
            <a:ext cx="1012634" cy="870149"/>
          </a:xfrm>
          <a:prstGeom prst="blockArc">
            <a:avLst>
              <a:gd name="adj1" fmla="val 10800000"/>
              <a:gd name="adj2" fmla="val 6"/>
              <a:gd name="adj3" fmla="val 26334"/>
            </a:avLst>
          </a:prstGeom>
          <a:effectLst>
            <a:softEdge rad="6350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8" name="Block Arc 17">
            <a:extLst>
              <a:ext uri="{FF2B5EF4-FFF2-40B4-BE49-F238E27FC236}">
                <a16:creationId xmlns:a16="http://schemas.microsoft.com/office/drawing/2014/main" id="{DF9CE7F3-1DE1-A633-684A-EFE01289897E}"/>
              </a:ext>
            </a:extLst>
          </p:cNvPr>
          <p:cNvSpPr/>
          <p:nvPr/>
        </p:nvSpPr>
        <p:spPr>
          <a:xfrm rot="4540169">
            <a:off x="2200129" y="1826407"/>
            <a:ext cx="1399641" cy="870149"/>
          </a:xfrm>
          <a:prstGeom prst="blockArc">
            <a:avLst>
              <a:gd name="adj1" fmla="val 10800000"/>
              <a:gd name="adj2" fmla="val 6"/>
              <a:gd name="adj3" fmla="val 26334"/>
            </a:avLst>
          </a:prstGeom>
          <a:effectLst>
            <a:softEdge rad="6350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9" name="Block Arc 18">
            <a:extLst>
              <a:ext uri="{FF2B5EF4-FFF2-40B4-BE49-F238E27FC236}">
                <a16:creationId xmlns:a16="http://schemas.microsoft.com/office/drawing/2014/main" id="{6582152C-9892-DF6E-89E9-E50C2C1BB272}"/>
              </a:ext>
            </a:extLst>
          </p:cNvPr>
          <p:cNvSpPr/>
          <p:nvPr/>
        </p:nvSpPr>
        <p:spPr>
          <a:xfrm rot="4540169">
            <a:off x="2599661" y="1707651"/>
            <a:ext cx="1399641" cy="870149"/>
          </a:xfrm>
          <a:prstGeom prst="blockArc">
            <a:avLst>
              <a:gd name="adj1" fmla="val 10800000"/>
              <a:gd name="adj2" fmla="val 6"/>
              <a:gd name="adj3" fmla="val 26334"/>
            </a:avLst>
          </a:prstGeom>
          <a:effectLst>
            <a:softEdge rad="6350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20" name="Block Arc 19">
            <a:extLst>
              <a:ext uri="{FF2B5EF4-FFF2-40B4-BE49-F238E27FC236}">
                <a16:creationId xmlns:a16="http://schemas.microsoft.com/office/drawing/2014/main" id="{22D81702-91DD-66D5-A000-1A1D59D680B0}"/>
              </a:ext>
            </a:extLst>
          </p:cNvPr>
          <p:cNvSpPr/>
          <p:nvPr/>
        </p:nvSpPr>
        <p:spPr>
          <a:xfrm rot="4540169">
            <a:off x="2973530" y="1635886"/>
            <a:ext cx="1399641" cy="870149"/>
          </a:xfrm>
          <a:prstGeom prst="blockArc">
            <a:avLst>
              <a:gd name="adj1" fmla="val 10800000"/>
              <a:gd name="adj2" fmla="val 6"/>
              <a:gd name="adj3" fmla="val 26334"/>
            </a:avLst>
          </a:prstGeom>
          <a:effectLst>
            <a:softEdge rad="6350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8CD17105-693D-B867-63E0-A564A80583A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411402" y="1209338"/>
            <a:ext cx="4942188" cy="3675752"/>
          </a:xfrm>
          <a:prstGeom prst="rect">
            <a:avLst/>
          </a:prstGeom>
        </p:spPr>
      </p:pic>
      <p:sp>
        <p:nvSpPr>
          <p:cNvPr id="23" name="Rectangle: Top Corners Snipped 4">
            <a:extLst>
              <a:ext uri="{FF2B5EF4-FFF2-40B4-BE49-F238E27FC236}">
                <a16:creationId xmlns:a16="http://schemas.microsoft.com/office/drawing/2014/main" id="{7B04B638-948B-5D3C-3569-2ED67C9607D2}"/>
              </a:ext>
            </a:extLst>
          </p:cNvPr>
          <p:cNvSpPr/>
          <p:nvPr/>
        </p:nvSpPr>
        <p:spPr>
          <a:xfrm rot="10800000">
            <a:off x="8638857" y="-153107"/>
            <a:ext cx="804246" cy="1341472"/>
          </a:xfrm>
          <a:prstGeom prst="snip2SameRect">
            <a:avLst/>
          </a:prstGeom>
          <a:solidFill>
            <a:schemeClr val="tx1">
              <a:lumMod val="65000"/>
              <a:lumOff val="35000"/>
            </a:schemeClr>
          </a:solidFill>
          <a:ln>
            <a:noFill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mc:AlternateContent xmlns:mc="http://schemas.openxmlformats.org/markup-compatibility/2006" xmlns:p14="http://schemas.microsoft.com/office/powerpoint/2010/main">
        <mc:Choice Requires="p14">
          <p:contentPart p14:bwMode="auto" r:id="rId7">
            <p14:nvContentPartPr>
              <p14:cNvPr id="24" name="Ink 23">
                <a:extLst>
                  <a:ext uri="{FF2B5EF4-FFF2-40B4-BE49-F238E27FC236}">
                    <a16:creationId xmlns:a16="http://schemas.microsoft.com/office/drawing/2014/main" id="{4222A2B9-74A8-6858-344C-3E1C882001DB}"/>
                  </a:ext>
                </a:extLst>
              </p14:cNvPr>
              <p14:cNvContentPartPr/>
              <p14:nvPr/>
            </p14:nvContentPartPr>
            <p14:xfrm>
              <a:off x="2123209" y="1379959"/>
              <a:ext cx="1879560" cy="1702440"/>
            </p14:xfrm>
          </p:contentPart>
        </mc:Choice>
        <mc:Fallback xmlns="">
          <p:pic>
            <p:nvPicPr>
              <p:cNvPr id="24" name="Ink 23">
                <a:extLst>
                  <a:ext uri="{FF2B5EF4-FFF2-40B4-BE49-F238E27FC236}">
                    <a16:creationId xmlns:a16="http://schemas.microsoft.com/office/drawing/2014/main" id="{4222A2B9-74A8-6858-344C-3E1C882001DB}"/>
                  </a:ext>
                </a:extLst>
              </p:cNvPr>
              <p:cNvPicPr/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2060569" y="1316959"/>
                <a:ext cx="2005200" cy="182808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9">
            <p14:nvContentPartPr>
              <p14:cNvPr id="25" name="Ink 24">
                <a:extLst>
                  <a:ext uri="{FF2B5EF4-FFF2-40B4-BE49-F238E27FC236}">
                    <a16:creationId xmlns:a16="http://schemas.microsoft.com/office/drawing/2014/main" id="{CB71AA0C-7B8A-75DF-80FD-56D78D3E6DE0}"/>
                  </a:ext>
                </a:extLst>
              </p14:cNvPr>
              <p14:cNvContentPartPr/>
              <p14:nvPr/>
            </p14:nvContentPartPr>
            <p14:xfrm>
              <a:off x="8424649" y="2398759"/>
              <a:ext cx="1739520" cy="1096560"/>
            </p14:xfrm>
          </p:contentPart>
        </mc:Choice>
        <mc:Fallback xmlns="">
          <p:pic>
            <p:nvPicPr>
              <p:cNvPr id="25" name="Ink 24">
                <a:extLst>
                  <a:ext uri="{FF2B5EF4-FFF2-40B4-BE49-F238E27FC236}">
                    <a16:creationId xmlns:a16="http://schemas.microsoft.com/office/drawing/2014/main" id="{CB71AA0C-7B8A-75DF-80FD-56D78D3E6DE0}"/>
                  </a:ext>
                </a:extLst>
              </p:cNvPr>
              <p:cNvPicPr/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8362009" y="2336119"/>
                <a:ext cx="1865160" cy="12222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11">
            <p14:nvContentPartPr>
              <p14:cNvPr id="26" name="Ink 25">
                <a:extLst>
                  <a:ext uri="{FF2B5EF4-FFF2-40B4-BE49-F238E27FC236}">
                    <a16:creationId xmlns:a16="http://schemas.microsoft.com/office/drawing/2014/main" id="{D29D407E-8C5D-82E2-0227-A4E3FD24A599}"/>
                  </a:ext>
                </a:extLst>
              </p14:cNvPr>
              <p14:cNvContentPartPr/>
              <p14:nvPr/>
            </p14:nvContentPartPr>
            <p14:xfrm>
              <a:off x="4070449" y="1483639"/>
              <a:ext cx="844200" cy="2032920"/>
            </p14:xfrm>
          </p:contentPart>
        </mc:Choice>
        <mc:Fallback xmlns="">
          <p:pic>
            <p:nvPicPr>
              <p:cNvPr id="26" name="Ink 25">
                <a:extLst>
                  <a:ext uri="{FF2B5EF4-FFF2-40B4-BE49-F238E27FC236}">
                    <a16:creationId xmlns:a16="http://schemas.microsoft.com/office/drawing/2014/main" id="{D29D407E-8C5D-82E2-0227-A4E3FD24A599}"/>
                  </a:ext>
                </a:extLst>
              </p:cNvPr>
              <p:cNvPicPr/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4034809" y="1447639"/>
                <a:ext cx="915840" cy="210456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13">
            <p14:nvContentPartPr>
              <p14:cNvPr id="27" name="Ink 26">
                <a:extLst>
                  <a:ext uri="{FF2B5EF4-FFF2-40B4-BE49-F238E27FC236}">
                    <a16:creationId xmlns:a16="http://schemas.microsoft.com/office/drawing/2014/main" id="{047A7A6D-0305-4F62-264B-1A9BB843D351}"/>
                  </a:ext>
                </a:extLst>
              </p14:cNvPr>
              <p14:cNvContentPartPr/>
              <p14:nvPr/>
            </p14:nvContentPartPr>
            <p14:xfrm>
              <a:off x="4903849" y="1831399"/>
              <a:ext cx="144360" cy="1375560"/>
            </p14:xfrm>
          </p:contentPart>
        </mc:Choice>
        <mc:Fallback xmlns="">
          <p:pic>
            <p:nvPicPr>
              <p:cNvPr id="27" name="Ink 26">
                <a:extLst>
                  <a:ext uri="{FF2B5EF4-FFF2-40B4-BE49-F238E27FC236}">
                    <a16:creationId xmlns:a16="http://schemas.microsoft.com/office/drawing/2014/main" id="{047A7A6D-0305-4F62-264B-1A9BB843D351}"/>
                  </a:ext>
                </a:extLst>
              </p:cNvPr>
              <p:cNvPicPr/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4867849" y="1795399"/>
                <a:ext cx="216000" cy="14472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15">
            <p14:nvContentPartPr>
              <p14:cNvPr id="28" name="Ink 27">
                <a:extLst>
                  <a:ext uri="{FF2B5EF4-FFF2-40B4-BE49-F238E27FC236}">
                    <a16:creationId xmlns:a16="http://schemas.microsoft.com/office/drawing/2014/main" id="{BE72B21A-6EE1-B0E6-9C32-A330CA79AB4A}"/>
                  </a:ext>
                </a:extLst>
              </p14:cNvPr>
              <p14:cNvContentPartPr/>
              <p14:nvPr/>
            </p14:nvContentPartPr>
            <p14:xfrm>
              <a:off x="8790049" y="3596119"/>
              <a:ext cx="1025280" cy="590040"/>
            </p14:xfrm>
          </p:contentPart>
        </mc:Choice>
        <mc:Fallback xmlns="">
          <p:pic>
            <p:nvPicPr>
              <p:cNvPr id="28" name="Ink 27">
                <a:extLst>
                  <a:ext uri="{FF2B5EF4-FFF2-40B4-BE49-F238E27FC236}">
                    <a16:creationId xmlns:a16="http://schemas.microsoft.com/office/drawing/2014/main" id="{BE72B21A-6EE1-B0E6-9C32-A330CA79AB4A}"/>
                  </a:ext>
                </a:extLst>
              </p:cNvPr>
              <p:cNvPicPr/>
              <p:nvPr/>
            </p:nvPicPr>
            <p:blipFill>
              <a:blip r:embed="rId16"/>
              <a:stretch>
                <a:fillRect/>
              </a:stretch>
            </p:blipFill>
            <p:spPr>
              <a:xfrm>
                <a:off x="8754409" y="3560119"/>
                <a:ext cx="1096920" cy="661680"/>
              </a:xfrm>
              <a:prstGeom prst="rect">
                <a:avLst/>
              </a:prstGeom>
            </p:spPr>
          </p:pic>
        </mc:Fallback>
      </mc:AlternateContent>
      <p:pic>
        <p:nvPicPr>
          <p:cNvPr id="2" name="Audio Recording Sep 27, 2022 at 8:24:11 PM" descr="Audio Recording Sep 27, 2022 at 8:24:11 PM">
            <a:hlinkClick r:id="" action="ppaction://media"/>
            <a:extLst>
              <a:ext uri="{FF2B5EF4-FFF2-40B4-BE49-F238E27FC236}">
                <a16:creationId xmlns:a16="http://schemas.microsoft.com/office/drawing/2014/main" id="{DAB428D6-29B5-6B7D-EC64-CCD1685CA127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17"/>
          <a:stretch>
            <a:fillRect/>
          </a:stretch>
        </p:blipFill>
        <p:spPr>
          <a:xfrm>
            <a:off x="10972147" y="5243754"/>
            <a:ext cx="812800" cy="812800"/>
          </a:xfrm>
          <a:prstGeom prst="rect">
            <a:avLst/>
          </a:prstGeom>
        </p:spPr>
      </p:pic>
      <p:pic>
        <p:nvPicPr>
          <p:cNvPr id="4" name="Picture 2">
            <a:extLst>
              <a:ext uri="{FF2B5EF4-FFF2-40B4-BE49-F238E27FC236}">
                <a16:creationId xmlns:a16="http://schemas.microsoft.com/office/drawing/2014/main" id="{F7386B74-28DA-1F6D-2DEF-5CD6A575050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6851" y="727161"/>
            <a:ext cx="563680" cy="1972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82281825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09248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1" fill="hold">
                            <p:stCondLst>
                              <p:cond delay="0"/>
                            </p:stCondLst>
                            <p:childTnLst>
                              <p:par>
                                <p:cTn id="12" presetID="9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dissolve">
                                      <p:cBhvr>
                                        <p:cTn id="14" dur="500"/>
                                        <p:tgtEl>
                                          <p:spTgt spid="1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5" fill="hold">
                            <p:stCondLst>
                              <p:cond delay="500"/>
                            </p:stCondLst>
                            <p:childTnLst>
                              <p:par>
                                <p:cTn id="16" presetID="9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dissolve">
                                      <p:cBhvr>
                                        <p:cTn id="18" dur="500"/>
                                        <p:tgtEl>
                                          <p:spTgt spid="1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9" fill="hold">
                            <p:stCondLst>
                              <p:cond delay="1000"/>
                            </p:stCondLst>
                            <p:childTnLst>
                              <p:par>
                                <p:cTn id="20" presetID="9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dissolve">
                                      <p:cBhvr>
                                        <p:cTn id="22" dur="500"/>
                                        <p:tgtEl>
                                          <p:spTgt spid="1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3" fill="hold">
                            <p:stCondLst>
                              <p:cond delay="1500"/>
                            </p:stCondLst>
                            <p:childTnLst>
                              <p:par>
                                <p:cTn id="24" presetID="1" presetClass="entr" presetSubtype="0" fill="hold" grpId="1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6" fill="hold">
                            <p:stCondLst>
                              <p:cond delay="1500"/>
                            </p:stCondLst>
                            <p:childTnLst>
                              <p:par>
                                <p:cTn id="27" presetID="9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dissolve">
                                      <p:cBhvr>
                                        <p:cTn id="29" dur="500"/>
                                        <p:tgtEl>
                                          <p:spTgt spid="1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0" fill="hold">
                            <p:stCondLst>
                              <p:cond delay="2000"/>
                            </p:stCondLst>
                            <p:childTnLst>
                              <p:par>
                                <p:cTn id="31" presetID="9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dissolve">
                                      <p:cBhvr>
                                        <p:cTn id="33" dur="500"/>
                                        <p:tgtEl>
                                          <p:spTgt spid="1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4" fill="hold">
                            <p:stCondLst>
                              <p:cond delay="2500"/>
                            </p:stCondLst>
                            <p:childTnLst>
                              <p:par>
                                <p:cTn id="35" presetID="9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dissolve">
                                      <p:cBhvr>
                                        <p:cTn id="37" dur="500"/>
                                        <p:tgtEl>
                                          <p:spTgt spid="2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8" fill="hold">
                            <p:stCondLst>
                              <p:cond delay="3000"/>
                            </p:stCondLst>
                            <p:childTnLst>
                              <p:par>
                                <p:cTn id="39" presetID="1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3" fill="hold">
                      <p:stCondLst>
                        <p:cond delay="indefinite"/>
                      </p:stCondLst>
                      <p:childTnLst>
                        <p:par>
                          <p:cTn id="44" fill="hold">
                            <p:stCondLst>
                              <p:cond delay="0"/>
                            </p:stCondLst>
                            <p:childTnLst>
                              <p:par>
                                <p:cTn id="4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9" fill="hold">
                      <p:stCondLst>
                        <p:cond delay="indefinite"/>
                      </p:stCondLst>
                      <p:childTnLst>
                        <p:par>
                          <p:cTn id="50" fill="hold">
                            <p:stCondLst>
                              <p:cond delay="0"/>
                            </p:stCondLst>
                            <p:childTnLst>
                              <p:par>
                                <p:cTn id="5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5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  <p:bldLst>
      <p:bldP spid="13" grpId="0" animBg="1"/>
      <p:bldP spid="14" grpId="0" animBg="1"/>
      <p:bldP spid="15" grpId="0" animBg="1"/>
      <p:bldP spid="15" grpId="1" animBg="1"/>
      <p:bldP spid="18" grpId="0" animBg="1"/>
      <p:bldP spid="19" grpId="0" animBg="1"/>
      <p:bldP spid="20" grpId="0" animBg="1"/>
      <p:bldP spid="23" grpId="0" animBg="1"/>
    </p:bld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6" descr="Sagittal section female pelvis with peritoneum">
            <a:extLst>
              <a:ext uri="{FF2B5EF4-FFF2-40B4-BE49-F238E27FC236}">
                <a16:creationId xmlns:a16="http://schemas.microsoft.com/office/drawing/2014/main" id="{0DDB9C0F-0B4E-9D39-32C1-40D3D26A517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48227" y="322851"/>
            <a:ext cx="4152766" cy="54595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A77FBC8-3CF1-1ED6-5B57-2F061F46984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endParaRPr lang="en-US" sz="900" dirty="0">
              <a:solidFill>
                <a:srgbClr val="000000"/>
              </a:solidFill>
              <a:latin typeface="Verdana" panose="020B0604030504040204" pitchFamily="34" charset="0"/>
            </a:endParaRPr>
          </a:p>
          <a:p>
            <a:endParaRPr lang="en-US" sz="900" dirty="0">
              <a:solidFill>
                <a:srgbClr val="000000"/>
              </a:solidFill>
              <a:latin typeface="Verdana" panose="020B0604030504040204" pitchFamily="34" charset="0"/>
            </a:endParaRPr>
          </a:p>
          <a:p>
            <a:pPr algn="l"/>
            <a:endParaRPr lang="en-US" sz="900" b="0" i="0" dirty="0">
              <a:solidFill>
                <a:srgbClr val="000000"/>
              </a:solidFill>
              <a:effectLst/>
              <a:latin typeface="Verdana" panose="020B0604030504040204" pitchFamily="34" charset="0"/>
            </a:endParaRPr>
          </a:p>
          <a:p>
            <a:pPr algn="l"/>
            <a:endParaRPr lang="en-US" sz="900" b="0" i="0" dirty="0">
              <a:solidFill>
                <a:srgbClr val="000000"/>
              </a:solidFill>
              <a:effectLst/>
              <a:latin typeface="Verdana" panose="020B0604030504040204" pitchFamily="34" charset="0"/>
            </a:endParaRPr>
          </a:p>
          <a:p>
            <a:endParaRPr lang="en-US" sz="1100" dirty="0"/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5CFB9244-5A25-0A0A-3B18-A4A13FE25E54}"/>
              </a:ext>
            </a:extLst>
          </p:cNvPr>
          <p:cNvGrpSpPr/>
          <p:nvPr/>
        </p:nvGrpSpPr>
        <p:grpSpPr>
          <a:xfrm rot="8712747">
            <a:off x="872488" y="2805897"/>
            <a:ext cx="843265" cy="385095"/>
            <a:chOff x="5071604" y="3000803"/>
            <a:chExt cx="843265" cy="385095"/>
          </a:xfrm>
        </p:grpSpPr>
        <p:sp>
          <p:nvSpPr>
            <p:cNvPr id="11" name="Rectangle: Top Corners Snipped 4">
              <a:extLst>
                <a:ext uri="{FF2B5EF4-FFF2-40B4-BE49-F238E27FC236}">
                  <a16:creationId xmlns:a16="http://schemas.microsoft.com/office/drawing/2014/main" id="{7B977097-9E67-16DD-176F-36F008D61209}"/>
                </a:ext>
              </a:extLst>
            </p:cNvPr>
            <p:cNvSpPr/>
            <p:nvPr/>
          </p:nvSpPr>
          <p:spPr>
            <a:xfrm rot="17074548">
              <a:off x="5300689" y="2771718"/>
              <a:ext cx="385095" cy="843265"/>
            </a:xfrm>
            <a:prstGeom prst="snip2SameRect">
              <a:avLst/>
            </a:prstGeom>
            <a:solidFill>
              <a:schemeClr val="tx1">
                <a:lumMod val="65000"/>
                <a:lumOff val="35000"/>
              </a:schemeClr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Oval 11">
              <a:extLst>
                <a:ext uri="{FF2B5EF4-FFF2-40B4-BE49-F238E27FC236}">
                  <a16:creationId xmlns:a16="http://schemas.microsoft.com/office/drawing/2014/main" id="{8FD01E9C-DAA0-AFBD-F7A1-AD29934BD78C}"/>
                </a:ext>
              </a:extLst>
            </p:cNvPr>
            <p:cNvSpPr/>
            <p:nvPr/>
          </p:nvSpPr>
          <p:spPr>
            <a:xfrm flipH="1" flipV="1">
              <a:off x="5193550" y="3238864"/>
              <a:ext cx="55712" cy="46107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3" name="Block Arc 12">
            <a:extLst>
              <a:ext uri="{FF2B5EF4-FFF2-40B4-BE49-F238E27FC236}">
                <a16:creationId xmlns:a16="http://schemas.microsoft.com/office/drawing/2014/main" id="{784E19FD-BE4F-8F34-0ED3-02554F7494A8}"/>
              </a:ext>
            </a:extLst>
          </p:cNvPr>
          <p:cNvSpPr/>
          <p:nvPr/>
        </p:nvSpPr>
        <p:spPr>
          <a:xfrm rot="4540169">
            <a:off x="1790627" y="2218124"/>
            <a:ext cx="1399641" cy="870149"/>
          </a:xfrm>
          <a:prstGeom prst="blockArc">
            <a:avLst>
              <a:gd name="adj1" fmla="val 10800000"/>
              <a:gd name="adj2" fmla="val 6"/>
              <a:gd name="adj3" fmla="val 26334"/>
            </a:avLst>
          </a:prstGeom>
          <a:effectLst>
            <a:softEdge rad="6350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4" name="Block Arc 13">
            <a:extLst>
              <a:ext uri="{FF2B5EF4-FFF2-40B4-BE49-F238E27FC236}">
                <a16:creationId xmlns:a16="http://schemas.microsoft.com/office/drawing/2014/main" id="{3E79C04E-029D-491E-99F8-B67384CBAD03}"/>
              </a:ext>
            </a:extLst>
          </p:cNvPr>
          <p:cNvSpPr/>
          <p:nvPr/>
        </p:nvSpPr>
        <p:spPr>
          <a:xfrm rot="4548798">
            <a:off x="1488497" y="2304889"/>
            <a:ext cx="1241095" cy="870149"/>
          </a:xfrm>
          <a:prstGeom prst="blockArc">
            <a:avLst>
              <a:gd name="adj1" fmla="val 10800000"/>
              <a:gd name="adj2" fmla="val 6"/>
              <a:gd name="adj3" fmla="val 26334"/>
            </a:avLst>
          </a:prstGeom>
          <a:effectLst>
            <a:softEdge rad="6350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5" name="Block Arc 14">
            <a:extLst>
              <a:ext uri="{FF2B5EF4-FFF2-40B4-BE49-F238E27FC236}">
                <a16:creationId xmlns:a16="http://schemas.microsoft.com/office/drawing/2014/main" id="{53D1722B-4A8F-9EAF-F4DC-BFB97DBEE68A}"/>
              </a:ext>
            </a:extLst>
          </p:cNvPr>
          <p:cNvSpPr/>
          <p:nvPr/>
        </p:nvSpPr>
        <p:spPr>
          <a:xfrm rot="4534082">
            <a:off x="1250744" y="2397941"/>
            <a:ext cx="1012634" cy="870149"/>
          </a:xfrm>
          <a:prstGeom prst="blockArc">
            <a:avLst>
              <a:gd name="adj1" fmla="val 10800000"/>
              <a:gd name="adj2" fmla="val 6"/>
              <a:gd name="adj3" fmla="val 26334"/>
            </a:avLst>
          </a:prstGeom>
          <a:effectLst>
            <a:softEdge rad="6350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8" name="Block Arc 17">
            <a:extLst>
              <a:ext uri="{FF2B5EF4-FFF2-40B4-BE49-F238E27FC236}">
                <a16:creationId xmlns:a16="http://schemas.microsoft.com/office/drawing/2014/main" id="{DF9CE7F3-1DE1-A633-684A-EFE01289897E}"/>
              </a:ext>
            </a:extLst>
          </p:cNvPr>
          <p:cNvSpPr/>
          <p:nvPr/>
        </p:nvSpPr>
        <p:spPr>
          <a:xfrm rot="4540169">
            <a:off x="2163301" y="2107761"/>
            <a:ext cx="1399641" cy="870149"/>
          </a:xfrm>
          <a:prstGeom prst="blockArc">
            <a:avLst>
              <a:gd name="adj1" fmla="val 10800000"/>
              <a:gd name="adj2" fmla="val 6"/>
              <a:gd name="adj3" fmla="val 26334"/>
            </a:avLst>
          </a:prstGeom>
          <a:effectLst>
            <a:softEdge rad="6350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9" name="Block Arc 18">
            <a:extLst>
              <a:ext uri="{FF2B5EF4-FFF2-40B4-BE49-F238E27FC236}">
                <a16:creationId xmlns:a16="http://schemas.microsoft.com/office/drawing/2014/main" id="{6582152C-9892-DF6E-89E9-E50C2C1BB272}"/>
              </a:ext>
            </a:extLst>
          </p:cNvPr>
          <p:cNvSpPr/>
          <p:nvPr/>
        </p:nvSpPr>
        <p:spPr>
          <a:xfrm rot="4540169">
            <a:off x="2562833" y="1989005"/>
            <a:ext cx="1399641" cy="870149"/>
          </a:xfrm>
          <a:prstGeom prst="blockArc">
            <a:avLst>
              <a:gd name="adj1" fmla="val 10800000"/>
              <a:gd name="adj2" fmla="val 6"/>
              <a:gd name="adj3" fmla="val 26334"/>
            </a:avLst>
          </a:prstGeom>
          <a:effectLst>
            <a:softEdge rad="6350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20" name="Block Arc 19">
            <a:extLst>
              <a:ext uri="{FF2B5EF4-FFF2-40B4-BE49-F238E27FC236}">
                <a16:creationId xmlns:a16="http://schemas.microsoft.com/office/drawing/2014/main" id="{22D81702-91DD-66D5-A000-1A1D59D680B0}"/>
              </a:ext>
            </a:extLst>
          </p:cNvPr>
          <p:cNvSpPr/>
          <p:nvPr/>
        </p:nvSpPr>
        <p:spPr>
          <a:xfrm rot="4540169">
            <a:off x="2936702" y="1917240"/>
            <a:ext cx="1399641" cy="870149"/>
          </a:xfrm>
          <a:prstGeom prst="blockArc">
            <a:avLst>
              <a:gd name="adj1" fmla="val 10800000"/>
              <a:gd name="adj2" fmla="val 6"/>
              <a:gd name="adj3" fmla="val 26334"/>
            </a:avLst>
          </a:prstGeom>
          <a:effectLst>
            <a:softEdge rad="6350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8CD17105-693D-B867-63E0-A564A80583A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411402" y="1209338"/>
            <a:ext cx="4942188" cy="3675752"/>
          </a:xfrm>
          <a:prstGeom prst="rect">
            <a:avLst/>
          </a:prstGeom>
        </p:spPr>
      </p:pic>
      <p:sp>
        <p:nvSpPr>
          <p:cNvPr id="4" name="Rectangle: Top Corners Snipped 4">
            <a:extLst>
              <a:ext uri="{FF2B5EF4-FFF2-40B4-BE49-F238E27FC236}">
                <a16:creationId xmlns:a16="http://schemas.microsoft.com/office/drawing/2014/main" id="{EF1A4456-4446-5B8D-8341-F22F8D586572}"/>
              </a:ext>
            </a:extLst>
          </p:cNvPr>
          <p:cNvSpPr/>
          <p:nvPr/>
        </p:nvSpPr>
        <p:spPr>
          <a:xfrm rot="10800000">
            <a:off x="8618760" y="-153107"/>
            <a:ext cx="804246" cy="1341472"/>
          </a:xfrm>
          <a:prstGeom prst="snip2SameRect">
            <a:avLst/>
          </a:prstGeom>
          <a:solidFill>
            <a:schemeClr val="tx1">
              <a:lumMod val="65000"/>
              <a:lumOff val="35000"/>
            </a:schemeClr>
          </a:solidFill>
          <a:ln>
            <a:noFill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" name="Audio Recording Sep 27, 2022 at 8:25:45 PM" descr="Audio Recording Sep 27, 2022 at 8:25:45 PM">
            <a:hlinkClick r:id="" action="ppaction://media"/>
            <a:extLst>
              <a:ext uri="{FF2B5EF4-FFF2-40B4-BE49-F238E27FC236}">
                <a16:creationId xmlns:a16="http://schemas.microsoft.com/office/drawing/2014/main" id="{6AA4528B-7AFA-CDB8-FA94-68596EEDCC35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10779701" y="5235184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7353528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47424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1" fill="hold">
                            <p:stCondLst>
                              <p:cond delay="0"/>
                            </p:stCondLst>
                            <p:childTnLst>
                              <p:par>
                                <p:cTn id="12" presetID="9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dissolve">
                                      <p:cBhvr>
                                        <p:cTn id="14" dur="500"/>
                                        <p:tgtEl>
                                          <p:spTgt spid="1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5" fill="hold">
                            <p:stCondLst>
                              <p:cond delay="500"/>
                            </p:stCondLst>
                            <p:childTnLst>
                              <p:par>
                                <p:cTn id="16" presetID="9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dissolve">
                                      <p:cBhvr>
                                        <p:cTn id="18" dur="500"/>
                                        <p:tgtEl>
                                          <p:spTgt spid="1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9" fill="hold">
                            <p:stCondLst>
                              <p:cond delay="1000"/>
                            </p:stCondLst>
                            <p:childTnLst>
                              <p:par>
                                <p:cTn id="20" presetID="9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dissolve">
                                      <p:cBhvr>
                                        <p:cTn id="22" dur="500"/>
                                        <p:tgtEl>
                                          <p:spTgt spid="1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3" fill="hold">
                            <p:stCondLst>
                              <p:cond delay="1500"/>
                            </p:stCondLst>
                            <p:childTnLst>
                              <p:par>
                                <p:cTn id="24" presetID="1" presetClass="entr" presetSubtype="0" fill="hold" grpId="1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6" fill="hold">
                            <p:stCondLst>
                              <p:cond delay="1500"/>
                            </p:stCondLst>
                            <p:childTnLst>
                              <p:par>
                                <p:cTn id="27" presetID="9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dissolve">
                                      <p:cBhvr>
                                        <p:cTn id="29" dur="500"/>
                                        <p:tgtEl>
                                          <p:spTgt spid="1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0" fill="hold">
                            <p:stCondLst>
                              <p:cond delay="2000"/>
                            </p:stCondLst>
                            <p:childTnLst>
                              <p:par>
                                <p:cTn id="31" presetID="9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dissolve">
                                      <p:cBhvr>
                                        <p:cTn id="33" dur="500"/>
                                        <p:tgtEl>
                                          <p:spTgt spid="1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4" fill="hold">
                            <p:stCondLst>
                              <p:cond delay="2500"/>
                            </p:stCondLst>
                            <p:childTnLst>
                              <p:par>
                                <p:cTn id="35" presetID="9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dissolve">
                                      <p:cBhvr>
                                        <p:cTn id="37" dur="500"/>
                                        <p:tgtEl>
                                          <p:spTgt spid="2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8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40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5"/>
                </p:tgtEl>
              </p:cMediaNode>
            </p:audio>
          </p:childTnLst>
        </p:cTn>
      </p:par>
    </p:tnLst>
    <p:bldLst>
      <p:bldP spid="13" grpId="0" animBg="1"/>
      <p:bldP spid="14" grpId="0" animBg="1"/>
      <p:bldP spid="15" grpId="0" animBg="1"/>
      <p:bldP spid="15" grpId="1" animBg="1"/>
      <p:bldP spid="18" grpId="0" animBg="1"/>
      <p:bldP spid="19" grpId="0" animBg="1"/>
      <p:bldP spid="20" grpId="0" animBg="1"/>
      <p:bldP spid="4" grpId="0" animBg="1"/>
    </p:bld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Picture 6" descr="Sagittal section female pelvis with peritoneum">
            <a:extLst>
              <a:ext uri="{FF2B5EF4-FFF2-40B4-BE49-F238E27FC236}">
                <a16:creationId xmlns:a16="http://schemas.microsoft.com/office/drawing/2014/main" id="{99B372C2-12B7-0280-36F9-9872E133425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63322" y="396453"/>
            <a:ext cx="4152766" cy="54595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4" name="Picture 8" descr="A filled bladder displaces the peritoneum upwards and brings the bladder preperitoneal">
            <a:extLst>
              <a:ext uri="{FF2B5EF4-FFF2-40B4-BE49-F238E27FC236}">
                <a16:creationId xmlns:a16="http://schemas.microsoft.com/office/drawing/2014/main" id="{670B7487-1FBA-4746-4B1D-39D4D45F8A3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75912" y="396453"/>
            <a:ext cx="4394522" cy="560671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mc:AlternateContent xmlns:mc="http://schemas.openxmlformats.org/markup-compatibility/2006" xmlns:p14="http://schemas.microsoft.com/office/powerpoint/2010/main">
        <mc:Choice Requires="p14">
          <p:contentPart p14:bwMode="auto" r:id="rId7">
            <p14:nvContentPartPr>
              <p14:cNvPr id="25" name="Ink 24">
                <a:extLst>
                  <a:ext uri="{FF2B5EF4-FFF2-40B4-BE49-F238E27FC236}">
                    <a16:creationId xmlns:a16="http://schemas.microsoft.com/office/drawing/2014/main" id="{15DA6F56-6475-8E0C-9E65-B1C160D40B1E}"/>
                  </a:ext>
                </a:extLst>
              </p14:cNvPr>
              <p14:cNvContentPartPr/>
              <p14:nvPr/>
            </p14:nvContentPartPr>
            <p14:xfrm>
              <a:off x="3793640" y="1667779"/>
              <a:ext cx="516240" cy="909360"/>
            </p14:xfrm>
          </p:contentPart>
        </mc:Choice>
        <mc:Fallback xmlns="">
          <p:pic>
            <p:nvPicPr>
              <p:cNvPr id="25" name="Ink 24">
                <a:extLst>
                  <a:ext uri="{FF2B5EF4-FFF2-40B4-BE49-F238E27FC236}">
                    <a16:creationId xmlns:a16="http://schemas.microsoft.com/office/drawing/2014/main" id="{15DA6F56-6475-8E0C-9E65-B1C160D40B1E}"/>
                  </a:ext>
                </a:extLst>
              </p:cNvPr>
              <p:cNvPicPr/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3758000" y="1631779"/>
                <a:ext cx="587880" cy="9810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9">
            <p14:nvContentPartPr>
              <p14:cNvPr id="26" name="Ink 25">
                <a:extLst>
                  <a:ext uri="{FF2B5EF4-FFF2-40B4-BE49-F238E27FC236}">
                    <a16:creationId xmlns:a16="http://schemas.microsoft.com/office/drawing/2014/main" id="{69C3D500-6A4E-F83B-2927-1B42C7C87DD7}"/>
                  </a:ext>
                </a:extLst>
              </p14:cNvPr>
              <p14:cNvContentPartPr/>
              <p14:nvPr/>
            </p14:nvContentPartPr>
            <p14:xfrm>
              <a:off x="8124769" y="2615479"/>
              <a:ext cx="805680" cy="428400"/>
            </p14:xfrm>
          </p:contentPart>
        </mc:Choice>
        <mc:Fallback xmlns="">
          <p:pic>
            <p:nvPicPr>
              <p:cNvPr id="26" name="Ink 25">
                <a:extLst>
                  <a:ext uri="{FF2B5EF4-FFF2-40B4-BE49-F238E27FC236}">
                    <a16:creationId xmlns:a16="http://schemas.microsoft.com/office/drawing/2014/main" id="{69C3D500-6A4E-F83B-2927-1B42C7C87DD7}"/>
                  </a:ext>
                </a:extLst>
              </p:cNvPr>
              <p:cNvPicPr/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8088769" y="2579839"/>
                <a:ext cx="877320" cy="50004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11">
            <p14:nvContentPartPr>
              <p14:cNvPr id="28" name="Ink 27">
                <a:extLst>
                  <a:ext uri="{FF2B5EF4-FFF2-40B4-BE49-F238E27FC236}">
                    <a16:creationId xmlns:a16="http://schemas.microsoft.com/office/drawing/2014/main" id="{06623AB6-BB56-8095-7599-220F81F5D65E}"/>
                  </a:ext>
                </a:extLst>
              </p14:cNvPr>
              <p14:cNvContentPartPr/>
              <p14:nvPr/>
            </p14:nvContentPartPr>
            <p14:xfrm>
              <a:off x="7773409" y="2481559"/>
              <a:ext cx="405000" cy="191160"/>
            </p14:xfrm>
          </p:contentPart>
        </mc:Choice>
        <mc:Fallback xmlns="">
          <p:pic>
            <p:nvPicPr>
              <p:cNvPr id="28" name="Ink 27">
                <a:extLst>
                  <a:ext uri="{FF2B5EF4-FFF2-40B4-BE49-F238E27FC236}">
                    <a16:creationId xmlns:a16="http://schemas.microsoft.com/office/drawing/2014/main" id="{06623AB6-BB56-8095-7599-220F81F5D65E}"/>
                  </a:ext>
                </a:extLst>
              </p:cNvPr>
              <p:cNvPicPr/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7737409" y="2445559"/>
                <a:ext cx="476640" cy="2628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13">
            <p14:nvContentPartPr>
              <p14:cNvPr id="30" name="Ink 29">
                <a:extLst>
                  <a:ext uri="{FF2B5EF4-FFF2-40B4-BE49-F238E27FC236}">
                    <a16:creationId xmlns:a16="http://schemas.microsoft.com/office/drawing/2014/main" id="{0668773F-C93E-CE02-6E09-4962B08910E8}"/>
                  </a:ext>
                </a:extLst>
              </p14:cNvPr>
              <p14:cNvContentPartPr/>
              <p14:nvPr/>
            </p14:nvContentPartPr>
            <p14:xfrm>
              <a:off x="7729129" y="2524759"/>
              <a:ext cx="279720" cy="169560"/>
            </p14:xfrm>
          </p:contentPart>
        </mc:Choice>
        <mc:Fallback xmlns="">
          <p:pic>
            <p:nvPicPr>
              <p:cNvPr id="30" name="Ink 29">
                <a:extLst>
                  <a:ext uri="{FF2B5EF4-FFF2-40B4-BE49-F238E27FC236}">
                    <a16:creationId xmlns:a16="http://schemas.microsoft.com/office/drawing/2014/main" id="{0668773F-C93E-CE02-6E09-4962B08910E8}"/>
                  </a:ext>
                </a:extLst>
              </p:cNvPr>
              <p:cNvPicPr/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7693489" y="2489119"/>
                <a:ext cx="351360" cy="2412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15">
            <p14:nvContentPartPr>
              <p14:cNvPr id="32" name="Ink 31">
                <a:extLst>
                  <a:ext uri="{FF2B5EF4-FFF2-40B4-BE49-F238E27FC236}">
                    <a16:creationId xmlns:a16="http://schemas.microsoft.com/office/drawing/2014/main" id="{3119A96D-60D7-F4E8-1CFB-1732FB3C4DAB}"/>
                  </a:ext>
                </a:extLst>
              </p14:cNvPr>
              <p14:cNvContentPartPr/>
              <p14:nvPr/>
            </p14:nvContentPartPr>
            <p14:xfrm>
              <a:off x="8578729" y="1877119"/>
              <a:ext cx="897480" cy="951480"/>
            </p14:xfrm>
          </p:contentPart>
        </mc:Choice>
        <mc:Fallback xmlns="">
          <p:pic>
            <p:nvPicPr>
              <p:cNvPr id="32" name="Ink 31">
                <a:extLst>
                  <a:ext uri="{FF2B5EF4-FFF2-40B4-BE49-F238E27FC236}">
                    <a16:creationId xmlns:a16="http://schemas.microsoft.com/office/drawing/2014/main" id="{3119A96D-60D7-F4E8-1CFB-1732FB3C4DAB}"/>
                  </a:ext>
                </a:extLst>
              </p:cNvPr>
              <p:cNvPicPr/>
              <p:nvPr/>
            </p:nvPicPr>
            <p:blipFill>
              <a:blip r:embed="rId16"/>
              <a:stretch>
                <a:fillRect/>
              </a:stretch>
            </p:blipFill>
            <p:spPr>
              <a:xfrm>
                <a:off x="8542729" y="1841479"/>
                <a:ext cx="969120" cy="1023120"/>
              </a:xfrm>
              <a:prstGeom prst="rect">
                <a:avLst/>
              </a:prstGeom>
            </p:spPr>
          </p:pic>
        </mc:Fallback>
      </mc:AlternateContent>
      <p:pic>
        <p:nvPicPr>
          <p:cNvPr id="2" name="Audio Recording Sep 27, 2022 at 8:26:49 PM" descr="Audio Recording Sep 27, 2022 at 8:26:49 PM">
            <a:hlinkClick r:id="" action="ppaction://media"/>
            <a:extLst>
              <a:ext uri="{FF2B5EF4-FFF2-40B4-BE49-F238E27FC236}">
                <a16:creationId xmlns:a16="http://schemas.microsoft.com/office/drawing/2014/main" id="{0C8C3C9D-59F6-CBF3-4EED-9DBD23DBF9C5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17"/>
          <a:stretch>
            <a:fillRect/>
          </a:stretch>
        </p:blipFill>
        <p:spPr>
          <a:xfrm>
            <a:off x="10896176" y="5207953"/>
            <a:ext cx="812800" cy="8128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CFB5312E-0667-04FA-09D1-ED8FEB1A281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41328" y="756188"/>
            <a:ext cx="563680" cy="1972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2">
            <a:extLst>
              <a:ext uri="{FF2B5EF4-FFF2-40B4-BE49-F238E27FC236}">
                <a16:creationId xmlns:a16="http://schemas.microsoft.com/office/drawing/2014/main" id="{B49C3261-7A95-1AA5-3D04-FC93895F0F5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94369" y="5614353"/>
            <a:ext cx="563680" cy="1972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2780478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1584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19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0814DD7-8F80-A885-EC8F-60388F2C67D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843892" y="759518"/>
            <a:ext cx="6504215" cy="4888388"/>
          </a:xfrm>
          <a:prstGeom prst="rect">
            <a:avLst/>
          </a:prstGeom>
        </p:spPr>
      </p:pic>
      <p:pic>
        <p:nvPicPr>
          <p:cNvPr id="2" name="Audio Recording Sep 27, 2022 at 8:31:07 PM" descr="Audio Recording Sep 27, 2022 at 8:31:07 PM">
            <a:hlinkClick r:id="" action="ppaction://media"/>
            <a:extLst>
              <a:ext uri="{FF2B5EF4-FFF2-40B4-BE49-F238E27FC236}">
                <a16:creationId xmlns:a16="http://schemas.microsoft.com/office/drawing/2014/main" id="{A536FB6B-99B5-5551-8C0B-A7C3F428681E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10613293" y="5132754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6086127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6416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62C33B-CFA6-0239-4799-6A1FBFB3028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86753" y="950258"/>
            <a:ext cx="9144000" cy="753035"/>
          </a:xfrm>
        </p:spPr>
        <p:txBody>
          <a:bodyPr>
            <a:normAutofit/>
          </a:bodyPr>
          <a:lstStyle/>
          <a:p>
            <a:r>
              <a:rPr lang="en-US" u="sng" dirty="0"/>
              <a:t>Summary - Suprapubic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FAC2473-7008-2500-F21B-391A8B2B175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461247" y="2013688"/>
            <a:ext cx="9511553" cy="3616147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3200" b="1" dirty="0"/>
              <a:t>Understand the anatomy of the bladder in relation to the pubic bone, rectum, and uterus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3200" b="1" dirty="0"/>
              <a:t>Compare the pelvic anatomy of a male and female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3200" b="1" dirty="0"/>
              <a:t>Recognize a positive FAST exam for the suprapubic view in both men and women. </a:t>
            </a:r>
          </a:p>
        </p:txBody>
      </p:sp>
      <p:pic>
        <p:nvPicPr>
          <p:cNvPr id="4" name="Audio Recording Sep 27, 2022 at 8:36:10 PM" descr="Audio Recording Sep 27, 2022 at 8:36:10 PM">
            <a:hlinkClick r:id="" action="ppaction://media"/>
            <a:extLst>
              <a:ext uri="{FF2B5EF4-FFF2-40B4-BE49-F238E27FC236}">
                <a16:creationId xmlns:a16="http://schemas.microsoft.com/office/drawing/2014/main" id="{918ABB22-4122-5866-6259-BBF16693115D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10972800" y="5694312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883624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2640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audio>
          </p:childTnLst>
        </p:cTn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033DE03E-AC5D-936D-B620-994926597915}"/>
              </a:ext>
            </a:extLst>
          </p:cNvPr>
          <p:cNvSpPr txBox="1"/>
          <p:nvPr/>
        </p:nvSpPr>
        <p:spPr>
          <a:xfrm>
            <a:off x="497840" y="186124"/>
            <a:ext cx="5029200" cy="59093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dirty="0">
                <a:solidFill>
                  <a:schemeClr val="accent2"/>
                </a:solidFill>
              </a:rPr>
              <a:t>Thank You!</a:t>
            </a:r>
          </a:p>
          <a:p>
            <a:endParaRPr lang="en-US" dirty="0"/>
          </a:p>
          <a:p>
            <a:r>
              <a:rPr lang="en-US" dirty="0"/>
              <a:t>Questions?</a:t>
            </a:r>
          </a:p>
          <a:p>
            <a:endParaRPr lang="en-US" sz="1800" b="0" i="0" dirty="0">
              <a:solidFill>
                <a:srgbClr val="000000"/>
              </a:solidFill>
              <a:effectLst/>
              <a:latin typeface="Calibri" panose="020F0502020204030204" pitchFamily="34" charset="0"/>
            </a:endParaRPr>
          </a:p>
          <a:p>
            <a:r>
              <a:rPr lang="en-US" sz="1800" b="0" i="0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lever Nguyen, MS-III</a:t>
            </a:r>
          </a:p>
          <a:p>
            <a:pPr algn="l" fontAlgn="base"/>
            <a:r>
              <a:rPr lang="en-US" sz="1800" b="0" i="0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MD Candidate Class of 2024</a:t>
            </a:r>
          </a:p>
          <a:p>
            <a:pPr algn="l" fontAlgn="base"/>
            <a:r>
              <a:rPr lang="en-US" sz="1800" b="0" i="0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nguyen3@pennstatehealth@psu.edu </a:t>
            </a:r>
            <a:br>
              <a:rPr lang="en-US" sz="1800" b="0" i="0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</a:br>
            <a:endParaRPr lang="en-US" sz="1800" b="0" i="0" dirty="0">
              <a:solidFill>
                <a:srgbClr val="000000"/>
              </a:solidFill>
              <a:effectLst/>
              <a:latin typeface="Calibri" panose="020F0502020204030204" pitchFamily="34" charset="0"/>
            </a:endParaRPr>
          </a:p>
          <a:p>
            <a:pPr algn="l" fontAlgn="base"/>
            <a:r>
              <a:rPr lang="en-US" sz="1800" b="0" i="0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Dr. Avram Flamm, DO, EMT-P</a:t>
            </a:r>
          </a:p>
          <a:p>
            <a:pPr algn="l" fontAlgn="base"/>
            <a:r>
              <a:rPr lang="en-US" sz="1800" b="0" i="0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Medical Director, Life Lion Critical Care Transport</a:t>
            </a:r>
          </a:p>
          <a:p>
            <a:pPr algn="l" fontAlgn="base"/>
            <a:r>
              <a:rPr lang="en-US" sz="1800" b="0" i="0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aflamm1@pennstatehealth.psu.edu</a:t>
            </a:r>
            <a:br>
              <a:rPr lang="en-US" sz="1800" b="0" i="0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</a:br>
            <a:endParaRPr lang="en-US" sz="1800" b="0" i="0" dirty="0">
              <a:solidFill>
                <a:srgbClr val="000000"/>
              </a:solidFill>
              <a:effectLst/>
              <a:latin typeface="Calibri" panose="020F0502020204030204" pitchFamily="34" charset="0"/>
            </a:endParaRPr>
          </a:p>
          <a:p>
            <a:pPr algn="l" fontAlgn="base"/>
            <a:r>
              <a:rPr lang="en-US" sz="1800" b="0" i="0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Dr. Craig Goodmurphy, Ph.D.</a:t>
            </a:r>
          </a:p>
          <a:p>
            <a:pPr algn="l" fontAlgn="base"/>
            <a:r>
              <a:rPr lang="en-US" sz="1800" b="0" i="0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Director of Ultrasound Education</a:t>
            </a:r>
          </a:p>
          <a:p>
            <a:pPr algn="l" fontAlgn="base"/>
            <a:r>
              <a:rPr lang="en-US" sz="1800" b="0" i="0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goodmurphy@pennstatehealth.psu.edu</a:t>
            </a:r>
            <a:br>
              <a:rPr lang="en-US" sz="1800" b="0" i="0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</a:br>
            <a:endParaRPr lang="en-US" sz="1800" b="0" i="0" dirty="0">
              <a:solidFill>
                <a:srgbClr val="000000"/>
              </a:solidFill>
              <a:effectLst/>
              <a:latin typeface="Calibri" panose="020F0502020204030204" pitchFamily="34" charset="0"/>
            </a:endParaRPr>
          </a:p>
          <a:p>
            <a:pPr algn="l" fontAlgn="base"/>
            <a:r>
              <a:rPr lang="en-US" sz="1800" b="0" i="0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Krista Hartmann, MS-III</a:t>
            </a:r>
          </a:p>
          <a:p>
            <a:pPr algn="l" fontAlgn="base"/>
            <a:r>
              <a:rPr lang="en-US" sz="1800" b="0" i="0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MD Candidate Class of 2024</a:t>
            </a:r>
          </a:p>
          <a:p>
            <a:pPr algn="l" fontAlgn="base"/>
            <a:r>
              <a:rPr lang="en-US" sz="1800" b="0" i="0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khartmann1@pennstatehealth.psu.edu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8B5BB46-39FC-543D-F4FF-C30A95C43B43}"/>
              </a:ext>
            </a:extLst>
          </p:cNvPr>
          <p:cNvSpPr txBox="1"/>
          <p:nvPr/>
        </p:nvSpPr>
        <p:spPr>
          <a:xfrm>
            <a:off x="5527040" y="986343"/>
            <a:ext cx="5273040" cy="38164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solidFill>
                  <a:schemeClr val="accent2"/>
                </a:solidFill>
              </a:rPr>
              <a:t>Will become more familiar during in-person scanning sessions!</a:t>
            </a:r>
          </a:p>
          <a:p>
            <a:endParaRPr lang="en-US" sz="3200" b="1" dirty="0">
              <a:solidFill>
                <a:schemeClr val="accent2"/>
              </a:solidFill>
            </a:endParaRPr>
          </a:p>
          <a:p>
            <a:endParaRPr lang="en-US" sz="3200" b="1" dirty="0">
              <a:solidFill>
                <a:schemeClr val="accent2"/>
              </a:solidFill>
            </a:endParaRPr>
          </a:p>
          <a:p>
            <a:r>
              <a:rPr lang="en-US" sz="3200" b="1" dirty="0">
                <a:solidFill>
                  <a:schemeClr val="accent2"/>
                </a:solidFill>
              </a:rPr>
              <a:t>See you in the next video module!</a:t>
            </a:r>
          </a:p>
          <a:p>
            <a:endParaRPr lang="en-US" dirty="0"/>
          </a:p>
        </p:txBody>
      </p:sp>
      <p:pic>
        <p:nvPicPr>
          <p:cNvPr id="2" name="Audio Recording Sep 27, 2022 at 8:07:06 PM" descr="Audio Recording Sep 27, 2022 at 8:07:06 PM">
            <a:hlinkClick r:id="" action="ppaction://media"/>
            <a:extLst>
              <a:ext uri="{FF2B5EF4-FFF2-40B4-BE49-F238E27FC236}">
                <a16:creationId xmlns:a16="http://schemas.microsoft.com/office/drawing/2014/main" id="{76D392A8-1BAE-9642-12C3-9BE03D929915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0556240" y="4802772"/>
            <a:ext cx="812800" cy="81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7178991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45806"/>
    </mc:Choice>
    <mc:Fallback xmlns="">
      <p:transition spd="slow" advTm="45806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6064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  <p:extLst>
    <p:ext uri="{3A86A75C-4F4B-4683-9AE1-C65F6400EC91}">
      <p14:laserTraceLst xmlns:p14="http://schemas.microsoft.com/office/powerpoint/2010/main">
        <p14:tracePtLst>
          <p14:tracePt t="3843" x="7642225" y="4843463"/>
          <p14:tracePt t="3870" x="6634163" y="4392613"/>
          <p14:tracePt t="3874" x="6264275" y="4179888"/>
          <p14:tracePt t="3906" x="5548313" y="3835400"/>
          <p14:tracePt t="3933" x="5521325" y="3808413"/>
          <p14:tracePt t="4000" x="5521325" y="3384550"/>
          <p14:tracePt t="4037" x="5441950" y="2987675"/>
          <p14:tracePt t="4069" x="5414963" y="2960688"/>
          <p14:tracePt t="4116" x="5362575" y="2881313"/>
          <p14:tracePt t="4149" x="5335588" y="2881313"/>
          <p14:tracePt t="4176" x="5310188" y="2881313"/>
          <p14:tracePt t="4236" x="5256213" y="2881313"/>
          <p14:tracePt t="4271" x="5176838" y="2898775"/>
          <p14:tracePt t="4298" x="5018088" y="2898775"/>
          <p14:tracePt t="4330" x="4805363" y="2925763"/>
          <p14:tracePt t="4355" x="4752975" y="2925763"/>
          <p14:tracePt t="4387" x="4621213" y="2854325"/>
          <p14:tracePt t="4458" x="4594225" y="2854325"/>
          <p14:tracePt t="4524" x="4541838" y="2801938"/>
          <p14:tracePt t="4553" x="4487863" y="2722563"/>
          <p14:tracePt t="4627" x="4487863" y="2695575"/>
          <p14:tracePt t="4655" x="4460875" y="2695575"/>
          <p14:tracePt t="4685" x="4381500" y="2616200"/>
          <p14:tracePt t="4722" x="4329113" y="2616200"/>
          <p14:tracePt t="4758" x="4249738" y="2589213"/>
          <p14:tracePt t="4787" x="4249738" y="2562225"/>
          <p14:tracePt t="6307" x="4294188" y="2819400"/>
          <p14:tracePt t="6336" x="4346575" y="2978150"/>
          <p14:tracePt t="6362" x="4373563" y="3030538"/>
          <p14:tracePt t="6395" x="4373563" y="3057525"/>
          <p14:tracePt t="6425" x="4373563" y="3084513"/>
          <p14:tracePt t="6455" x="4373563" y="3270250"/>
          <p14:tracePt t="6465" x="4373563" y="3349625"/>
          <p14:tracePt t="6467" x="4373563" y="3429000"/>
          <p14:tracePt t="6500" x="4373563" y="3641725"/>
          <p14:tracePt t="6532" x="4356100" y="3800475"/>
          <p14:tracePt t="6563" x="4356100" y="4117975"/>
          <p14:tracePt t="6595" x="4249738" y="4357688"/>
          <p14:tracePt t="6625" x="4249738" y="4437063"/>
          <p14:tracePt t="6652" x="4249738" y="4462463"/>
          <p14:tracePt t="6690" x="4222750" y="4489450"/>
          <p14:tracePt t="44849" x="4319588" y="4073525"/>
          <p14:tracePt t="44876" x="4398963" y="3756025"/>
          <p14:tracePt t="44910" x="4584700" y="3357563"/>
          <p14:tracePt t="44941" x="4718050" y="2908300"/>
          <p14:tracePt t="44972" x="4903788" y="2536825"/>
          <p14:tracePt t="45004" x="5114925" y="2271713"/>
          <p14:tracePt t="45032" x="5434013" y="2165350"/>
          <p14:tracePt t="45063" x="6016625" y="1900238"/>
          <p14:tracePt t="45095" x="6467475" y="1422400"/>
          <p14:tracePt t="45128" x="7129463" y="946150"/>
          <p14:tracePt t="45159" x="7473950" y="760413"/>
          <p14:tracePt t="45191" x="7580313" y="495300"/>
          <p14:tracePt t="45224" x="7659688" y="282575"/>
          <p14:tracePt t="45260" x="7793038" y="71438"/>
        </p14:tracePtLst>
      </p14:laserTraceLst>
    </p:ext>
  </p:extLst>
</p:sld>
</file>

<file path=ppt/theme/theme1.xml><?xml version="1.0" encoding="utf-8"?>
<a:theme xmlns:a="http://schemas.openxmlformats.org/drawingml/2006/main" name="Office Theme">
  <a:themeElements>
    <a:clrScheme name="PA Palette">
      <a:dk1>
        <a:srgbClr val="000000"/>
      </a:dk1>
      <a:lt1>
        <a:srgbClr val="FFFFFF"/>
      </a:lt1>
      <a:dk2>
        <a:srgbClr val="041E41"/>
      </a:dk2>
      <a:lt2>
        <a:srgbClr val="B8D6E6"/>
      </a:lt2>
      <a:accent1>
        <a:srgbClr val="009CDE"/>
      </a:accent1>
      <a:accent2>
        <a:srgbClr val="1E407C"/>
      </a:accent2>
      <a:accent3>
        <a:srgbClr val="A3AAAD"/>
      </a:accent3>
      <a:accent4>
        <a:srgbClr val="83B1D4"/>
      </a:accent4>
      <a:accent5>
        <a:srgbClr val="3EA39E"/>
      </a:accent5>
      <a:accent6>
        <a:srgbClr val="305470"/>
      </a:accent6>
      <a:hlink>
        <a:srgbClr val="64B8B6"/>
      </a:hlink>
      <a:folHlink>
        <a:srgbClr val="7D4C7C"/>
      </a:folHlink>
    </a:clrScheme>
    <a:fontScheme name="Franklin Gothic">
      <a:majorFont>
        <a:latin typeface="Franklin Gothic Medium" panose="020B0603020102020204"/>
        <a:ea typeface=""/>
        <a:cs typeface=""/>
        <a:font script="Jpan" typeface="HG創英角ｺﾞｼｯｸUB"/>
        <a:font script="Hang" typeface="돋움"/>
        <a:font script="Hans" typeface="隶书"/>
        <a:font script="Hant" typeface="微軟正黑體"/>
        <a:font script="Arab" typeface="Tahoma"/>
        <a:font script="Hebr" typeface="Aharoni"/>
        <a:font script="Thai" typeface="Lily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Franklin Gothic Book" panose="020B0503020102020204"/>
        <a:ea typeface=""/>
        <a:cs typeface=""/>
        <a:font script="Jpan" typeface="HGｺﾞｼｯｸE"/>
        <a:font script="Hang" typeface="돋움"/>
        <a:font script="Hans" typeface="华文楷体"/>
        <a:font script="Hant" typeface="微軟正黑體"/>
        <a:font script="Arab" typeface="Tahoma"/>
        <a:font script="Hebr" typeface="Aharoni"/>
        <a:font script="Thai" typeface="Lily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204A49901785041AF741C157FF60EBA" ma:contentTypeVersion="12" ma:contentTypeDescription="Create a new document." ma:contentTypeScope="" ma:versionID="2dc561ac532b927686394fff98d3cec6">
  <xsd:schema xmlns:xsd="http://www.w3.org/2001/XMLSchema" xmlns:xs="http://www.w3.org/2001/XMLSchema" xmlns:p="http://schemas.microsoft.com/office/2006/metadata/properties" xmlns:ns2="c7c738f6-68ec-422e-b0e4-3523873f7adf" xmlns:ns3="542b8847-f5d4-4c9f-bd30-657d16e5db1d" targetNamespace="http://schemas.microsoft.com/office/2006/metadata/properties" ma:root="true" ma:fieldsID="37215006c6ba2f10ad2271fcfa8576ba" ns2:_="" ns3:_="">
    <xsd:import namespace="c7c738f6-68ec-422e-b0e4-3523873f7adf"/>
    <xsd:import namespace="542b8847-f5d4-4c9f-bd30-657d16e5db1d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LengthInSeconds" minOccurs="0"/>
                <xsd:element ref="ns3:SharedWithUsers" minOccurs="0"/>
                <xsd:element ref="ns3:SharedWithDetail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7c738f6-68ec-422e-b0e4-3523873f7adf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7" nillable="true" ma:displayName="Length (seconds)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42b8847-f5d4-4c9f-bd30-657d16e5db1d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SharedWithUsers xmlns="542b8847-f5d4-4c9f-bd30-657d16e5db1d">
      <UserInfo>
        <DisplayName>SharingLinks.fbaea811-671e-4f37-b677-a2b510205813.OrganizationEdit.a0f3e262-4087-45ce-9207-f143fa734173</DisplayName>
        <AccountId>24</AccountId>
        <AccountType/>
      </UserInfo>
      <UserInfo>
        <DisplayName>SharingLinks.1bd6d71e-3df5-449b-9aa8-5e919b3d88bc.OrganizationEdit.e1a2a2cf-c433-48ff-870c-19c9ef8ea587</DisplayName>
        <AccountId>25</AccountId>
        <AccountType/>
      </UserInfo>
      <UserInfo>
        <DisplayName>Olson, Samantha N</DisplayName>
        <AccountId>4305</AccountId>
        <AccountType/>
      </UserInfo>
    </SharedWithUsers>
  </documentManagement>
</p:properties>
</file>

<file path=customXml/itemProps1.xml><?xml version="1.0" encoding="utf-8"?>
<ds:datastoreItem xmlns:ds="http://schemas.openxmlformats.org/officeDocument/2006/customXml" ds:itemID="{EE49368D-A9E8-45BF-9DE1-9DF71906CB3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c7c738f6-68ec-422e-b0e4-3523873f7adf"/>
    <ds:schemaRef ds:uri="542b8847-f5d4-4c9f-bd30-657d16e5db1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6EE8212F-472D-486A-9E3D-EC119BF771F9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B0872EE0-2104-452E-9839-3EC9728C0A3E}">
  <ds:schemaRefs>
    <ds:schemaRef ds:uri="http://schemas.microsoft.com/office/2006/documentManagement/types"/>
    <ds:schemaRef ds:uri="http://purl.org/dc/elements/1.1/"/>
    <ds:schemaRef ds:uri="http://purl.org/dc/terms/"/>
    <ds:schemaRef ds:uri="http://purl.org/dc/dcmitype/"/>
    <ds:schemaRef ds:uri="a01248ac-76f1-4f58-bd61-bb5ad5b08742"/>
    <ds:schemaRef ds:uri="http://schemas.microsoft.com/office/infopath/2007/PartnerControls"/>
    <ds:schemaRef ds:uri="http://www.w3.org/XML/1998/namespace"/>
    <ds:schemaRef ds:uri="http://schemas.openxmlformats.org/package/2006/metadata/core-properties"/>
    <ds:schemaRef ds:uri="7e353704-68ee-4592-8419-7aec398fa0ef"/>
    <ds:schemaRef ds:uri="http://schemas.microsoft.com/office/2006/metadata/properties"/>
    <ds:schemaRef ds:uri="3c8fd356-1280-4d00-a910-3bff90828a90"/>
    <ds:schemaRef ds:uri="542b8847-f5d4-4c9f-bd30-657d16e5db1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2358</TotalTime>
  <Words>621</Words>
  <Application>Microsoft Macintosh PowerPoint</Application>
  <PresentationFormat>Widescreen</PresentationFormat>
  <Paragraphs>70</Paragraphs>
  <Slides>9</Slides>
  <Notes>6</Notes>
  <HiddenSlides>0</HiddenSlides>
  <MMClips>9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7" baseType="lpstr">
      <vt:lpstr>Arial</vt:lpstr>
      <vt:lpstr>Calibri</vt:lpstr>
      <vt:lpstr>Franklin Gothic Book</vt:lpstr>
      <vt:lpstr>Franklin Gothic Medium</vt:lpstr>
      <vt:lpstr>proxima</vt:lpstr>
      <vt:lpstr>Times New Roman</vt:lpstr>
      <vt:lpstr>Verdana</vt:lpstr>
      <vt:lpstr>Office Theme</vt:lpstr>
      <vt:lpstr>PowerPoint Presentation</vt:lpstr>
      <vt:lpstr>EFAST Exam Component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Summary - Suprapubic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Wray, Alisa</cp:lastModifiedBy>
  <cp:revision>33</cp:revision>
  <dcterms:created xsi:type="dcterms:W3CDTF">2018-03-19T17:38:41Z</dcterms:created>
  <dcterms:modified xsi:type="dcterms:W3CDTF">2024-01-24T19:03:5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204A49901785041AF741C157FF60EBA</vt:lpwstr>
  </property>
</Properties>
</file>